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9737" autoAdjust="0"/>
  </p:normalViewPr>
  <p:slideViewPr>
    <p:cSldViewPr snapToGrid="0">
      <p:cViewPr varScale="1">
        <p:scale>
          <a:sx n="99" d="100"/>
          <a:sy n="99" d="100"/>
        </p:scale>
        <p:origin x="30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08B3CD-D394-4A81-85D1-FD92360A82C4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3971F0-C39F-4D2F-AA4C-F69274CAE4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41019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882B88-6EAA-CF42-AEFA-BC49647140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E26A37C-B011-17B0-728C-9BBB6E78E8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04A905-9781-055C-343E-993A4812D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709419B-C389-76E7-FB80-D24B7AD5D6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1E559F7-63DE-F957-3B1C-4B13DD9F4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9654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DDB909-8432-DE7A-258E-B0BCD55945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33AE6D7-B94E-E710-E3EB-7745351FA3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C3D231-A96E-31F3-473C-A90438D85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B354BE-5380-36AC-9C5E-C8FBCFE54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597086-85EA-4625-B46C-391DCBAEE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324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2B9ECBD-C23F-F877-844F-B682E730D6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0323C3D-F0C3-7DD5-7CF2-B831309F8C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4220976-06B0-C3ED-86D6-D83BB0C2E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479C41-9339-D9F7-05DA-86744D832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457253B-222D-EDDF-CB68-2BC6437AC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368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219920-9851-6BFD-4875-0E5093FAFA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2F61722-C510-4F65-5D5A-5159919F56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65CB9F1-D17C-49CD-D373-F0CBE51DF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453B95-B513-A6FB-25BB-22791B64C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11C78F-E3C9-F4AC-5A8A-C57844510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3265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71726B-77A5-12E6-D568-ECD48CA061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B815A9F-1D89-77FB-6E72-C945445176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1BD235-F264-BD81-B5B8-2E2D5D533D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05B5BC-DC26-BD28-39C3-6A2FAEF56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56AABFC-0046-5CB6-83CC-DADB0263A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6589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E513F9-374D-EAAB-BD93-4EDC04E8CD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BE664ED-30DD-F7F3-56E0-7BA33A61BD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E4906AF-A6B4-3072-5E88-DAE8F8783D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D983074-9002-2F38-7C11-B476776066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F85963A-B1BA-371A-ACC3-7C83A5770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385F760-5C6C-B493-7B96-033CA5E88A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7195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BE38CD-CF75-0AD9-D696-E1D9F98E7D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369E2CE-E182-C4D7-C462-075F5AFEED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16C6447-FE4B-41B7-8BFA-6FB5C7469F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A1B3D20-6DE2-33C4-5661-5D145EC062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6CB478F-4ECB-8233-59FF-E661203D12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89A7923-1A08-82E6-8852-38DCFB062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9E59D37-943B-7F8C-D640-FC153DDB8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7B1E5C9-AC59-F3B9-BC5D-2C94DCB0A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8485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CC8A0D-3A1D-71BD-AB58-5A62DF58BA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5F2F65E-4DE6-EAF9-8C0B-2A93CF8C9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C323F7C-3D2B-2DAF-B5B2-A913E7239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95A701A-0FAF-5308-CD5B-198DBB266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7754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9F6E695-593C-5E95-CCC4-EF82CC339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5ABD970-4EB7-3E57-A5D6-1E08DA364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66BD427-E7B7-ED4D-0444-2CEDA28F8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455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5F0DCD-5368-9A3B-73F7-7DFF9A9360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E973110-A00F-1B7A-DAC7-3B0088FC08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71FE1E8-FB81-D555-29E1-C9596B73AB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7D3E03F-38D7-C0A5-AAF3-1EB5D0D89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5EF8A7A-6D52-6631-551A-C82B6EDBA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A86F86-3B4A-40B2-278B-6CF5B88F1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0588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096599-6671-B963-06C3-21D7F9DE79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3E8F7D5-5E09-3497-959E-CF1AC1FB71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5985A14-4FDF-AEDC-D746-3A3B5576DD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2A74611-D464-34B7-DEC5-7CB621CD9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946F870-D84B-D7E2-3453-103AEC1FD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CD64B38-41C3-2A73-CCCE-CD9827797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960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7DEF9F7-9F00-52F2-5CC2-4FB85D7DC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E5C16F6-62AD-FE62-23E0-D556C9290C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10DDEE-443D-9A66-68FF-565D0ACA44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DD3D1-A094-47B0-A84D-8A7F01BDB563}" type="datetimeFigureOut">
              <a:rPr kumimoji="1" lang="ja-JP" altLang="en-US" smtClean="0"/>
              <a:t>2024/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0FEF85-ED03-6862-909A-E92CF860F3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FFD976-418D-1E2A-143D-B8B075E5AB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5209C0-3792-4A84-9EAB-FC485201FE3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726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8E052CE3-7E11-AC92-3D29-FCD1775676B1}"/>
              </a:ext>
            </a:extLst>
          </p:cNvPr>
          <p:cNvGrpSpPr/>
          <p:nvPr/>
        </p:nvGrpSpPr>
        <p:grpSpPr>
          <a:xfrm>
            <a:off x="1455332" y="22939"/>
            <a:ext cx="9281335" cy="6812121"/>
            <a:chOff x="1455332" y="22939"/>
            <a:chExt cx="9281335" cy="6812121"/>
          </a:xfrm>
        </p:grpSpPr>
        <p:sp>
          <p:nvSpPr>
            <p:cNvPr id="432" name="Rectangle 207">
              <a:extLst>
                <a:ext uri="{FF2B5EF4-FFF2-40B4-BE49-F238E27FC236}">
                  <a16:creationId xmlns:a16="http://schemas.microsoft.com/office/drawing/2014/main" id="{BC1027DC-F13C-6068-C3A2-EBEB0BBF84FC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1544252" y="42189"/>
              <a:ext cx="21713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8" name="テキスト ボックス 437">
              <a:extLst>
                <a:ext uri="{FF2B5EF4-FFF2-40B4-BE49-F238E27FC236}">
                  <a16:creationId xmlns:a16="http://schemas.microsoft.com/office/drawing/2014/main" id="{85BEE72D-12EE-F170-E1B3-3EE61A9716EF}"/>
                </a:ext>
              </a:extLst>
            </p:cNvPr>
            <p:cNvSpPr txBox="1"/>
            <p:nvPr/>
          </p:nvSpPr>
          <p:spPr>
            <a:xfrm>
              <a:off x="7035377" y="1624358"/>
              <a:ext cx="1309974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l-cause mortality;</a:t>
              </a:r>
            </a:p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P=0.62</a:t>
              </a:r>
            </a:p>
          </p:txBody>
        </p:sp>
        <p:sp>
          <p:nvSpPr>
            <p:cNvPr id="720" name="Rectangle 207">
              <a:extLst>
                <a:ext uri="{FF2B5EF4-FFF2-40B4-BE49-F238E27FC236}">
                  <a16:creationId xmlns:a16="http://schemas.microsoft.com/office/drawing/2014/main" id="{776481F1-B572-C126-E5FB-F9D2FD1D7023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216557" y="35733"/>
              <a:ext cx="211288" cy="1623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6" name="テキスト ボックス 1415">
              <a:extLst>
                <a:ext uri="{FF2B5EF4-FFF2-40B4-BE49-F238E27FC236}">
                  <a16:creationId xmlns:a16="http://schemas.microsoft.com/office/drawing/2014/main" id="{55B7370D-6E04-504D-5331-0360446C5495}"/>
                </a:ext>
              </a:extLst>
            </p:cNvPr>
            <p:cNvSpPr txBox="1"/>
            <p:nvPr/>
          </p:nvSpPr>
          <p:spPr>
            <a:xfrm>
              <a:off x="2459902" y="1631050"/>
              <a:ext cx="1806905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ary composite </a:t>
              </a:r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utcome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</a:t>
              </a:r>
            </a:p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P=0.050</a:t>
              </a:r>
            </a:p>
          </p:txBody>
        </p:sp>
        <p:sp>
          <p:nvSpPr>
            <p:cNvPr id="2" name="正方形/長方形 1">
              <a:extLst>
                <a:ext uri="{FF2B5EF4-FFF2-40B4-BE49-F238E27FC236}">
                  <a16:creationId xmlns:a16="http://schemas.microsoft.com/office/drawing/2014/main" id="{5DE581F3-4035-45EB-5BCA-12A64D7ED843}"/>
                </a:ext>
              </a:extLst>
            </p:cNvPr>
            <p:cNvSpPr/>
            <p:nvPr/>
          </p:nvSpPr>
          <p:spPr>
            <a:xfrm>
              <a:off x="1455332" y="22939"/>
              <a:ext cx="4594630" cy="3304748"/>
            </a:xfrm>
            <a:prstGeom prst="rect">
              <a:avLst/>
            </a:prstGeom>
            <a:noFill/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4DE6A493-9697-7A7A-0AEE-E2CE6BA6450E}"/>
                </a:ext>
              </a:extLst>
            </p:cNvPr>
            <p:cNvSpPr/>
            <p:nvPr/>
          </p:nvSpPr>
          <p:spPr>
            <a:xfrm>
              <a:off x="6142037" y="30093"/>
              <a:ext cx="4594630" cy="3304748"/>
            </a:xfrm>
            <a:prstGeom prst="rect">
              <a:avLst/>
            </a:prstGeom>
            <a:noFill/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13" name="テキスト ボックス 2012">
              <a:extLst>
                <a:ext uri="{FF2B5EF4-FFF2-40B4-BE49-F238E27FC236}">
                  <a16:creationId xmlns:a16="http://schemas.microsoft.com/office/drawing/2014/main" id="{A788A894-AE9E-289D-0D80-42C77118B034}"/>
                </a:ext>
              </a:extLst>
            </p:cNvPr>
            <p:cNvSpPr txBox="1"/>
            <p:nvPr/>
          </p:nvSpPr>
          <p:spPr>
            <a:xfrm>
              <a:off x="4837549" y="5095160"/>
              <a:ext cx="1797287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rt failure hospitalization</a:t>
              </a:r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</a:t>
              </a:r>
            </a:p>
            <a:p>
              <a:r>
                <a:rPr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P=0.019</a:t>
              </a: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FC00FD93-6A37-8B46-8CE9-91823822853D}"/>
                </a:ext>
              </a:extLst>
            </p:cNvPr>
            <p:cNvSpPr/>
            <p:nvPr/>
          </p:nvSpPr>
          <p:spPr>
            <a:xfrm>
              <a:off x="3872772" y="3389336"/>
              <a:ext cx="4594630" cy="3445724"/>
            </a:xfrm>
            <a:prstGeom prst="rect">
              <a:avLst/>
            </a:prstGeom>
            <a:noFill/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Line 5">
              <a:extLst>
                <a:ext uri="{FF2B5EF4-FFF2-40B4-BE49-F238E27FC236}">
                  <a16:creationId xmlns:a16="http://schemas.microsoft.com/office/drawing/2014/main" id="{6F692599-55EC-56F2-0173-15F0B60529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1800" y="5739883"/>
              <a:ext cx="340742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1DA1782E-343A-7FF2-DB9D-E59977ED22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1800" y="5739883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4" name="Line 7">
              <a:extLst>
                <a:ext uri="{FF2B5EF4-FFF2-40B4-BE49-F238E27FC236}">
                  <a16:creationId xmlns:a16="http://schemas.microsoft.com/office/drawing/2014/main" id="{A2DF0ECF-7B83-89E8-B733-833A85E75D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36682" y="5739883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5" name="Line 8">
              <a:extLst>
                <a:ext uri="{FF2B5EF4-FFF2-40B4-BE49-F238E27FC236}">
                  <a16:creationId xmlns:a16="http://schemas.microsoft.com/office/drawing/2014/main" id="{D0FC969D-FCE6-0324-7845-D13C8E5FFA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2954" y="5739883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6" name="Line 9">
              <a:extLst>
                <a:ext uri="{FF2B5EF4-FFF2-40B4-BE49-F238E27FC236}">
                  <a16:creationId xmlns:a16="http://schemas.microsoft.com/office/drawing/2014/main" id="{6B12A66C-BB3C-B95C-01A5-05485CADB3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09225" y="5739883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7" name="Rectangle 10">
              <a:extLst>
                <a:ext uri="{FF2B5EF4-FFF2-40B4-BE49-F238E27FC236}">
                  <a16:creationId xmlns:a16="http://schemas.microsoft.com/office/drawing/2014/main" id="{1FFEF6F6-03EA-A95B-E0A4-E350CCFDE5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4847" y="5863699"/>
              <a:ext cx="61716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8" name="Rectangle 11">
              <a:extLst>
                <a:ext uri="{FF2B5EF4-FFF2-40B4-BE49-F238E27FC236}">
                  <a16:creationId xmlns:a16="http://schemas.microsoft.com/office/drawing/2014/main" id="{BCB0945B-1B78-B6A4-BA4E-E0CC33C69B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1664" y="5863699"/>
              <a:ext cx="185149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9" name="Rectangle 12">
              <a:extLst>
                <a:ext uri="{FF2B5EF4-FFF2-40B4-BE49-F238E27FC236}">
                  <a16:creationId xmlns:a16="http://schemas.microsoft.com/office/drawing/2014/main" id="{3D47E826-3485-18CA-C803-579ACB36FE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5987" y="5863699"/>
              <a:ext cx="246867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0" name="Rectangle 13">
              <a:extLst>
                <a:ext uri="{FF2B5EF4-FFF2-40B4-BE49-F238E27FC236}">
                  <a16:creationId xmlns:a16="http://schemas.microsoft.com/office/drawing/2014/main" id="{C14B1AB9-B7AE-94FA-6524-9B7E7F9CE2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2259" y="5863699"/>
              <a:ext cx="246867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1" name="Line 14">
              <a:extLst>
                <a:ext uri="{FF2B5EF4-FFF2-40B4-BE49-F238E27FC236}">
                  <a16:creationId xmlns:a16="http://schemas.microsoft.com/office/drawing/2014/main" id="{569B272C-CCF4-7FEB-12DF-66417B5F36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65670" y="3513372"/>
              <a:ext cx="0" cy="2142141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2" name="Line 15">
              <a:extLst>
                <a:ext uri="{FF2B5EF4-FFF2-40B4-BE49-F238E27FC236}">
                  <a16:creationId xmlns:a16="http://schemas.microsoft.com/office/drawing/2014/main" id="{3026722F-95D4-1EC0-4D06-C64BB20E94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93437" y="5655512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3" name="Line 16">
              <a:extLst>
                <a:ext uri="{FF2B5EF4-FFF2-40B4-BE49-F238E27FC236}">
                  <a16:creationId xmlns:a16="http://schemas.microsoft.com/office/drawing/2014/main" id="{BA916943-E579-DC28-E9A0-06E8B8957B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93437" y="5227084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4" name="Line 17">
              <a:extLst>
                <a:ext uri="{FF2B5EF4-FFF2-40B4-BE49-F238E27FC236}">
                  <a16:creationId xmlns:a16="http://schemas.microsoft.com/office/drawing/2014/main" id="{80615E2A-913B-CA00-3C43-FC4958B7C8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93437" y="4798656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5" name="Line 18">
              <a:extLst>
                <a:ext uri="{FF2B5EF4-FFF2-40B4-BE49-F238E27FC236}">
                  <a16:creationId xmlns:a16="http://schemas.microsoft.com/office/drawing/2014/main" id="{A11A5BC8-CBFD-037E-77F5-600317A4B3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93437" y="4370228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6" name="Line 19">
              <a:extLst>
                <a:ext uri="{FF2B5EF4-FFF2-40B4-BE49-F238E27FC236}">
                  <a16:creationId xmlns:a16="http://schemas.microsoft.com/office/drawing/2014/main" id="{A64C006F-4C30-3B21-10E5-DEA8C32EF2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93437" y="3941800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7" name="Line 20">
              <a:extLst>
                <a:ext uri="{FF2B5EF4-FFF2-40B4-BE49-F238E27FC236}">
                  <a16:creationId xmlns:a16="http://schemas.microsoft.com/office/drawing/2014/main" id="{1CF199F1-6FEC-F5C4-D747-F272D68704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593437" y="3513372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8" name="Rectangle 21">
              <a:extLst>
                <a:ext uri="{FF2B5EF4-FFF2-40B4-BE49-F238E27FC236}">
                  <a16:creationId xmlns:a16="http://schemas.microsoft.com/office/drawing/2014/main" id="{4E7C99C5-9138-1F71-2544-25E466F36C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8689" y="5616066"/>
              <a:ext cx="61716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9" name="Rectangle 22">
              <a:extLst>
                <a:ext uri="{FF2B5EF4-FFF2-40B4-BE49-F238E27FC236}">
                  <a16:creationId xmlns:a16="http://schemas.microsoft.com/office/drawing/2014/main" id="{F1C04B3C-3862-6846-A508-77CFD40F89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6456" y="5193116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0" name="Rectangle 23">
              <a:extLst>
                <a:ext uri="{FF2B5EF4-FFF2-40B4-BE49-F238E27FC236}">
                  <a16:creationId xmlns:a16="http://schemas.microsoft.com/office/drawing/2014/main" id="{8B1F02E6-7C68-3016-E0CD-3950D767D0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6456" y="4764689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1" name="Rectangle 24">
              <a:extLst>
                <a:ext uri="{FF2B5EF4-FFF2-40B4-BE49-F238E27FC236}">
                  <a16:creationId xmlns:a16="http://schemas.microsoft.com/office/drawing/2014/main" id="{AEE7A919-9B5C-9491-072A-C36494B5B4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6456" y="4336260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2" name="Rectangle 25">
              <a:extLst>
                <a:ext uri="{FF2B5EF4-FFF2-40B4-BE49-F238E27FC236}">
                  <a16:creationId xmlns:a16="http://schemas.microsoft.com/office/drawing/2014/main" id="{602C8ACA-EBAA-F395-E58F-E7ADCFCE7F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36456" y="3907833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3" name="Rectangle 26">
              <a:extLst>
                <a:ext uri="{FF2B5EF4-FFF2-40B4-BE49-F238E27FC236}">
                  <a16:creationId xmlns:a16="http://schemas.microsoft.com/office/drawing/2014/main" id="{FBE05F7C-6073-4FEE-044A-9734AC8405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2558" y="3479404"/>
              <a:ext cx="185149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4" name="Freeform 27">
              <a:extLst>
                <a:ext uri="{FF2B5EF4-FFF2-40B4-BE49-F238E27FC236}">
                  <a16:creationId xmlns:a16="http://schemas.microsoft.com/office/drawing/2014/main" id="{CDF9393A-3F9F-4E0D-A36B-AEC4427B362E}"/>
                </a:ext>
              </a:extLst>
            </p:cNvPr>
            <p:cNvSpPr>
              <a:spLocks/>
            </p:cNvSpPr>
            <p:nvPr/>
          </p:nvSpPr>
          <p:spPr bwMode="auto">
            <a:xfrm>
              <a:off x="4665670" y="3429001"/>
              <a:ext cx="3679686" cy="2310882"/>
            </a:xfrm>
            <a:custGeom>
              <a:avLst/>
              <a:gdLst>
                <a:gd name="T0" fmla="*/ 0 w 515"/>
                <a:gd name="T1" fmla="*/ 0 h 410"/>
                <a:gd name="T2" fmla="*/ 0 w 515"/>
                <a:gd name="T3" fmla="*/ 410 h 410"/>
                <a:gd name="T4" fmla="*/ 515 w 515"/>
                <a:gd name="T5" fmla="*/ 410 h 4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10">
                  <a:moveTo>
                    <a:pt x="0" y="0"/>
                  </a:moveTo>
                  <a:lnTo>
                    <a:pt x="0" y="410"/>
                  </a:lnTo>
                  <a:lnTo>
                    <a:pt x="515" y="41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5" name="Rectangle 28">
              <a:extLst>
                <a:ext uri="{FF2B5EF4-FFF2-40B4-BE49-F238E27FC236}">
                  <a16:creationId xmlns:a16="http://schemas.microsoft.com/office/drawing/2014/main" id="{4EF200E7-6293-F2CF-9CDE-B390E35DD2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4167" y="6026963"/>
              <a:ext cx="1272204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-up Duration (day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6" name="Rectangle 29">
              <a:extLst>
                <a:ext uri="{FF2B5EF4-FFF2-40B4-BE49-F238E27FC236}">
                  <a16:creationId xmlns:a16="http://schemas.microsoft.com/office/drawing/2014/main" id="{4DABCEBF-B768-2E3E-17A4-32935E04AC6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742155" y="4633659"/>
              <a:ext cx="931609" cy="148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vent-free Survival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7" name="Freeform 30">
              <a:extLst>
                <a:ext uri="{FF2B5EF4-FFF2-40B4-BE49-F238E27FC236}">
                  <a16:creationId xmlns:a16="http://schemas.microsoft.com/office/drawing/2014/main" id="{F42316E7-0FA5-8EBC-3325-DA133D609000}"/>
                </a:ext>
              </a:extLst>
            </p:cNvPr>
            <p:cNvSpPr>
              <a:spLocks/>
            </p:cNvSpPr>
            <p:nvPr/>
          </p:nvSpPr>
          <p:spPr bwMode="auto">
            <a:xfrm>
              <a:off x="4801800" y="3513372"/>
              <a:ext cx="3407426" cy="1177904"/>
            </a:xfrm>
            <a:custGeom>
              <a:avLst/>
              <a:gdLst>
                <a:gd name="T0" fmla="*/ 0 w 477"/>
                <a:gd name="T1" fmla="*/ 0 h 209"/>
                <a:gd name="T2" fmla="*/ 2 w 477"/>
                <a:gd name="T3" fmla="*/ 0 h 209"/>
                <a:gd name="T4" fmla="*/ 2 w 477"/>
                <a:gd name="T5" fmla="*/ 10 h 209"/>
                <a:gd name="T6" fmla="*/ 4 w 477"/>
                <a:gd name="T7" fmla="*/ 10 h 209"/>
                <a:gd name="T8" fmla="*/ 4 w 477"/>
                <a:gd name="T9" fmla="*/ 20 h 209"/>
                <a:gd name="T10" fmla="*/ 13 w 477"/>
                <a:gd name="T11" fmla="*/ 20 h 209"/>
                <a:gd name="T12" fmla="*/ 13 w 477"/>
                <a:gd name="T13" fmla="*/ 30 h 209"/>
                <a:gd name="T14" fmla="*/ 14 w 477"/>
                <a:gd name="T15" fmla="*/ 30 h 209"/>
                <a:gd name="T16" fmla="*/ 14 w 477"/>
                <a:gd name="T17" fmla="*/ 39 h 209"/>
                <a:gd name="T18" fmla="*/ 15 w 477"/>
                <a:gd name="T19" fmla="*/ 39 h 209"/>
                <a:gd name="T20" fmla="*/ 15 w 477"/>
                <a:gd name="T21" fmla="*/ 49 h 209"/>
                <a:gd name="T22" fmla="*/ 16 w 477"/>
                <a:gd name="T23" fmla="*/ 49 h 209"/>
                <a:gd name="T24" fmla="*/ 16 w 477"/>
                <a:gd name="T25" fmla="*/ 59 h 209"/>
                <a:gd name="T26" fmla="*/ 28 w 477"/>
                <a:gd name="T27" fmla="*/ 59 h 209"/>
                <a:gd name="T28" fmla="*/ 28 w 477"/>
                <a:gd name="T29" fmla="*/ 69 h 209"/>
                <a:gd name="T30" fmla="*/ 39 w 477"/>
                <a:gd name="T31" fmla="*/ 69 h 209"/>
                <a:gd name="T32" fmla="*/ 39 w 477"/>
                <a:gd name="T33" fmla="*/ 79 h 209"/>
                <a:gd name="T34" fmla="*/ 79 w 477"/>
                <a:gd name="T35" fmla="*/ 79 h 209"/>
                <a:gd name="T36" fmla="*/ 79 w 477"/>
                <a:gd name="T37" fmla="*/ 90 h 209"/>
                <a:gd name="T38" fmla="*/ 80 w 477"/>
                <a:gd name="T39" fmla="*/ 90 h 209"/>
                <a:gd name="T40" fmla="*/ 80 w 477"/>
                <a:gd name="T41" fmla="*/ 101 h 209"/>
                <a:gd name="T42" fmla="*/ 92 w 477"/>
                <a:gd name="T43" fmla="*/ 101 h 209"/>
                <a:gd name="T44" fmla="*/ 92 w 477"/>
                <a:gd name="T45" fmla="*/ 113 h 209"/>
                <a:gd name="T46" fmla="*/ 225 w 477"/>
                <a:gd name="T47" fmla="*/ 113 h 209"/>
                <a:gd name="T48" fmla="*/ 225 w 477"/>
                <a:gd name="T49" fmla="*/ 126 h 209"/>
                <a:gd name="T50" fmla="*/ 230 w 477"/>
                <a:gd name="T51" fmla="*/ 126 h 209"/>
                <a:gd name="T52" fmla="*/ 230 w 477"/>
                <a:gd name="T53" fmla="*/ 140 h 209"/>
                <a:gd name="T54" fmla="*/ 276 w 477"/>
                <a:gd name="T55" fmla="*/ 140 h 209"/>
                <a:gd name="T56" fmla="*/ 276 w 477"/>
                <a:gd name="T57" fmla="*/ 153 h 209"/>
                <a:gd name="T58" fmla="*/ 289 w 477"/>
                <a:gd name="T59" fmla="*/ 153 h 209"/>
                <a:gd name="T60" fmla="*/ 289 w 477"/>
                <a:gd name="T61" fmla="*/ 166 h 209"/>
                <a:gd name="T62" fmla="*/ 332 w 477"/>
                <a:gd name="T63" fmla="*/ 166 h 209"/>
                <a:gd name="T64" fmla="*/ 332 w 477"/>
                <a:gd name="T65" fmla="*/ 181 h 209"/>
                <a:gd name="T66" fmla="*/ 379 w 477"/>
                <a:gd name="T67" fmla="*/ 181 h 209"/>
                <a:gd name="T68" fmla="*/ 379 w 477"/>
                <a:gd name="T69" fmla="*/ 195 h 209"/>
                <a:gd name="T70" fmla="*/ 409 w 477"/>
                <a:gd name="T71" fmla="*/ 195 h 209"/>
                <a:gd name="T72" fmla="*/ 409 w 477"/>
                <a:gd name="T73" fmla="*/ 209 h 209"/>
                <a:gd name="T74" fmla="*/ 477 w 477"/>
                <a:gd name="T75" fmla="*/ 209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477" h="209">
                  <a:moveTo>
                    <a:pt x="0" y="0"/>
                  </a:moveTo>
                  <a:lnTo>
                    <a:pt x="2" y="0"/>
                  </a:lnTo>
                  <a:lnTo>
                    <a:pt x="2" y="10"/>
                  </a:lnTo>
                  <a:lnTo>
                    <a:pt x="4" y="10"/>
                  </a:lnTo>
                  <a:lnTo>
                    <a:pt x="4" y="20"/>
                  </a:lnTo>
                  <a:lnTo>
                    <a:pt x="13" y="20"/>
                  </a:lnTo>
                  <a:lnTo>
                    <a:pt x="13" y="30"/>
                  </a:lnTo>
                  <a:lnTo>
                    <a:pt x="14" y="30"/>
                  </a:lnTo>
                  <a:lnTo>
                    <a:pt x="14" y="39"/>
                  </a:lnTo>
                  <a:lnTo>
                    <a:pt x="15" y="39"/>
                  </a:lnTo>
                  <a:lnTo>
                    <a:pt x="15" y="49"/>
                  </a:lnTo>
                  <a:lnTo>
                    <a:pt x="16" y="49"/>
                  </a:lnTo>
                  <a:lnTo>
                    <a:pt x="16" y="59"/>
                  </a:lnTo>
                  <a:lnTo>
                    <a:pt x="28" y="59"/>
                  </a:lnTo>
                  <a:lnTo>
                    <a:pt x="28" y="69"/>
                  </a:lnTo>
                  <a:lnTo>
                    <a:pt x="39" y="69"/>
                  </a:lnTo>
                  <a:lnTo>
                    <a:pt x="39" y="79"/>
                  </a:lnTo>
                  <a:lnTo>
                    <a:pt x="79" y="79"/>
                  </a:lnTo>
                  <a:lnTo>
                    <a:pt x="79" y="90"/>
                  </a:lnTo>
                  <a:lnTo>
                    <a:pt x="80" y="90"/>
                  </a:lnTo>
                  <a:lnTo>
                    <a:pt x="80" y="101"/>
                  </a:lnTo>
                  <a:lnTo>
                    <a:pt x="92" y="101"/>
                  </a:lnTo>
                  <a:lnTo>
                    <a:pt x="92" y="113"/>
                  </a:lnTo>
                  <a:lnTo>
                    <a:pt x="225" y="113"/>
                  </a:lnTo>
                  <a:lnTo>
                    <a:pt x="225" y="126"/>
                  </a:lnTo>
                  <a:lnTo>
                    <a:pt x="230" y="126"/>
                  </a:lnTo>
                  <a:lnTo>
                    <a:pt x="230" y="140"/>
                  </a:lnTo>
                  <a:lnTo>
                    <a:pt x="276" y="140"/>
                  </a:lnTo>
                  <a:lnTo>
                    <a:pt x="276" y="153"/>
                  </a:lnTo>
                  <a:lnTo>
                    <a:pt x="289" y="153"/>
                  </a:lnTo>
                  <a:lnTo>
                    <a:pt x="289" y="166"/>
                  </a:lnTo>
                  <a:lnTo>
                    <a:pt x="332" y="166"/>
                  </a:lnTo>
                  <a:lnTo>
                    <a:pt x="332" y="181"/>
                  </a:lnTo>
                  <a:lnTo>
                    <a:pt x="379" y="181"/>
                  </a:lnTo>
                  <a:lnTo>
                    <a:pt x="379" y="195"/>
                  </a:lnTo>
                  <a:lnTo>
                    <a:pt x="409" y="195"/>
                  </a:lnTo>
                  <a:lnTo>
                    <a:pt x="409" y="209"/>
                  </a:lnTo>
                  <a:lnTo>
                    <a:pt x="477" y="209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8" name="Line 31">
              <a:extLst>
                <a:ext uri="{FF2B5EF4-FFF2-40B4-BE49-F238E27FC236}">
                  <a16:creationId xmlns:a16="http://schemas.microsoft.com/office/drawing/2014/main" id="{35B140FF-BF08-9F2C-CEF0-8FEB65F0BC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2629" y="3513372"/>
              <a:ext cx="7084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9" name="Line 32">
              <a:extLst>
                <a:ext uri="{FF2B5EF4-FFF2-40B4-BE49-F238E27FC236}">
                  <a16:creationId xmlns:a16="http://schemas.microsoft.com/office/drawing/2014/main" id="{9F827FB8-C1F6-84F0-0D85-F6E4B563C6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08745" y="3485979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0" name="Line 33">
              <a:extLst>
                <a:ext uri="{FF2B5EF4-FFF2-40B4-BE49-F238E27FC236}">
                  <a16:creationId xmlns:a16="http://schemas.microsoft.com/office/drawing/2014/main" id="{C2A3B49B-2CBD-772B-8CFA-540E1C088C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43487" y="3846472"/>
              <a:ext cx="7917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1" name="Line 34">
              <a:extLst>
                <a:ext uri="{FF2B5EF4-FFF2-40B4-BE49-F238E27FC236}">
                  <a16:creationId xmlns:a16="http://schemas.microsoft.com/office/drawing/2014/main" id="{656FF3EF-92E5-D663-8B2C-576780FE69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79603" y="3817983"/>
              <a:ext cx="0" cy="5697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2" name="Line 35">
              <a:extLst>
                <a:ext uri="{FF2B5EF4-FFF2-40B4-BE49-F238E27FC236}">
                  <a16:creationId xmlns:a16="http://schemas.microsoft.com/office/drawing/2014/main" id="{EC0119AB-EC81-498A-3516-897E188538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1828" y="3902354"/>
              <a:ext cx="7084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3" name="Line 36">
              <a:extLst>
                <a:ext uri="{FF2B5EF4-FFF2-40B4-BE49-F238E27FC236}">
                  <a16:creationId xmlns:a16="http://schemas.microsoft.com/office/drawing/2014/main" id="{76D8BCF9-3439-BFAD-087C-8699B9C020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36555" y="3874961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4" name="Line 37">
              <a:extLst>
                <a:ext uri="{FF2B5EF4-FFF2-40B4-BE49-F238E27FC236}">
                  <a16:creationId xmlns:a16="http://schemas.microsoft.com/office/drawing/2014/main" id="{9D912C60-BDFE-52C4-0611-030A4A976A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9624" y="3959331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5" name="Line 38">
              <a:extLst>
                <a:ext uri="{FF2B5EF4-FFF2-40B4-BE49-F238E27FC236}">
                  <a16:creationId xmlns:a16="http://schemas.microsoft.com/office/drawing/2014/main" id="{9FFB7132-8D38-27AA-D45B-F6BF8C41A6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65740" y="3930843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6" name="Line 39">
              <a:extLst>
                <a:ext uri="{FF2B5EF4-FFF2-40B4-BE49-F238E27FC236}">
                  <a16:creationId xmlns:a16="http://schemas.microsoft.com/office/drawing/2014/main" id="{A80F1A87-F76F-3464-D59E-7984640ABC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93536" y="3959331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7" name="Line 40">
              <a:extLst>
                <a:ext uri="{FF2B5EF4-FFF2-40B4-BE49-F238E27FC236}">
                  <a16:creationId xmlns:a16="http://schemas.microsoft.com/office/drawing/2014/main" id="{27E6D409-0FA4-4387-845E-F4C7436B39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29652" y="3930843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0" name="Line 41">
              <a:extLst>
                <a:ext uri="{FF2B5EF4-FFF2-40B4-BE49-F238E27FC236}">
                  <a16:creationId xmlns:a16="http://schemas.microsoft.com/office/drawing/2014/main" id="{1593368C-D877-6D1B-C018-C5CFF678DF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86604" y="4083148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1" name="Line 42">
              <a:extLst>
                <a:ext uri="{FF2B5EF4-FFF2-40B4-BE49-F238E27FC236}">
                  <a16:creationId xmlns:a16="http://schemas.microsoft.com/office/drawing/2014/main" id="{1B8A9EB3-5396-8CA1-C743-B9C930E9430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22721" y="4054660"/>
              <a:ext cx="0" cy="6245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2" name="Line 43">
              <a:extLst>
                <a:ext uri="{FF2B5EF4-FFF2-40B4-BE49-F238E27FC236}">
                  <a16:creationId xmlns:a16="http://schemas.microsoft.com/office/drawing/2014/main" id="{4756CE22-653C-DC4D-DFDB-C4FAD4F007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5783" y="4151083"/>
              <a:ext cx="7084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3" name="Line 44">
              <a:extLst>
                <a:ext uri="{FF2B5EF4-FFF2-40B4-BE49-F238E27FC236}">
                  <a16:creationId xmlns:a16="http://schemas.microsoft.com/office/drawing/2014/main" id="{3A7BED8D-CA89-E5E7-FA78-9016828A983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01899" y="4122595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4" name="Line 45">
              <a:extLst>
                <a:ext uri="{FF2B5EF4-FFF2-40B4-BE49-F238E27FC236}">
                  <a16:creationId xmlns:a16="http://schemas.microsoft.com/office/drawing/2014/main" id="{694955CD-D6B6-4EDD-BE23-D75E090775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51948" y="4151083"/>
              <a:ext cx="7084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5" name="Line 46">
              <a:extLst>
                <a:ext uri="{FF2B5EF4-FFF2-40B4-BE49-F238E27FC236}">
                  <a16:creationId xmlns:a16="http://schemas.microsoft.com/office/drawing/2014/main" id="{9F336B84-EF5E-12AF-DE95-BC6B30BF97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86675" y="4122595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6" name="Line 47">
              <a:extLst>
                <a:ext uri="{FF2B5EF4-FFF2-40B4-BE49-F238E27FC236}">
                  <a16:creationId xmlns:a16="http://schemas.microsoft.com/office/drawing/2014/main" id="{07652FCC-D6A0-5907-81AA-DEC45156AD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22848" y="4151083"/>
              <a:ext cx="7084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7" name="Line 48">
              <a:extLst>
                <a:ext uri="{FF2B5EF4-FFF2-40B4-BE49-F238E27FC236}">
                  <a16:creationId xmlns:a16="http://schemas.microsoft.com/office/drawing/2014/main" id="{86469A0C-3827-C01D-8D8F-4E1A332E9E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58964" y="4122595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8" name="Line 49">
              <a:extLst>
                <a:ext uri="{FF2B5EF4-FFF2-40B4-BE49-F238E27FC236}">
                  <a16:creationId xmlns:a16="http://schemas.microsoft.com/office/drawing/2014/main" id="{E1E9B90E-AAE5-6C05-A298-25B514DAB8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16002" y="4449120"/>
              <a:ext cx="7084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9" name="Line 50">
              <a:extLst>
                <a:ext uri="{FF2B5EF4-FFF2-40B4-BE49-F238E27FC236}">
                  <a16:creationId xmlns:a16="http://schemas.microsoft.com/office/drawing/2014/main" id="{5ABB3BD1-51DB-45B9-5256-EEE43BE28E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52118" y="4420631"/>
              <a:ext cx="0" cy="6245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0" name="Line 51">
              <a:extLst>
                <a:ext uri="{FF2B5EF4-FFF2-40B4-BE49-F238E27FC236}">
                  <a16:creationId xmlns:a16="http://schemas.microsoft.com/office/drawing/2014/main" id="{15677497-0C0A-86C3-3027-896CA46FDD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3067" y="4691275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1" name="Line 52">
              <a:extLst>
                <a:ext uri="{FF2B5EF4-FFF2-40B4-BE49-F238E27FC236}">
                  <a16:creationId xmlns:a16="http://schemas.microsoft.com/office/drawing/2014/main" id="{CA2A8BAB-854C-4D42-5AD8-73AC1FEA93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09183" y="4663882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2" name="Line 53">
              <a:extLst>
                <a:ext uri="{FF2B5EF4-FFF2-40B4-BE49-F238E27FC236}">
                  <a16:creationId xmlns:a16="http://schemas.microsoft.com/office/drawing/2014/main" id="{529FAF5A-DF57-80FE-2C30-7955706B2C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3109" y="4691275"/>
              <a:ext cx="722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3" name="Line 54">
              <a:extLst>
                <a:ext uri="{FF2B5EF4-FFF2-40B4-BE49-F238E27FC236}">
                  <a16:creationId xmlns:a16="http://schemas.microsoft.com/office/drawing/2014/main" id="{1C516465-9AA2-D9AC-523F-83C871DF54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9225" y="4663882"/>
              <a:ext cx="0" cy="5588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4" name="Freeform 55">
              <a:extLst>
                <a:ext uri="{FF2B5EF4-FFF2-40B4-BE49-F238E27FC236}">
                  <a16:creationId xmlns:a16="http://schemas.microsoft.com/office/drawing/2014/main" id="{18A3855D-C097-2AB0-69BC-556D6B5818C6}"/>
                </a:ext>
              </a:extLst>
            </p:cNvPr>
            <p:cNvSpPr>
              <a:spLocks/>
            </p:cNvSpPr>
            <p:nvPr/>
          </p:nvSpPr>
          <p:spPr bwMode="auto">
            <a:xfrm>
              <a:off x="4801800" y="3513372"/>
              <a:ext cx="3407426" cy="1375134"/>
            </a:xfrm>
            <a:custGeom>
              <a:avLst/>
              <a:gdLst>
                <a:gd name="T0" fmla="*/ 0 w 477"/>
                <a:gd name="T1" fmla="*/ 0 h 244"/>
                <a:gd name="T2" fmla="*/ 1 w 477"/>
                <a:gd name="T3" fmla="*/ 0 h 244"/>
                <a:gd name="T4" fmla="*/ 1 w 477"/>
                <a:gd name="T5" fmla="*/ 12 h 244"/>
                <a:gd name="T6" fmla="*/ 2 w 477"/>
                <a:gd name="T7" fmla="*/ 12 h 244"/>
                <a:gd name="T8" fmla="*/ 2 w 477"/>
                <a:gd name="T9" fmla="*/ 23 h 244"/>
                <a:gd name="T10" fmla="*/ 2 w 477"/>
                <a:gd name="T11" fmla="*/ 23 h 244"/>
                <a:gd name="T12" fmla="*/ 2 w 477"/>
                <a:gd name="T13" fmla="*/ 34 h 244"/>
                <a:gd name="T14" fmla="*/ 3 w 477"/>
                <a:gd name="T15" fmla="*/ 34 h 244"/>
                <a:gd name="T16" fmla="*/ 3 w 477"/>
                <a:gd name="T17" fmla="*/ 45 h 244"/>
                <a:gd name="T18" fmla="*/ 3 w 477"/>
                <a:gd name="T19" fmla="*/ 45 h 244"/>
                <a:gd name="T20" fmla="*/ 3 w 477"/>
                <a:gd name="T21" fmla="*/ 56 h 244"/>
                <a:gd name="T22" fmla="*/ 4 w 477"/>
                <a:gd name="T23" fmla="*/ 56 h 244"/>
                <a:gd name="T24" fmla="*/ 4 w 477"/>
                <a:gd name="T25" fmla="*/ 67 h 244"/>
                <a:gd name="T26" fmla="*/ 6 w 477"/>
                <a:gd name="T27" fmla="*/ 67 h 244"/>
                <a:gd name="T28" fmla="*/ 6 w 477"/>
                <a:gd name="T29" fmla="*/ 79 h 244"/>
                <a:gd name="T30" fmla="*/ 11 w 477"/>
                <a:gd name="T31" fmla="*/ 79 h 244"/>
                <a:gd name="T32" fmla="*/ 11 w 477"/>
                <a:gd name="T33" fmla="*/ 90 h 244"/>
                <a:gd name="T34" fmla="*/ 11 w 477"/>
                <a:gd name="T35" fmla="*/ 90 h 244"/>
                <a:gd name="T36" fmla="*/ 11 w 477"/>
                <a:gd name="T37" fmla="*/ 101 h 244"/>
                <a:gd name="T38" fmla="*/ 21 w 477"/>
                <a:gd name="T39" fmla="*/ 101 h 244"/>
                <a:gd name="T40" fmla="*/ 21 w 477"/>
                <a:gd name="T41" fmla="*/ 114 h 244"/>
                <a:gd name="T42" fmla="*/ 49 w 477"/>
                <a:gd name="T43" fmla="*/ 114 h 244"/>
                <a:gd name="T44" fmla="*/ 49 w 477"/>
                <a:gd name="T45" fmla="*/ 127 h 244"/>
                <a:gd name="T46" fmla="*/ 59 w 477"/>
                <a:gd name="T47" fmla="*/ 127 h 244"/>
                <a:gd name="T48" fmla="*/ 59 w 477"/>
                <a:gd name="T49" fmla="*/ 140 h 244"/>
                <a:gd name="T50" fmla="*/ 64 w 477"/>
                <a:gd name="T51" fmla="*/ 140 h 244"/>
                <a:gd name="T52" fmla="*/ 64 w 477"/>
                <a:gd name="T53" fmla="*/ 154 h 244"/>
                <a:gd name="T54" fmla="*/ 95 w 477"/>
                <a:gd name="T55" fmla="*/ 154 h 244"/>
                <a:gd name="T56" fmla="*/ 95 w 477"/>
                <a:gd name="T57" fmla="*/ 168 h 244"/>
                <a:gd name="T58" fmla="*/ 141 w 477"/>
                <a:gd name="T59" fmla="*/ 168 h 244"/>
                <a:gd name="T60" fmla="*/ 141 w 477"/>
                <a:gd name="T61" fmla="*/ 182 h 244"/>
                <a:gd name="T62" fmla="*/ 173 w 477"/>
                <a:gd name="T63" fmla="*/ 182 h 244"/>
                <a:gd name="T64" fmla="*/ 173 w 477"/>
                <a:gd name="T65" fmla="*/ 198 h 244"/>
                <a:gd name="T66" fmla="*/ 231 w 477"/>
                <a:gd name="T67" fmla="*/ 198 h 244"/>
                <a:gd name="T68" fmla="*/ 231 w 477"/>
                <a:gd name="T69" fmla="*/ 217 h 244"/>
                <a:gd name="T70" fmla="*/ 409 w 477"/>
                <a:gd name="T71" fmla="*/ 217 h 244"/>
                <a:gd name="T72" fmla="*/ 409 w 477"/>
                <a:gd name="T73" fmla="*/ 244 h 244"/>
                <a:gd name="T74" fmla="*/ 477 w 477"/>
                <a:gd name="T75" fmla="*/ 244 h 2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477" h="244">
                  <a:moveTo>
                    <a:pt x="0" y="0"/>
                  </a:moveTo>
                  <a:lnTo>
                    <a:pt x="1" y="0"/>
                  </a:lnTo>
                  <a:lnTo>
                    <a:pt x="1" y="12"/>
                  </a:lnTo>
                  <a:lnTo>
                    <a:pt x="2" y="12"/>
                  </a:lnTo>
                  <a:lnTo>
                    <a:pt x="2" y="23"/>
                  </a:lnTo>
                  <a:lnTo>
                    <a:pt x="2" y="23"/>
                  </a:lnTo>
                  <a:lnTo>
                    <a:pt x="2" y="34"/>
                  </a:lnTo>
                  <a:lnTo>
                    <a:pt x="3" y="34"/>
                  </a:lnTo>
                  <a:lnTo>
                    <a:pt x="3" y="45"/>
                  </a:lnTo>
                  <a:lnTo>
                    <a:pt x="3" y="45"/>
                  </a:lnTo>
                  <a:lnTo>
                    <a:pt x="3" y="56"/>
                  </a:lnTo>
                  <a:lnTo>
                    <a:pt x="4" y="56"/>
                  </a:lnTo>
                  <a:lnTo>
                    <a:pt x="4" y="67"/>
                  </a:lnTo>
                  <a:lnTo>
                    <a:pt x="6" y="67"/>
                  </a:lnTo>
                  <a:lnTo>
                    <a:pt x="6" y="79"/>
                  </a:lnTo>
                  <a:lnTo>
                    <a:pt x="11" y="79"/>
                  </a:lnTo>
                  <a:lnTo>
                    <a:pt x="11" y="90"/>
                  </a:lnTo>
                  <a:lnTo>
                    <a:pt x="11" y="90"/>
                  </a:lnTo>
                  <a:lnTo>
                    <a:pt x="11" y="101"/>
                  </a:lnTo>
                  <a:lnTo>
                    <a:pt x="21" y="101"/>
                  </a:lnTo>
                  <a:lnTo>
                    <a:pt x="21" y="114"/>
                  </a:lnTo>
                  <a:lnTo>
                    <a:pt x="49" y="114"/>
                  </a:lnTo>
                  <a:lnTo>
                    <a:pt x="49" y="127"/>
                  </a:lnTo>
                  <a:lnTo>
                    <a:pt x="59" y="127"/>
                  </a:lnTo>
                  <a:lnTo>
                    <a:pt x="59" y="140"/>
                  </a:lnTo>
                  <a:lnTo>
                    <a:pt x="64" y="140"/>
                  </a:lnTo>
                  <a:lnTo>
                    <a:pt x="64" y="154"/>
                  </a:lnTo>
                  <a:lnTo>
                    <a:pt x="95" y="154"/>
                  </a:lnTo>
                  <a:lnTo>
                    <a:pt x="95" y="168"/>
                  </a:lnTo>
                  <a:lnTo>
                    <a:pt x="141" y="168"/>
                  </a:lnTo>
                  <a:lnTo>
                    <a:pt x="141" y="182"/>
                  </a:lnTo>
                  <a:lnTo>
                    <a:pt x="173" y="182"/>
                  </a:lnTo>
                  <a:lnTo>
                    <a:pt x="173" y="198"/>
                  </a:lnTo>
                  <a:lnTo>
                    <a:pt x="231" y="198"/>
                  </a:lnTo>
                  <a:lnTo>
                    <a:pt x="231" y="217"/>
                  </a:lnTo>
                  <a:lnTo>
                    <a:pt x="409" y="217"/>
                  </a:lnTo>
                  <a:lnTo>
                    <a:pt x="409" y="244"/>
                  </a:lnTo>
                  <a:lnTo>
                    <a:pt x="477" y="244"/>
                  </a:lnTo>
                </a:path>
              </a:pathLst>
            </a:custGeom>
            <a:noFill/>
            <a:ln w="1905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5" name="Line 56">
              <a:extLst>
                <a:ext uri="{FF2B5EF4-FFF2-40B4-BE49-F238E27FC236}">
                  <a16:creationId xmlns:a16="http://schemas.microsoft.com/office/drawing/2014/main" id="{44A358C7-8DC8-5D2F-8711-11A7F5A146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72643" y="4083148"/>
              <a:ext cx="70844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6" name="Line 57">
              <a:extLst>
                <a:ext uri="{FF2B5EF4-FFF2-40B4-BE49-F238E27FC236}">
                  <a16:creationId xmlns:a16="http://schemas.microsoft.com/office/drawing/2014/main" id="{D7D03EFB-FA41-6E1B-2677-C96579586B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08759" y="4054660"/>
              <a:ext cx="0" cy="5697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7" name="Line 58">
              <a:extLst>
                <a:ext uri="{FF2B5EF4-FFF2-40B4-BE49-F238E27FC236}">
                  <a16:creationId xmlns:a16="http://schemas.microsoft.com/office/drawing/2014/main" id="{BB8FD951-6091-6BB2-2D51-A6F974786B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79589" y="4083148"/>
              <a:ext cx="72232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8" name="Line 59">
              <a:extLst>
                <a:ext uri="{FF2B5EF4-FFF2-40B4-BE49-F238E27FC236}">
                  <a16:creationId xmlns:a16="http://schemas.microsoft.com/office/drawing/2014/main" id="{9D5C6221-84D8-3B57-47DF-6E4EA8D21C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15705" y="4054660"/>
              <a:ext cx="0" cy="5697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9" name="Line 60">
              <a:extLst>
                <a:ext uri="{FF2B5EF4-FFF2-40B4-BE49-F238E27FC236}">
                  <a16:creationId xmlns:a16="http://schemas.microsoft.com/office/drawing/2014/main" id="{52DDDAC4-2702-D6E7-3AD2-62F62FEA77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86534" y="4083148"/>
              <a:ext cx="79178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0" name="Line 61">
              <a:extLst>
                <a:ext uri="{FF2B5EF4-FFF2-40B4-BE49-F238E27FC236}">
                  <a16:creationId xmlns:a16="http://schemas.microsoft.com/office/drawing/2014/main" id="{EA216817-70E8-0AAE-66C1-EB3671CE6C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29596" y="4054660"/>
              <a:ext cx="0" cy="5697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1" name="Line 62">
              <a:extLst>
                <a:ext uri="{FF2B5EF4-FFF2-40B4-BE49-F238E27FC236}">
                  <a16:creationId xmlns:a16="http://schemas.microsoft.com/office/drawing/2014/main" id="{A23C319C-D43D-5D5C-9C7C-084C79E17A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93494" y="4156562"/>
              <a:ext cx="72232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2" name="Line 63">
              <a:extLst>
                <a:ext uri="{FF2B5EF4-FFF2-40B4-BE49-F238E27FC236}">
                  <a16:creationId xmlns:a16="http://schemas.microsoft.com/office/drawing/2014/main" id="{6359F5BE-0FE5-C0E0-2803-469F346479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29610" y="4122595"/>
              <a:ext cx="0" cy="61361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3" name="Line 64">
              <a:extLst>
                <a:ext uri="{FF2B5EF4-FFF2-40B4-BE49-F238E27FC236}">
                  <a16:creationId xmlns:a16="http://schemas.microsoft.com/office/drawing/2014/main" id="{372529BD-F268-11E6-3B1B-F0FEEF50E8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58809" y="4381185"/>
              <a:ext cx="77789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4" name="Line 65">
              <a:extLst>
                <a:ext uri="{FF2B5EF4-FFF2-40B4-BE49-F238E27FC236}">
                  <a16:creationId xmlns:a16="http://schemas.microsoft.com/office/drawing/2014/main" id="{F441F694-14A3-F142-011E-1195101069F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93536" y="4348314"/>
              <a:ext cx="0" cy="61361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5" name="Line 66">
              <a:extLst>
                <a:ext uri="{FF2B5EF4-FFF2-40B4-BE49-F238E27FC236}">
                  <a16:creationId xmlns:a16="http://schemas.microsoft.com/office/drawing/2014/main" id="{833C1F90-A7ED-1E89-49C5-0E49A710FA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93607" y="4538970"/>
              <a:ext cx="72232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6" name="Line 67">
              <a:extLst>
                <a:ext uri="{FF2B5EF4-FFF2-40B4-BE49-F238E27FC236}">
                  <a16:creationId xmlns:a16="http://schemas.microsoft.com/office/drawing/2014/main" id="{265C8076-4844-A863-560F-552EF65FB5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29723" y="4511576"/>
              <a:ext cx="0" cy="5588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7" name="Line 68">
              <a:extLst>
                <a:ext uri="{FF2B5EF4-FFF2-40B4-BE49-F238E27FC236}">
                  <a16:creationId xmlns:a16="http://schemas.microsoft.com/office/drawing/2014/main" id="{1EBD58F7-8ACE-08DC-C1F4-4B5F592BE0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79730" y="4538970"/>
              <a:ext cx="72232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8" name="Line 69">
              <a:extLst>
                <a:ext uri="{FF2B5EF4-FFF2-40B4-BE49-F238E27FC236}">
                  <a16:creationId xmlns:a16="http://schemas.microsoft.com/office/drawing/2014/main" id="{7283932E-D6C0-A346-57F7-3583048C06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15846" y="4511576"/>
              <a:ext cx="0" cy="5588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9" name="Line 70">
              <a:extLst>
                <a:ext uri="{FF2B5EF4-FFF2-40B4-BE49-F238E27FC236}">
                  <a16:creationId xmlns:a16="http://schemas.microsoft.com/office/drawing/2014/main" id="{706F4672-ECE1-21A2-43D4-1D930C398E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43656" y="4629914"/>
              <a:ext cx="72232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0" name="Line 71">
              <a:extLst>
                <a:ext uri="{FF2B5EF4-FFF2-40B4-BE49-F238E27FC236}">
                  <a16:creationId xmlns:a16="http://schemas.microsoft.com/office/drawing/2014/main" id="{61FAF895-8EE0-4BB0-A384-B6D342A7E0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79772" y="4601426"/>
              <a:ext cx="0" cy="5588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1" name="Line 72">
              <a:extLst>
                <a:ext uri="{FF2B5EF4-FFF2-40B4-BE49-F238E27FC236}">
                  <a16:creationId xmlns:a16="http://schemas.microsoft.com/office/drawing/2014/main" id="{2CA21B24-61FD-118F-422E-800C3D150E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572883" y="4736200"/>
              <a:ext cx="70844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2" name="Line 73">
              <a:extLst>
                <a:ext uri="{FF2B5EF4-FFF2-40B4-BE49-F238E27FC236}">
                  <a16:creationId xmlns:a16="http://schemas.microsoft.com/office/drawing/2014/main" id="{A3B03DE5-4664-69AD-872F-31DCF18A85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608999" y="4703328"/>
              <a:ext cx="0" cy="61361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3" name="Line 74">
              <a:extLst>
                <a:ext uri="{FF2B5EF4-FFF2-40B4-BE49-F238E27FC236}">
                  <a16:creationId xmlns:a16="http://schemas.microsoft.com/office/drawing/2014/main" id="{A8F512BD-170E-3958-69A7-E0EE27E4BA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02068" y="4736200"/>
              <a:ext cx="70844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4" name="Line 75">
              <a:extLst>
                <a:ext uri="{FF2B5EF4-FFF2-40B4-BE49-F238E27FC236}">
                  <a16:creationId xmlns:a16="http://schemas.microsoft.com/office/drawing/2014/main" id="{C2563887-6BDD-4745-8691-E853A3183F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36795" y="4703328"/>
              <a:ext cx="0" cy="61361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5" name="Line 76">
              <a:extLst>
                <a:ext uri="{FF2B5EF4-FFF2-40B4-BE49-F238E27FC236}">
                  <a16:creationId xmlns:a16="http://schemas.microsoft.com/office/drawing/2014/main" id="{85578FB3-5687-E848-FC71-72560661ED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22904" y="4736200"/>
              <a:ext cx="70844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6" name="Line 77">
              <a:extLst>
                <a:ext uri="{FF2B5EF4-FFF2-40B4-BE49-F238E27FC236}">
                  <a16:creationId xmlns:a16="http://schemas.microsoft.com/office/drawing/2014/main" id="{EDA9EC0B-E62F-D2D3-FAD1-6089B123C9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759020" y="4703328"/>
              <a:ext cx="0" cy="61361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7" name="Line 78">
              <a:extLst>
                <a:ext uri="{FF2B5EF4-FFF2-40B4-BE49-F238E27FC236}">
                  <a16:creationId xmlns:a16="http://schemas.microsoft.com/office/drawing/2014/main" id="{033F80E2-5A72-6B0E-E863-7472ECF43D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59190" y="4888505"/>
              <a:ext cx="77789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8" name="Line 79">
              <a:extLst>
                <a:ext uri="{FF2B5EF4-FFF2-40B4-BE49-F238E27FC236}">
                  <a16:creationId xmlns:a16="http://schemas.microsoft.com/office/drawing/2014/main" id="{62B2DC97-445D-9053-79D5-EC8D344BB2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95306" y="4861112"/>
              <a:ext cx="0" cy="5588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9" name="Line 80">
              <a:extLst>
                <a:ext uri="{FF2B5EF4-FFF2-40B4-BE49-F238E27FC236}">
                  <a16:creationId xmlns:a16="http://schemas.microsoft.com/office/drawing/2014/main" id="{5369A5AA-6D6E-7980-71CE-D25FE54CFD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3109" y="4888505"/>
              <a:ext cx="72232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0" name="Line 81">
              <a:extLst>
                <a:ext uri="{FF2B5EF4-FFF2-40B4-BE49-F238E27FC236}">
                  <a16:creationId xmlns:a16="http://schemas.microsoft.com/office/drawing/2014/main" id="{8E85DE04-65A2-AF73-E3AF-29429E7AA1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9225" y="4861112"/>
              <a:ext cx="0" cy="5588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1" name="Freeform 82">
              <a:extLst>
                <a:ext uri="{FF2B5EF4-FFF2-40B4-BE49-F238E27FC236}">
                  <a16:creationId xmlns:a16="http://schemas.microsoft.com/office/drawing/2014/main" id="{D8E4B44D-0550-3A9F-AE73-3FC017ABC989}"/>
                </a:ext>
              </a:extLst>
            </p:cNvPr>
            <p:cNvSpPr>
              <a:spLocks/>
            </p:cNvSpPr>
            <p:nvPr/>
          </p:nvSpPr>
          <p:spPr bwMode="auto">
            <a:xfrm>
              <a:off x="4801800" y="3513372"/>
              <a:ext cx="3407426" cy="586213"/>
            </a:xfrm>
            <a:custGeom>
              <a:avLst/>
              <a:gdLst>
                <a:gd name="T0" fmla="*/ 0 w 477"/>
                <a:gd name="T1" fmla="*/ 0 h 104"/>
                <a:gd name="T2" fmla="*/ 3 w 477"/>
                <a:gd name="T3" fmla="*/ 0 h 104"/>
                <a:gd name="T4" fmla="*/ 3 w 477"/>
                <a:gd name="T5" fmla="*/ 11 h 104"/>
                <a:gd name="T6" fmla="*/ 9 w 477"/>
                <a:gd name="T7" fmla="*/ 11 h 104"/>
                <a:gd name="T8" fmla="*/ 9 w 477"/>
                <a:gd name="T9" fmla="*/ 22 h 104"/>
                <a:gd name="T10" fmla="*/ 33 w 477"/>
                <a:gd name="T11" fmla="*/ 22 h 104"/>
                <a:gd name="T12" fmla="*/ 33 w 477"/>
                <a:gd name="T13" fmla="*/ 34 h 104"/>
                <a:gd name="T14" fmla="*/ 52 w 477"/>
                <a:gd name="T15" fmla="*/ 34 h 104"/>
                <a:gd name="T16" fmla="*/ 52 w 477"/>
                <a:gd name="T17" fmla="*/ 47 h 104"/>
                <a:gd name="T18" fmla="*/ 130 w 477"/>
                <a:gd name="T19" fmla="*/ 47 h 104"/>
                <a:gd name="T20" fmla="*/ 130 w 477"/>
                <a:gd name="T21" fmla="*/ 65 h 104"/>
                <a:gd name="T22" fmla="*/ 273 w 477"/>
                <a:gd name="T23" fmla="*/ 65 h 104"/>
                <a:gd name="T24" fmla="*/ 273 w 477"/>
                <a:gd name="T25" fmla="*/ 84 h 104"/>
                <a:gd name="T26" fmla="*/ 284 w 477"/>
                <a:gd name="T27" fmla="*/ 84 h 104"/>
                <a:gd name="T28" fmla="*/ 284 w 477"/>
                <a:gd name="T29" fmla="*/ 104 h 104"/>
                <a:gd name="T30" fmla="*/ 477 w 477"/>
                <a:gd name="T31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477" h="104">
                  <a:moveTo>
                    <a:pt x="0" y="0"/>
                  </a:moveTo>
                  <a:lnTo>
                    <a:pt x="3" y="0"/>
                  </a:lnTo>
                  <a:lnTo>
                    <a:pt x="3" y="11"/>
                  </a:lnTo>
                  <a:lnTo>
                    <a:pt x="9" y="11"/>
                  </a:lnTo>
                  <a:lnTo>
                    <a:pt x="9" y="22"/>
                  </a:lnTo>
                  <a:lnTo>
                    <a:pt x="33" y="22"/>
                  </a:lnTo>
                  <a:lnTo>
                    <a:pt x="33" y="34"/>
                  </a:lnTo>
                  <a:lnTo>
                    <a:pt x="52" y="34"/>
                  </a:lnTo>
                  <a:lnTo>
                    <a:pt x="52" y="47"/>
                  </a:lnTo>
                  <a:lnTo>
                    <a:pt x="130" y="47"/>
                  </a:lnTo>
                  <a:lnTo>
                    <a:pt x="130" y="65"/>
                  </a:lnTo>
                  <a:lnTo>
                    <a:pt x="273" y="65"/>
                  </a:lnTo>
                  <a:lnTo>
                    <a:pt x="273" y="84"/>
                  </a:lnTo>
                  <a:lnTo>
                    <a:pt x="284" y="84"/>
                  </a:lnTo>
                  <a:lnTo>
                    <a:pt x="284" y="104"/>
                  </a:lnTo>
                  <a:lnTo>
                    <a:pt x="477" y="104"/>
                  </a:lnTo>
                </a:path>
              </a:pathLst>
            </a:custGeom>
            <a:noFill/>
            <a:ln w="19050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2" name="Line 83">
              <a:extLst>
                <a:ext uri="{FF2B5EF4-FFF2-40B4-BE49-F238E27FC236}">
                  <a16:creationId xmlns:a16="http://schemas.microsoft.com/office/drawing/2014/main" id="{427C969D-221A-3716-5A80-387EFD4BCA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9575" y="3513372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3" name="Line 84">
              <a:extLst>
                <a:ext uri="{FF2B5EF4-FFF2-40B4-BE49-F238E27FC236}">
                  <a16:creationId xmlns:a16="http://schemas.microsoft.com/office/drawing/2014/main" id="{E67D5A87-A3AB-3B3E-18DD-CDEEE4475F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15691" y="3485979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4" name="Line 85">
              <a:extLst>
                <a:ext uri="{FF2B5EF4-FFF2-40B4-BE49-F238E27FC236}">
                  <a16:creationId xmlns:a16="http://schemas.microsoft.com/office/drawing/2014/main" id="{26931F28-F5BA-002E-1CA4-1193EA00FD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1800" y="3575828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5" name="Line 86">
              <a:extLst>
                <a:ext uri="{FF2B5EF4-FFF2-40B4-BE49-F238E27FC236}">
                  <a16:creationId xmlns:a16="http://schemas.microsoft.com/office/drawing/2014/main" id="{36F2CE1F-4235-447E-BA05-BB7E2E6856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36527" y="3547339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6" name="Line 87">
              <a:extLst>
                <a:ext uri="{FF2B5EF4-FFF2-40B4-BE49-F238E27FC236}">
                  <a16:creationId xmlns:a16="http://schemas.microsoft.com/office/drawing/2014/main" id="{2E2877E0-9150-444C-86E3-7B2300C0148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8745" y="3575828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7" name="Line 88">
              <a:extLst>
                <a:ext uri="{FF2B5EF4-FFF2-40B4-BE49-F238E27FC236}">
                  <a16:creationId xmlns:a16="http://schemas.microsoft.com/office/drawing/2014/main" id="{D60615DE-A088-DFD8-3219-1F66BF0084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43473" y="3547339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8" name="Line 89">
              <a:extLst>
                <a:ext uri="{FF2B5EF4-FFF2-40B4-BE49-F238E27FC236}">
                  <a16:creationId xmlns:a16="http://schemas.microsoft.com/office/drawing/2014/main" id="{27F449D7-E233-B996-030F-525F265F6B4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2636" y="3575828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9" name="Line 90">
              <a:extLst>
                <a:ext uri="{FF2B5EF4-FFF2-40B4-BE49-F238E27FC236}">
                  <a16:creationId xmlns:a16="http://schemas.microsoft.com/office/drawing/2014/main" id="{E032C23E-9A61-65E3-EB9F-AFBF25D03D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58752" y="3547339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0" name="Line 91">
              <a:extLst>
                <a:ext uri="{FF2B5EF4-FFF2-40B4-BE49-F238E27FC236}">
                  <a16:creationId xmlns:a16="http://schemas.microsoft.com/office/drawing/2014/main" id="{0A560F7F-9957-C272-1B3E-26696E5E2D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36527" y="3637189"/>
              <a:ext cx="79178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1" name="Line 92">
              <a:extLst>
                <a:ext uri="{FF2B5EF4-FFF2-40B4-BE49-F238E27FC236}">
                  <a16:creationId xmlns:a16="http://schemas.microsoft.com/office/drawing/2014/main" id="{4EC48919-7E7C-3310-9A0A-A1F6D21ED5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79589" y="3609796"/>
              <a:ext cx="0" cy="61361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2" name="Line 93">
              <a:extLst>
                <a:ext uri="{FF2B5EF4-FFF2-40B4-BE49-F238E27FC236}">
                  <a16:creationId xmlns:a16="http://schemas.microsoft.com/office/drawing/2014/main" id="{3F08087B-D114-EE2C-F324-85EA090FA6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65726" y="3705123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3" name="Line 94">
              <a:extLst>
                <a:ext uri="{FF2B5EF4-FFF2-40B4-BE49-F238E27FC236}">
                  <a16:creationId xmlns:a16="http://schemas.microsoft.com/office/drawing/2014/main" id="{5BEFEB02-93F3-F4F4-51F8-4EB703AA059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01843" y="3676635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4" name="Line 95">
              <a:extLst>
                <a:ext uri="{FF2B5EF4-FFF2-40B4-BE49-F238E27FC236}">
                  <a16:creationId xmlns:a16="http://schemas.microsoft.com/office/drawing/2014/main" id="{74C89F1F-2558-3455-012E-262C480F2D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9624" y="3705123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5" name="Line 96">
              <a:extLst>
                <a:ext uri="{FF2B5EF4-FFF2-40B4-BE49-F238E27FC236}">
                  <a16:creationId xmlns:a16="http://schemas.microsoft.com/office/drawing/2014/main" id="{5FB28700-C53B-B13F-ED59-D568B2FD68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65740" y="3676635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6" name="Line 97">
              <a:extLst>
                <a:ext uri="{FF2B5EF4-FFF2-40B4-BE49-F238E27FC236}">
                  <a16:creationId xmlns:a16="http://schemas.microsoft.com/office/drawing/2014/main" id="{CD44D2D1-00BD-138C-4901-AC4535ADA7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15747" y="3778537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7" name="Line 98">
              <a:extLst>
                <a:ext uri="{FF2B5EF4-FFF2-40B4-BE49-F238E27FC236}">
                  <a16:creationId xmlns:a16="http://schemas.microsoft.com/office/drawing/2014/main" id="{30129079-1B88-83B1-91CB-FD408242CE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51864" y="3750048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8" name="Line 99">
              <a:extLst>
                <a:ext uri="{FF2B5EF4-FFF2-40B4-BE49-F238E27FC236}">
                  <a16:creationId xmlns:a16="http://schemas.microsoft.com/office/drawing/2014/main" id="{A59DF4D3-D9C5-D522-09FA-D34D917857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9638" y="3778537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9" name="Line 100">
              <a:extLst>
                <a:ext uri="{FF2B5EF4-FFF2-40B4-BE49-F238E27FC236}">
                  <a16:creationId xmlns:a16="http://schemas.microsoft.com/office/drawing/2014/main" id="{805B302C-9E03-FB05-9E2B-3C18BE261E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65755" y="3750048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9" name="Line 101">
              <a:extLst>
                <a:ext uri="{FF2B5EF4-FFF2-40B4-BE49-F238E27FC236}">
                  <a16:creationId xmlns:a16="http://schemas.microsoft.com/office/drawing/2014/main" id="{D2D80973-9AA9-FF77-26E2-6A1FDBA474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51864" y="3778537"/>
              <a:ext cx="77789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0" name="Line 102">
              <a:extLst>
                <a:ext uri="{FF2B5EF4-FFF2-40B4-BE49-F238E27FC236}">
                  <a16:creationId xmlns:a16="http://schemas.microsoft.com/office/drawing/2014/main" id="{E60C80B2-93F3-D0D9-9579-F8148AE686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86590" y="3750048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1" name="Line 103">
              <a:extLst>
                <a:ext uri="{FF2B5EF4-FFF2-40B4-BE49-F238E27FC236}">
                  <a16:creationId xmlns:a16="http://schemas.microsoft.com/office/drawing/2014/main" id="{6EDAAA7B-3C8D-45B8-0F9F-C0D1BAA54E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79645" y="3778537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2" name="Line 104">
              <a:extLst>
                <a:ext uri="{FF2B5EF4-FFF2-40B4-BE49-F238E27FC236}">
                  <a16:creationId xmlns:a16="http://schemas.microsoft.com/office/drawing/2014/main" id="{6167F782-5FDF-573E-C0AD-28C85BB599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15762" y="3750048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3" name="Line 105">
              <a:extLst>
                <a:ext uri="{FF2B5EF4-FFF2-40B4-BE49-F238E27FC236}">
                  <a16:creationId xmlns:a16="http://schemas.microsoft.com/office/drawing/2014/main" id="{29F89EBE-F66E-C68D-07A8-06CDAB7940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36597" y="3778537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4" name="Line 106">
              <a:extLst>
                <a:ext uri="{FF2B5EF4-FFF2-40B4-BE49-F238E27FC236}">
                  <a16:creationId xmlns:a16="http://schemas.microsoft.com/office/drawing/2014/main" id="{2C954536-D776-47AC-8417-0206014EC0C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72714" y="3750048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5" name="Line 107">
              <a:extLst>
                <a:ext uri="{FF2B5EF4-FFF2-40B4-BE49-F238E27FC236}">
                  <a16:creationId xmlns:a16="http://schemas.microsoft.com/office/drawing/2014/main" id="{27775A5B-ED5F-6FB9-E355-6F18B7991C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65797" y="3778537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6" name="Line 108">
              <a:extLst>
                <a:ext uri="{FF2B5EF4-FFF2-40B4-BE49-F238E27FC236}">
                  <a16:creationId xmlns:a16="http://schemas.microsoft.com/office/drawing/2014/main" id="{60D87AA1-4B37-AE8E-E2E9-DC7C968A201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01913" y="3750048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7" name="Line 109">
              <a:extLst>
                <a:ext uri="{FF2B5EF4-FFF2-40B4-BE49-F238E27FC236}">
                  <a16:creationId xmlns:a16="http://schemas.microsoft.com/office/drawing/2014/main" id="{061F70AB-E34B-1FD4-1076-866681428F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6640" y="3778537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4" name="Line 110">
              <a:extLst>
                <a:ext uri="{FF2B5EF4-FFF2-40B4-BE49-F238E27FC236}">
                  <a16:creationId xmlns:a16="http://schemas.microsoft.com/office/drawing/2014/main" id="{C9702FA2-1FA9-5373-B4A8-897748F7A2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72756" y="3750048"/>
              <a:ext cx="0" cy="5697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3" name="Line 111">
              <a:extLst>
                <a:ext uri="{FF2B5EF4-FFF2-40B4-BE49-F238E27FC236}">
                  <a16:creationId xmlns:a16="http://schemas.microsoft.com/office/drawing/2014/main" id="{E9FB481F-26D4-48CC-A5DF-A6C29742B5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5818" y="3880439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4" name="Line 112">
              <a:extLst>
                <a:ext uri="{FF2B5EF4-FFF2-40B4-BE49-F238E27FC236}">
                  <a16:creationId xmlns:a16="http://schemas.microsoft.com/office/drawing/2014/main" id="{8B01B0D0-88E8-A6B7-19E0-D84BAA937F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51934" y="3851950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5" name="Line 113">
              <a:extLst>
                <a:ext uri="{FF2B5EF4-FFF2-40B4-BE49-F238E27FC236}">
                  <a16:creationId xmlns:a16="http://schemas.microsoft.com/office/drawing/2014/main" id="{FFD4DDB8-2FA3-8908-3947-E662C7A46A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36739" y="3880439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6" name="Line 114">
              <a:extLst>
                <a:ext uri="{FF2B5EF4-FFF2-40B4-BE49-F238E27FC236}">
                  <a16:creationId xmlns:a16="http://schemas.microsoft.com/office/drawing/2014/main" id="{3C24B0A9-5FF7-9308-BD8B-0369CBCDED4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72855" y="3851950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7" name="Line 115">
              <a:extLst>
                <a:ext uri="{FF2B5EF4-FFF2-40B4-BE49-F238E27FC236}">
                  <a16:creationId xmlns:a16="http://schemas.microsoft.com/office/drawing/2014/main" id="{2E3ED362-0307-8691-C727-8C14B9C259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36880" y="4099584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8" name="Line 116">
              <a:extLst>
                <a:ext uri="{FF2B5EF4-FFF2-40B4-BE49-F238E27FC236}">
                  <a16:creationId xmlns:a16="http://schemas.microsoft.com/office/drawing/2014/main" id="{AFBDA33D-6702-A096-5EF8-049F01A3ED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72996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5" name="Line 117">
              <a:extLst>
                <a:ext uri="{FF2B5EF4-FFF2-40B4-BE49-F238E27FC236}">
                  <a16:creationId xmlns:a16="http://schemas.microsoft.com/office/drawing/2014/main" id="{51738E3E-9053-06D4-759A-47653DAF39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02167" y="4099584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6" name="Line 118">
              <a:extLst>
                <a:ext uri="{FF2B5EF4-FFF2-40B4-BE49-F238E27FC236}">
                  <a16:creationId xmlns:a16="http://schemas.microsoft.com/office/drawing/2014/main" id="{B2592F43-B0BE-86FC-1AF5-F8DB9D66D2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36894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7" name="Line 119">
              <a:extLst>
                <a:ext uri="{FF2B5EF4-FFF2-40B4-BE49-F238E27FC236}">
                  <a16:creationId xmlns:a16="http://schemas.microsoft.com/office/drawing/2014/main" id="{A68685AA-090F-7EA1-7198-6BD9AB701F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73024" y="4099584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8" name="Line 120">
              <a:extLst>
                <a:ext uri="{FF2B5EF4-FFF2-40B4-BE49-F238E27FC236}">
                  <a16:creationId xmlns:a16="http://schemas.microsoft.com/office/drawing/2014/main" id="{6C04D03D-3E18-A621-7522-40EA51FC0D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09140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9" name="Line 121">
              <a:extLst>
                <a:ext uri="{FF2B5EF4-FFF2-40B4-BE49-F238E27FC236}">
                  <a16:creationId xmlns:a16="http://schemas.microsoft.com/office/drawing/2014/main" id="{081FC25C-4575-9CA6-EA71-EA8540CF73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2202" y="4099584"/>
              <a:ext cx="77789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4" name="Line 122">
              <a:extLst>
                <a:ext uri="{FF2B5EF4-FFF2-40B4-BE49-F238E27FC236}">
                  <a16:creationId xmlns:a16="http://schemas.microsoft.com/office/drawing/2014/main" id="{02ADFF3B-712B-F64A-2B94-20ADCC60D4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95264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5" name="Line 123">
              <a:extLst>
                <a:ext uri="{FF2B5EF4-FFF2-40B4-BE49-F238E27FC236}">
                  <a16:creationId xmlns:a16="http://schemas.microsoft.com/office/drawing/2014/main" id="{5DD481A3-2050-ED95-E597-54B7AAAAEB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45313" y="4099584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6" name="Line 124">
              <a:extLst>
                <a:ext uri="{FF2B5EF4-FFF2-40B4-BE49-F238E27FC236}">
                  <a16:creationId xmlns:a16="http://schemas.microsoft.com/office/drawing/2014/main" id="{1462961A-8FA0-25F8-7E09-FF2DD1FF01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80041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7" name="Line 125">
              <a:extLst>
                <a:ext uri="{FF2B5EF4-FFF2-40B4-BE49-F238E27FC236}">
                  <a16:creationId xmlns:a16="http://schemas.microsoft.com/office/drawing/2014/main" id="{B179516D-DC4B-C640-94A8-1EF5CE3EBD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95320" y="4099584"/>
              <a:ext cx="70844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8" name="Line 126">
              <a:extLst>
                <a:ext uri="{FF2B5EF4-FFF2-40B4-BE49-F238E27FC236}">
                  <a16:creationId xmlns:a16="http://schemas.microsoft.com/office/drawing/2014/main" id="{826BE80F-A09D-3045-B441-8462D350CF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30048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9" name="Line 127">
              <a:extLst>
                <a:ext uri="{FF2B5EF4-FFF2-40B4-BE49-F238E27FC236}">
                  <a16:creationId xmlns:a16="http://schemas.microsoft.com/office/drawing/2014/main" id="{1C445F38-6F86-4302-3653-166CFC6AD0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02266" y="4099584"/>
              <a:ext cx="77789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0" name="Line 128">
              <a:extLst>
                <a:ext uri="{FF2B5EF4-FFF2-40B4-BE49-F238E27FC236}">
                  <a16:creationId xmlns:a16="http://schemas.microsoft.com/office/drawing/2014/main" id="{19C94190-6645-01C0-1EDE-B5B18DD0A7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45327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1" name="Line 129">
              <a:extLst>
                <a:ext uri="{FF2B5EF4-FFF2-40B4-BE49-F238E27FC236}">
                  <a16:creationId xmlns:a16="http://schemas.microsoft.com/office/drawing/2014/main" id="{F8BC5851-CC35-10A5-BA8D-F724B921CE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3109" y="4099584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2" name="Line 130">
              <a:extLst>
                <a:ext uri="{FF2B5EF4-FFF2-40B4-BE49-F238E27FC236}">
                  <a16:creationId xmlns:a16="http://schemas.microsoft.com/office/drawing/2014/main" id="{8BF56953-B169-06E6-E8AE-ED993EF216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9225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3" name="Line 131">
              <a:extLst>
                <a:ext uri="{FF2B5EF4-FFF2-40B4-BE49-F238E27FC236}">
                  <a16:creationId xmlns:a16="http://schemas.microsoft.com/office/drawing/2014/main" id="{EF4173BD-7C6A-9038-145D-3604A6C741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3109" y="4099584"/>
              <a:ext cx="72232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6" name="Line 132">
              <a:extLst>
                <a:ext uri="{FF2B5EF4-FFF2-40B4-BE49-F238E27FC236}">
                  <a16:creationId xmlns:a16="http://schemas.microsoft.com/office/drawing/2014/main" id="{927CE2C0-3DA4-1D76-F7C9-23116BBE38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9225" y="4072191"/>
              <a:ext cx="0" cy="5588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3" name="Freeform 133">
              <a:extLst>
                <a:ext uri="{FF2B5EF4-FFF2-40B4-BE49-F238E27FC236}">
                  <a16:creationId xmlns:a16="http://schemas.microsoft.com/office/drawing/2014/main" id="{09ACADCC-EC54-158E-BB7C-1B96877AA2EF}"/>
                </a:ext>
              </a:extLst>
            </p:cNvPr>
            <p:cNvSpPr>
              <a:spLocks/>
            </p:cNvSpPr>
            <p:nvPr/>
          </p:nvSpPr>
          <p:spPr bwMode="auto">
            <a:xfrm>
              <a:off x="4801800" y="3513372"/>
              <a:ext cx="3407426" cy="1679745"/>
            </a:xfrm>
            <a:custGeom>
              <a:avLst/>
              <a:gdLst>
                <a:gd name="T0" fmla="*/ 0 w 477"/>
                <a:gd name="T1" fmla="*/ 0 h 298"/>
                <a:gd name="T2" fmla="*/ 3 w 477"/>
                <a:gd name="T3" fmla="*/ 0 h 298"/>
                <a:gd name="T4" fmla="*/ 3 w 477"/>
                <a:gd name="T5" fmla="*/ 11 h 298"/>
                <a:gd name="T6" fmla="*/ 14 w 477"/>
                <a:gd name="T7" fmla="*/ 11 h 298"/>
                <a:gd name="T8" fmla="*/ 14 w 477"/>
                <a:gd name="T9" fmla="*/ 24 h 298"/>
                <a:gd name="T10" fmla="*/ 16 w 477"/>
                <a:gd name="T11" fmla="*/ 24 h 298"/>
                <a:gd name="T12" fmla="*/ 16 w 477"/>
                <a:gd name="T13" fmla="*/ 38 h 298"/>
                <a:gd name="T14" fmla="*/ 52 w 477"/>
                <a:gd name="T15" fmla="*/ 38 h 298"/>
                <a:gd name="T16" fmla="*/ 52 w 477"/>
                <a:gd name="T17" fmla="*/ 57 h 298"/>
                <a:gd name="T18" fmla="*/ 65 w 477"/>
                <a:gd name="T19" fmla="*/ 57 h 298"/>
                <a:gd name="T20" fmla="*/ 65 w 477"/>
                <a:gd name="T21" fmla="*/ 76 h 298"/>
                <a:gd name="T22" fmla="*/ 75 w 477"/>
                <a:gd name="T23" fmla="*/ 76 h 298"/>
                <a:gd name="T24" fmla="*/ 75 w 477"/>
                <a:gd name="T25" fmla="*/ 95 h 298"/>
                <a:gd name="T26" fmla="*/ 78 w 477"/>
                <a:gd name="T27" fmla="*/ 95 h 298"/>
                <a:gd name="T28" fmla="*/ 78 w 477"/>
                <a:gd name="T29" fmla="*/ 114 h 298"/>
                <a:gd name="T30" fmla="*/ 93 w 477"/>
                <a:gd name="T31" fmla="*/ 114 h 298"/>
                <a:gd name="T32" fmla="*/ 93 w 477"/>
                <a:gd name="T33" fmla="*/ 138 h 298"/>
                <a:gd name="T34" fmla="*/ 232 w 477"/>
                <a:gd name="T35" fmla="*/ 138 h 298"/>
                <a:gd name="T36" fmla="*/ 232 w 477"/>
                <a:gd name="T37" fmla="*/ 165 h 298"/>
                <a:gd name="T38" fmla="*/ 312 w 477"/>
                <a:gd name="T39" fmla="*/ 165 h 298"/>
                <a:gd name="T40" fmla="*/ 312 w 477"/>
                <a:gd name="T41" fmla="*/ 196 h 298"/>
                <a:gd name="T42" fmla="*/ 313 w 477"/>
                <a:gd name="T43" fmla="*/ 196 h 298"/>
                <a:gd name="T44" fmla="*/ 313 w 477"/>
                <a:gd name="T45" fmla="*/ 226 h 298"/>
                <a:gd name="T46" fmla="*/ 334 w 477"/>
                <a:gd name="T47" fmla="*/ 226 h 298"/>
                <a:gd name="T48" fmla="*/ 334 w 477"/>
                <a:gd name="T49" fmla="*/ 257 h 298"/>
                <a:gd name="T50" fmla="*/ 436 w 477"/>
                <a:gd name="T51" fmla="*/ 257 h 298"/>
                <a:gd name="T52" fmla="*/ 436 w 477"/>
                <a:gd name="T53" fmla="*/ 298 h 298"/>
                <a:gd name="T54" fmla="*/ 477 w 477"/>
                <a:gd name="T55" fmla="*/ 298 h 2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477" h="298">
                  <a:moveTo>
                    <a:pt x="0" y="0"/>
                  </a:moveTo>
                  <a:lnTo>
                    <a:pt x="3" y="0"/>
                  </a:lnTo>
                  <a:lnTo>
                    <a:pt x="3" y="11"/>
                  </a:lnTo>
                  <a:lnTo>
                    <a:pt x="14" y="11"/>
                  </a:lnTo>
                  <a:lnTo>
                    <a:pt x="14" y="24"/>
                  </a:lnTo>
                  <a:lnTo>
                    <a:pt x="16" y="24"/>
                  </a:lnTo>
                  <a:lnTo>
                    <a:pt x="16" y="38"/>
                  </a:lnTo>
                  <a:lnTo>
                    <a:pt x="52" y="38"/>
                  </a:lnTo>
                  <a:lnTo>
                    <a:pt x="52" y="57"/>
                  </a:lnTo>
                  <a:lnTo>
                    <a:pt x="65" y="57"/>
                  </a:lnTo>
                  <a:lnTo>
                    <a:pt x="65" y="76"/>
                  </a:lnTo>
                  <a:lnTo>
                    <a:pt x="75" y="76"/>
                  </a:lnTo>
                  <a:lnTo>
                    <a:pt x="75" y="95"/>
                  </a:lnTo>
                  <a:lnTo>
                    <a:pt x="78" y="95"/>
                  </a:lnTo>
                  <a:lnTo>
                    <a:pt x="78" y="114"/>
                  </a:lnTo>
                  <a:lnTo>
                    <a:pt x="93" y="114"/>
                  </a:lnTo>
                  <a:lnTo>
                    <a:pt x="93" y="138"/>
                  </a:lnTo>
                  <a:lnTo>
                    <a:pt x="232" y="138"/>
                  </a:lnTo>
                  <a:lnTo>
                    <a:pt x="232" y="165"/>
                  </a:lnTo>
                  <a:lnTo>
                    <a:pt x="312" y="165"/>
                  </a:lnTo>
                  <a:lnTo>
                    <a:pt x="312" y="196"/>
                  </a:lnTo>
                  <a:lnTo>
                    <a:pt x="313" y="196"/>
                  </a:lnTo>
                  <a:lnTo>
                    <a:pt x="313" y="226"/>
                  </a:lnTo>
                  <a:lnTo>
                    <a:pt x="334" y="226"/>
                  </a:lnTo>
                  <a:lnTo>
                    <a:pt x="334" y="257"/>
                  </a:lnTo>
                  <a:lnTo>
                    <a:pt x="436" y="257"/>
                  </a:lnTo>
                  <a:lnTo>
                    <a:pt x="436" y="298"/>
                  </a:lnTo>
                  <a:lnTo>
                    <a:pt x="477" y="298"/>
                  </a:lnTo>
                </a:path>
              </a:pathLst>
            </a:custGeom>
            <a:noFill/>
            <a:ln w="19050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5" name="Line 134">
              <a:extLst>
                <a:ext uri="{FF2B5EF4-FFF2-40B4-BE49-F238E27FC236}">
                  <a16:creationId xmlns:a16="http://schemas.microsoft.com/office/drawing/2014/main" id="{1939D39D-42F4-AD15-D327-EA548DA369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86520" y="3575828"/>
              <a:ext cx="72232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6" name="Line 135">
              <a:extLst>
                <a:ext uri="{FF2B5EF4-FFF2-40B4-BE49-F238E27FC236}">
                  <a16:creationId xmlns:a16="http://schemas.microsoft.com/office/drawing/2014/main" id="{BD6DD4D8-DAE2-4EAB-877D-16DFE4A220F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22636" y="3547339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7" name="Line 136">
              <a:extLst>
                <a:ext uri="{FF2B5EF4-FFF2-40B4-BE49-F238E27FC236}">
                  <a16:creationId xmlns:a16="http://schemas.microsoft.com/office/drawing/2014/main" id="{A104E9AE-C85B-DCC9-286A-D67C5F5FC8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93466" y="3575828"/>
              <a:ext cx="72232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8" name="Line 137">
              <a:extLst>
                <a:ext uri="{FF2B5EF4-FFF2-40B4-BE49-F238E27FC236}">
                  <a16:creationId xmlns:a16="http://schemas.microsoft.com/office/drawing/2014/main" id="{57E573D7-EDB5-EE0F-5690-F45D07BDAD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29582" y="3547339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9" name="Line 138">
              <a:extLst>
                <a:ext uri="{FF2B5EF4-FFF2-40B4-BE49-F238E27FC236}">
                  <a16:creationId xmlns:a16="http://schemas.microsoft.com/office/drawing/2014/main" id="{D9C1C892-64A7-2B5F-DCF5-18C5ED6AB4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08745" y="3575828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0" name="Line 139">
              <a:extLst>
                <a:ext uri="{FF2B5EF4-FFF2-40B4-BE49-F238E27FC236}">
                  <a16:creationId xmlns:a16="http://schemas.microsoft.com/office/drawing/2014/main" id="{BF265DF6-821E-DDE1-4E9C-5F45EAADA9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43473" y="3547339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1" name="Line 140">
              <a:extLst>
                <a:ext uri="{FF2B5EF4-FFF2-40B4-BE49-F238E27FC236}">
                  <a16:creationId xmlns:a16="http://schemas.microsoft.com/office/drawing/2014/main" id="{020D89C7-3D31-94BE-27F7-483AF032C7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22636" y="3575828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2" name="Line 141">
              <a:extLst>
                <a:ext uri="{FF2B5EF4-FFF2-40B4-BE49-F238E27FC236}">
                  <a16:creationId xmlns:a16="http://schemas.microsoft.com/office/drawing/2014/main" id="{F589B463-4791-FAEC-EBFD-A980781E66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58752" y="3547339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3" name="Line 142">
              <a:extLst>
                <a:ext uri="{FF2B5EF4-FFF2-40B4-BE49-F238E27FC236}">
                  <a16:creationId xmlns:a16="http://schemas.microsoft.com/office/drawing/2014/main" id="{835AA6E2-9E91-3BC0-86F6-A6D4BB5D0F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8752" y="3575828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4" name="Line 143">
              <a:extLst>
                <a:ext uri="{FF2B5EF4-FFF2-40B4-BE49-F238E27FC236}">
                  <a16:creationId xmlns:a16="http://schemas.microsoft.com/office/drawing/2014/main" id="{C4B7837C-68F1-BFD4-C76A-336A852D43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93480" y="3547339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5" name="Line 144">
              <a:extLst>
                <a:ext uri="{FF2B5EF4-FFF2-40B4-BE49-F238E27FC236}">
                  <a16:creationId xmlns:a16="http://schemas.microsoft.com/office/drawing/2014/main" id="{A719494A-D3D3-6224-257B-7DED5E429F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93480" y="3728134"/>
              <a:ext cx="72232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6" name="Line 145">
              <a:extLst>
                <a:ext uri="{FF2B5EF4-FFF2-40B4-BE49-F238E27FC236}">
                  <a16:creationId xmlns:a16="http://schemas.microsoft.com/office/drawing/2014/main" id="{8324F792-EDD5-DF32-E21F-FEAC78A7F95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29596" y="3694166"/>
              <a:ext cx="0" cy="6245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7" name="Line 146">
              <a:extLst>
                <a:ext uri="{FF2B5EF4-FFF2-40B4-BE49-F238E27FC236}">
                  <a16:creationId xmlns:a16="http://schemas.microsoft.com/office/drawing/2014/main" id="{F93C5567-0EE8-B01E-AE9C-E0C59D516A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29596" y="3728134"/>
              <a:ext cx="72232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8" name="Line 147">
              <a:extLst>
                <a:ext uri="{FF2B5EF4-FFF2-40B4-BE49-F238E27FC236}">
                  <a16:creationId xmlns:a16="http://schemas.microsoft.com/office/drawing/2014/main" id="{FD0BD3AE-B7CF-F091-31C5-D00B85C4D59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65712" y="3694166"/>
              <a:ext cx="0" cy="6245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9" name="Line 148">
              <a:extLst>
                <a:ext uri="{FF2B5EF4-FFF2-40B4-BE49-F238E27FC236}">
                  <a16:creationId xmlns:a16="http://schemas.microsoft.com/office/drawing/2014/main" id="{63355623-AA78-D286-7D5A-FFDA5AF83AA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1821" y="3728134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0" name="Line 149">
              <a:extLst>
                <a:ext uri="{FF2B5EF4-FFF2-40B4-BE49-F238E27FC236}">
                  <a16:creationId xmlns:a16="http://schemas.microsoft.com/office/drawing/2014/main" id="{E4A5582E-5A5D-E223-EE51-96BD23503D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86548" y="3694166"/>
              <a:ext cx="0" cy="6245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1" name="Line 150">
              <a:extLst>
                <a:ext uri="{FF2B5EF4-FFF2-40B4-BE49-F238E27FC236}">
                  <a16:creationId xmlns:a16="http://schemas.microsoft.com/office/drawing/2014/main" id="{470DFF33-D1E3-C5AB-4FAF-A1C8F6DDD7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8766" y="3728134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2" name="Line 151">
              <a:extLst>
                <a:ext uri="{FF2B5EF4-FFF2-40B4-BE49-F238E27FC236}">
                  <a16:creationId xmlns:a16="http://schemas.microsoft.com/office/drawing/2014/main" id="{64AD6805-3E0C-6FA5-F612-2B75C5597A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93494" y="3694166"/>
              <a:ext cx="0" cy="6245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3" name="Line 152">
              <a:extLst>
                <a:ext uri="{FF2B5EF4-FFF2-40B4-BE49-F238E27FC236}">
                  <a16:creationId xmlns:a16="http://schemas.microsoft.com/office/drawing/2014/main" id="{F8A243D0-0551-AE14-31C7-0ED3CDC1A23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8766" y="3728134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4" name="Line 153">
              <a:extLst>
                <a:ext uri="{FF2B5EF4-FFF2-40B4-BE49-F238E27FC236}">
                  <a16:creationId xmlns:a16="http://schemas.microsoft.com/office/drawing/2014/main" id="{F17439D6-EEBF-B0F2-4149-077EC3B742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93494" y="3694166"/>
              <a:ext cx="0" cy="6245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5" name="Line 154">
              <a:extLst>
                <a:ext uri="{FF2B5EF4-FFF2-40B4-BE49-F238E27FC236}">
                  <a16:creationId xmlns:a16="http://schemas.microsoft.com/office/drawing/2014/main" id="{A15DABB6-B943-F934-BF23-98045B1072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29610" y="3728134"/>
              <a:ext cx="79178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6" name="Line 155">
              <a:extLst>
                <a:ext uri="{FF2B5EF4-FFF2-40B4-BE49-F238E27FC236}">
                  <a16:creationId xmlns:a16="http://schemas.microsoft.com/office/drawing/2014/main" id="{A3B1132F-0BB7-7D3E-A91A-4173B60DA91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72671" y="3694166"/>
              <a:ext cx="0" cy="6245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7" name="Line 156">
              <a:extLst>
                <a:ext uri="{FF2B5EF4-FFF2-40B4-BE49-F238E27FC236}">
                  <a16:creationId xmlns:a16="http://schemas.microsoft.com/office/drawing/2014/main" id="{46461E30-BECB-2D80-F493-EF0F295A9B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43501" y="3728134"/>
              <a:ext cx="72232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8" name="Line 157">
              <a:extLst>
                <a:ext uri="{FF2B5EF4-FFF2-40B4-BE49-F238E27FC236}">
                  <a16:creationId xmlns:a16="http://schemas.microsoft.com/office/drawing/2014/main" id="{B303F23C-D1D1-98CB-1F94-E680760A32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79617" y="3694166"/>
              <a:ext cx="0" cy="6245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9" name="Line 158">
              <a:extLst>
                <a:ext uri="{FF2B5EF4-FFF2-40B4-BE49-F238E27FC236}">
                  <a16:creationId xmlns:a16="http://schemas.microsoft.com/office/drawing/2014/main" id="{D4E34427-46E3-DF16-ED6F-764F3E5DAE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65726" y="3728134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0" name="Line 159">
              <a:extLst>
                <a:ext uri="{FF2B5EF4-FFF2-40B4-BE49-F238E27FC236}">
                  <a16:creationId xmlns:a16="http://schemas.microsoft.com/office/drawing/2014/main" id="{05D65175-6CC5-22FA-18DC-57DDF8F3BA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01843" y="3694166"/>
              <a:ext cx="0" cy="6245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1" name="Line 160">
              <a:extLst>
                <a:ext uri="{FF2B5EF4-FFF2-40B4-BE49-F238E27FC236}">
                  <a16:creationId xmlns:a16="http://schemas.microsoft.com/office/drawing/2014/main" id="{973DB133-3494-8E29-8BB1-FF3EF5B066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29652" y="4156562"/>
              <a:ext cx="72232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2" name="Line 161">
              <a:extLst>
                <a:ext uri="{FF2B5EF4-FFF2-40B4-BE49-F238E27FC236}">
                  <a16:creationId xmlns:a16="http://schemas.microsoft.com/office/drawing/2014/main" id="{C815F499-EC41-56DE-AE69-3AE085E9B7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65769" y="4128073"/>
              <a:ext cx="0" cy="55882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3" name="Line 162">
              <a:extLst>
                <a:ext uri="{FF2B5EF4-FFF2-40B4-BE49-F238E27FC236}">
                  <a16:creationId xmlns:a16="http://schemas.microsoft.com/office/drawing/2014/main" id="{95189453-F672-BD4D-4534-640FC35EF9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8823" y="4156562"/>
              <a:ext cx="77789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4" name="Line 163">
              <a:extLst>
                <a:ext uri="{FF2B5EF4-FFF2-40B4-BE49-F238E27FC236}">
                  <a16:creationId xmlns:a16="http://schemas.microsoft.com/office/drawing/2014/main" id="{EB762CF6-9696-964A-E972-098EA4B521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93550" y="4128073"/>
              <a:ext cx="0" cy="55882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5" name="Line 164">
              <a:extLst>
                <a:ext uri="{FF2B5EF4-FFF2-40B4-BE49-F238E27FC236}">
                  <a16:creationId xmlns:a16="http://schemas.microsoft.com/office/drawing/2014/main" id="{C23CC93E-7E3D-DF31-BDD0-570FE8F06B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08830" y="4156562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6" name="Line 165">
              <a:extLst>
                <a:ext uri="{FF2B5EF4-FFF2-40B4-BE49-F238E27FC236}">
                  <a16:creationId xmlns:a16="http://schemas.microsoft.com/office/drawing/2014/main" id="{F9B522D9-3EE0-6E81-518C-9BEC010F18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43557" y="4128073"/>
              <a:ext cx="0" cy="55882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7" name="Line 166">
              <a:extLst>
                <a:ext uri="{FF2B5EF4-FFF2-40B4-BE49-F238E27FC236}">
                  <a16:creationId xmlns:a16="http://schemas.microsoft.com/office/drawing/2014/main" id="{5E8FCD0E-C38B-254D-7656-F151C55C7D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72812" y="4291336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8" name="Line 167">
              <a:extLst>
                <a:ext uri="{FF2B5EF4-FFF2-40B4-BE49-F238E27FC236}">
                  <a16:creationId xmlns:a16="http://schemas.microsoft.com/office/drawing/2014/main" id="{87E4817B-38A6-365F-A94E-72B5975F32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108929" y="4262847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9" name="Line 168">
              <a:extLst>
                <a:ext uri="{FF2B5EF4-FFF2-40B4-BE49-F238E27FC236}">
                  <a16:creationId xmlns:a16="http://schemas.microsoft.com/office/drawing/2014/main" id="{65E00D1A-30A7-0C39-94AD-64A481BCF4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893762" y="4443641"/>
              <a:ext cx="72232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0" name="Line 169">
              <a:extLst>
                <a:ext uri="{FF2B5EF4-FFF2-40B4-BE49-F238E27FC236}">
                  <a16:creationId xmlns:a16="http://schemas.microsoft.com/office/drawing/2014/main" id="{3FCA3881-9B2B-8573-663C-911AE4D189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29878" y="4415152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1" name="Line 170">
              <a:extLst>
                <a:ext uri="{FF2B5EF4-FFF2-40B4-BE49-F238E27FC236}">
                  <a16:creationId xmlns:a16="http://schemas.microsoft.com/office/drawing/2014/main" id="{372AF8BF-5A6A-3855-3289-55A79D71F6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59147" y="4961919"/>
              <a:ext cx="70844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2" name="Line 171">
              <a:extLst>
                <a:ext uri="{FF2B5EF4-FFF2-40B4-BE49-F238E27FC236}">
                  <a16:creationId xmlns:a16="http://schemas.microsoft.com/office/drawing/2014/main" id="{47017D01-5FF7-AA6A-ED8D-C68A9FFCCB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95264" y="4933430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3" name="Line 172">
              <a:extLst>
                <a:ext uri="{FF2B5EF4-FFF2-40B4-BE49-F238E27FC236}">
                  <a16:creationId xmlns:a16="http://schemas.microsoft.com/office/drawing/2014/main" id="{1BC11C04-807E-037E-7F73-EE339FA774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73109" y="5193116"/>
              <a:ext cx="72232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4" name="Line 173">
              <a:extLst>
                <a:ext uri="{FF2B5EF4-FFF2-40B4-BE49-F238E27FC236}">
                  <a16:creationId xmlns:a16="http://schemas.microsoft.com/office/drawing/2014/main" id="{86351910-224F-1F8B-8890-651B57CDE5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9225" y="5164628"/>
              <a:ext cx="0" cy="5697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5" name="Rectangle 174">
              <a:extLst>
                <a:ext uri="{FF2B5EF4-FFF2-40B4-BE49-F238E27FC236}">
                  <a16:creationId xmlns:a16="http://schemas.microsoft.com/office/drawing/2014/main" id="{55A3AF59-AC4D-F5D7-9DDE-F2FBE023FE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8731" y="6297606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4" name="Rectangle 175">
              <a:extLst>
                <a:ext uri="{FF2B5EF4-FFF2-40B4-BE49-F238E27FC236}">
                  <a16:creationId xmlns:a16="http://schemas.microsoft.com/office/drawing/2014/main" id="{88F3411D-EB1A-22EE-D66A-82D69E9BCD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3614" y="6297606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5" name="Rectangle 176">
              <a:extLst>
                <a:ext uri="{FF2B5EF4-FFF2-40B4-BE49-F238E27FC236}">
                  <a16:creationId xmlns:a16="http://schemas.microsoft.com/office/drawing/2014/main" id="{2DFD3C3F-45CA-CC2F-2E7B-900A485342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79885" y="6297606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6" name="Rectangle 177">
              <a:extLst>
                <a:ext uri="{FF2B5EF4-FFF2-40B4-BE49-F238E27FC236}">
                  <a16:creationId xmlns:a16="http://schemas.microsoft.com/office/drawing/2014/main" id="{43EF1E7E-DA29-43B4-3BFD-DD8D48EC80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16157" y="6297606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7" name="Rectangle 178">
              <a:extLst>
                <a:ext uri="{FF2B5EF4-FFF2-40B4-BE49-F238E27FC236}">
                  <a16:creationId xmlns:a16="http://schemas.microsoft.com/office/drawing/2014/main" id="{424CD179-BF2D-A3CD-E902-D22421D6DA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8731" y="6404987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8" name="Rectangle 179">
              <a:extLst>
                <a:ext uri="{FF2B5EF4-FFF2-40B4-BE49-F238E27FC236}">
                  <a16:creationId xmlns:a16="http://schemas.microsoft.com/office/drawing/2014/main" id="{EEB20950-DD36-9AF0-66F7-DC6229B0D0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3614" y="6404987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9" name="Rectangle 180">
              <a:extLst>
                <a:ext uri="{FF2B5EF4-FFF2-40B4-BE49-F238E27FC236}">
                  <a16:creationId xmlns:a16="http://schemas.microsoft.com/office/drawing/2014/main" id="{ED72B293-FFE5-FF70-A286-19203FA78B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6002" y="6404987"/>
              <a:ext cx="61716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8" name="Rectangle 181">
              <a:extLst>
                <a:ext uri="{FF2B5EF4-FFF2-40B4-BE49-F238E27FC236}">
                  <a16:creationId xmlns:a16="http://schemas.microsoft.com/office/drawing/2014/main" id="{FFB84B53-91EB-F3CC-554B-043D9F87C1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52273" y="6404987"/>
              <a:ext cx="61716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9" name="Rectangle 182">
              <a:extLst>
                <a:ext uri="{FF2B5EF4-FFF2-40B4-BE49-F238E27FC236}">
                  <a16:creationId xmlns:a16="http://schemas.microsoft.com/office/drawing/2014/main" id="{30287297-B6AD-108F-81A6-6CB74505E1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8731" y="6512368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7" name="Rectangle 183">
              <a:extLst>
                <a:ext uri="{FF2B5EF4-FFF2-40B4-BE49-F238E27FC236}">
                  <a16:creationId xmlns:a16="http://schemas.microsoft.com/office/drawing/2014/main" id="{A1D0FC55-6B5B-0A83-C2C6-75F17ECF37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3614" y="6512368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8" name="Rectangle 184">
              <a:extLst>
                <a:ext uri="{FF2B5EF4-FFF2-40B4-BE49-F238E27FC236}">
                  <a16:creationId xmlns:a16="http://schemas.microsoft.com/office/drawing/2014/main" id="{B2DF2213-75D1-1AF3-6D82-CF38A0D6FD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79885" y="6512368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9" name="Rectangle 185">
              <a:extLst>
                <a:ext uri="{FF2B5EF4-FFF2-40B4-BE49-F238E27FC236}">
                  <a16:creationId xmlns:a16="http://schemas.microsoft.com/office/drawing/2014/main" id="{530F6072-9BDB-92F6-92A7-BF9910A403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52273" y="6512368"/>
              <a:ext cx="61716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0" name="Rectangle 186">
              <a:extLst>
                <a:ext uri="{FF2B5EF4-FFF2-40B4-BE49-F238E27FC236}">
                  <a16:creationId xmlns:a16="http://schemas.microsoft.com/office/drawing/2014/main" id="{9DB869E5-33D4-5696-FFCB-B84509A820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08731" y="6637904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1" name="Rectangle 187">
              <a:extLst>
                <a:ext uri="{FF2B5EF4-FFF2-40B4-BE49-F238E27FC236}">
                  <a16:creationId xmlns:a16="http://schemas.microsoft.com/office/drawing/2014/main" id="{2A827C4E-9837-6C1F-A7B2-6D9AB0348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3614" y="6637904"/>
              <a:ext cx="123433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2" name="Rectangle 188">
              <a:extLst>
                <a:ext uri="{FF2B5EF4-FFF2-40B4-BE49-F238E27FC236}">
                  <a16:creationId xmlns:a16="http://schemas.microsoft.com/office/drawing/2014/main" id="{E5F2FBE8-54AE-DC3B-9474-E9585E883C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6002" y="6637904"/>
              <a:ext cx="61716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3" name="Rectangle 189">
              <a:extLst>
                <a:ext uri="{FF2B5EF4-FFF2-40B4-BE49-F238E27FC236}">
                  <a16:creationId xmlns:a16="http://schemas.microsoft.com/office/drawing/2014/main" id="{61CE25C1-B987-7E54-FDEF-BCE73036D8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52273" y="6637904"/>
              <a:ext cx="61716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4" name="Rectangle 194">
              <a:extLst>
                <a:ext uri="{FF2B5EF4-FFF2-40B4-BE49-F238E27FC236}">
                  <a16:creationId xmlns:a16="http://schemas.microsoft.com/office/drawing/2014/main" id="{E838D5FF-C90D-09C7-344C-0178C59F24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65670" y="6134344"/>
              <a:ext cx="737794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5" name="Rectangle 162">
              <a:extLst>
                <a:ext uri="{FF2B5EF4-FFF2-40B4-BE49-F238E27FC236}">
                  <a16:creationId xmlns:a16="http://schemas.microsoft.com/office/drawing/2014/main" id="{E13DD2F9-D36C-4E75-EBA8-80E143B54B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4302" y="6295618"/>
              <a:ext cx="389938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6" name="Rectangle 163">
              <a:extLst>
                <a:ext uri="{FF2B5EF4-FFF2-40B4-BE49-F238E27FC236}">
                  <a16:creationId xmlns:a16="http://schemas.microsoft.com/office/drawing/2014/main" id="{AFB16F60-6FDE-7732-9C42-669D945B4A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0896" y="6401211"/>
              <a:ext cx="342247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7" name="Rectangle 164">
              <a:extLst>
                <a:ext uri="{FF2B5EF4-FFF2-40B4-BE49-F238E27FC236}">
                  <a16:creationId xmlns:a16="http://schemas.microsoft.com/office/drawing/2014/main" id="{FC4E9F86-65EC-DBCD-DD75-9EE3D8D43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0896" y="6504352"/>
              <a:ext cx="342247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8" name="Rectangle 165">
              <a:extLst>
                <a:ext uri="{FF2B5EF4-FFF2-40B4-BE49-F238E27FC236}">
                  <a16:creationId xmlns:a16="http://schemas.microsoft.com/office/drawing/2014/main" id="{AC2AD1B1-4148-1E0F-738A-16D5B25C65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4849" y="6620846"/>
              <a:ext cx="294557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9" name="Line 157">
              <a:extLst>
                <a:ext uri="{FF2B5EF4-FFF2-40B4-BE49-F238E27FC236}">
                  <a16:creationId xmlns:a16="http://schemas.microsoft.com/office/drawing/2014/main" id="{70325E6B-D5F9-7227-77EA-06CC9F923D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35533" y="3649242"/>
              <a:ext cx="206974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0" name="Line 158">
              <a:extLst>
                <a:ext uri="{FF2B5EF4-FFF2-40B4-BE49-F238E27FC236}">
                  <a16:creationId xmlns:a16="http://schemas.microsoft.com/office/drawing/2014/main" id="{7126C7F0-5282-07C3-4F1C-DA637DB1E8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35533" y="3756623"/>
              <a:ext cx="206974" cy="0"/>
            </a:xfrm>
            <a:prstGeom prst="line">
              <a:avLst/>
            </a:prstGeom>
            <a:noFill/>
            <a:ln w="1905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1" name="Line 159">
              <a:extLst>
                <a:ext uri="{FF2B5EF4-FFF2-40B4-BE49-F238E27FC236}">
                  <a16:creationId xmlns:a16="http://schemas.microsoft.com/office/drawing/2014/main" id="{B023DD68-0032-310E-1FC6-168176F485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35533" y="3862908"/>
              <a:ext cx="206974" cy="0"/>
            </a:xfrm>
            <a:prstGeom prst="line">
              <a:avLst/>
            </a:prstGeom>
            <a:noFill/>
            <a:ln w="19050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2" name="Line 160">
              <a:extLst>
                <a:ext uri="{FF2B5EF4-FFF2-40B4-BE49-F238E27FC236}">
                  <a16:creationId xmlns:a16="http://schemas.microsoft.com/office/drawing/2014/main" id="{6CAA5765-E5F4-E884-FE85-E908CC447F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35533" y="3970289"/>
              <a:ext cx="206974" cy="0"/>
            </a:xfrm>
            <a:prstGeom prst="line">
              <a:avLst/>
            </a:prstGeom>
            <a:noFill/>
            <a:ln w="19050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3" name="Rectangle 162">
              <a:extLst>
                <a:ext uri="{FF2B5EF4-FFF2-40B4-BE49-F238E27FC236}">
                  <a16:creationId xmlns:a16="http://schemas.microsoft.com/office/drawing/2014/main" id="{48C2FFE5-D751-1973-833B-14FCCF51AC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90145" y="3581307"/>
              <a:ext cx="389938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4" name="Rectangle 163">
              <a:extLst>
                <a:ext uri="{FF2B5EF4-FFF2-40B4-BE49-F238E27FC236}">
                  <a16:creationId xmlns:a16="http://schemas.microsoft.com/office/drawing/2014/main" id="{04F152A8-0CA8-41E6-2317-AA92D5D3E4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86741" y="3686900"/>
              <a:ext cx="342247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5" name="Rectangle 164">
              <a:extLst>
                <a:ext uri="{FF2B5EF4-FFF2-40B4-BE49-F238E27FC236}">
                  <a16:creationId xmlns:a16="http://schemas.microsoft.com/office/drawing/2014/main" id="{04AFD5AD-87A1-FF04-8820-A1C782479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86741" y="3790042"/>
              <a:ext cx="342247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6" name="Rectangle 165">
              <a:extLst>
                <a:ext uri="{FF2B5EF4-FFF2-40B4-BE49-F238E27FC236}">
                  <a16:creationId xmlns:a16="http://schemas.microsoft.com/office/drawing/2014/main" id="{4193C6F8-4489-A893-953D-19D8E1E635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30694" y="3906535"/>
              <a:ext cx="294557" cy="1168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8" name="Rectangle 207">
              <a:extLst>
                <a:ext uri="{FF2B5EF4-FFF2-40B4-BE49-F238E27FC236}">
                  <a16:creationId xmlns:a16="http://schemas.microsoft.com/office/drawing/2014/main" id="{446D9F01-D681-BE48-3779-B910089F9CC6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3930879" y="3418165"/>
              <a:ext cx="21128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0" name="Line 5">
              <a:extLst>
                <a:ext uri="{FF2B5EF4-FFF2-40B4-BE49-F238E27FC236}">
                  <a16:creationId xmlns:a16="http://schemas.microsoft.com/office/drawing/2014/main" id="{4A1EB745-BE6E-902D-A1E4-04F44B3E6D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3028" y="2303391"/>
              <a:ext cx="338450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1" name="Line 6">
              <a:extLst>
                <a:ext uri="{FF2B5EF4-FFF2-40B4-BE49-F238E27FC236}">
                  <a16:creationId xmlns:a16="http://schemas.microsoft.com/office/drawing/2014/main" id="{52A81FD1-A740-2437-CC22-593F44AEAE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3028" y="2303391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2" name="Line 7">
              <a:extLst>
                <a:ext uri="{FF2B5EF4-FFF2-40B4-BE49-F238E27FC236}">
                  <a16:creationId xmlns:a16="http://schemas.microsoft.com/office/drawing/2014/main" id="{CEA6D410-8747-A3AA-FE2E-A3DC673DE3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80277" y="2303391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3" name="Line 8">
              <a:extLst>
                <a:ext uri="{FF2B5EF4-FFF2-40B4-BE49-F238E27FC236}">
                  <a16:creationId xmlns:a16="http://schemas.microsoft.com/office/drawing/2014/main" id="{AC190A1B-15D8-1493-FDE5-F3171D1D76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308906" y="2303391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4" name="Line 9">
              <a:extLst>
                <a:ext uri="{FF2B5EF4-FFF2-40B4-BE49-F238E27FC236}">
                  <a16:creationId xmlns:a16="http://schemas.microsoft.com/office/drawing/2014/main" id="{07CAB36E-842D-4897-07F9-C5C514EF5D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37535" y="2303391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5" name="Rectangle 10">
              <a:extLst>
                <a:ext uri="{FF2B5EF4-FFF2-40B4-BE49-F238E27FC236}">
                  <a16:creationId xmlns:a16="http://schemas.microsoft.com/office/drawing/2014/main" id="{B4BAFFCA-46C4-6E88-A787-06AFD6FA2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96459" y="2420243"/>
              <a:ext cx="60709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6" name="Rectangle 11">
              <a:extLst>
                <a:ext uri="{FF2B5EF4-FFF2-40B4-BE49-F238E27FC236}">
                  <a16:creationId xmlns:a16="http://schemas.microsoft.com/office/drawing/2014/main" id="{AD5FFA88-FFA2-E00D-45F4-8514DB8A1C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6100" y="2420243"/>
              <a:ext cx="183506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7" name="Rectangle 12">
              <a:extLst>
                <a:ext uri="{FF2B5EF4-FFF2-40B4-BE49-F238E27FC236}">
                  <a16:creationId xmlns:a16="http://schemas.microsoft.com/office/drawing/2014/main" id="{B2C36846-87D5-EB38-BC19-23953AD8F7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52995" y="2420243"/>
              <a:ext cx="245594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8" name="Rectangle 13">
              <a:extLst>
                <a:ext uri="{FF2B5EF4-FFF2-40B4-BE49-F238E27FC236}">
                  <a16:creationId xmlns:a16="http://schemas.microsoft.com/office/drawing/2014/main" id="{725C0986-8423-E158-582B-D6214A978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81624" y="2420243"/>
              <a:ext cx="245594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9" name="Line 14">
              <a:extLst>
                <a:ext uri="{FF2B5EF4-FFF2-40B4-BE49-F238E27FC236}">
                  <a16:creationId xmlns:a16="http://schemas.microsoft.com/office/drawing/2014/main" id="{AB3B06A3-4D7F-C001-5BF5-EDCFF43526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917813" y="202132"/>
              <a:ext cx="0" cy="202163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0" name="Line 15">
              <a:extLst>
                <a:ext uri="{FF2B5EF4-FFF2-40B4-BE49-F238E27FC236}">
                  <a16:creationId xmlns:a16="http://schemas.microsoft.com/office/drawing/2014/main" id="{587C5239-48F9-9ECD-D6CF-2311466AB7E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846067" y="2223767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1" name="Line 16">
              <a:extLst>
                <a:ext uri="{FF2B5EF4-FFF2-40B4-BE49-F238E27FC236}">
                  <a16:creationId xmlns:a16="http://schemas.microsoft.com/office/drawing/2014/main" id="{D9745B2C-E055-C92A-296B-2372DE224B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846067" y="1819440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2" name="Line 17">
              <a:extLst>
                <a:ext uri="{FF2B5EF4-FFF2-40B4-BE49-F238E27FC236}">
                  <a16:creationId xmlns:a16="http://schemas.microsoft.com/office/drawing/2014/main" id="{EA555D59-6200-D4A6-FB4F-A0F4889229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846067" y="1415113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3" name="Line 18">
              <a:extLst>
                <a:ext uri="{FF2B5EF4-FFF2-40B4-BE49-F238E27FC236}">
                  <a16:creationId xmlns:a16="http://schemas.microsoft.com/office/drawing/2014/main" id="{BB6D02CD-F5AC-5C6C-A25D-E82CD55BFD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846067" y="1010786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4" name="Line 19">
              <a:extLst>
                <a:ext uri="{FF2B5EF4-FFF2-40B4-BE49-F238E27FC236}">
                  <a16:creationId xmlns:a16="http://schemas.microsoft.com/office/drawing/2014/main" id="{B447420E-0713-2C6C-1CAD-C7640C5EA1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846067" y="606459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5" name="Line 20">
              <a:extLst>
                <a:ext uri="{FF2B5EF4-FFF2-40B4-BE49-F238E27FC236}">
                  <a16:creationId xmlns:a16="http://schemas.microsoft.com/office/drawing/2014/main" id="{3BBB3571-D61F-91CE-A983-43170A1D35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846067" y="202132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6" name="Rectangle 21">
              <a:extLst>
                <a:ext uri="{FF2B5EF4-FFF2-40B4-BE49-F238E27FC236}">
                  <a16:creationId xmlns:a16="http://schemas.microsoft.com/office/drawing/2014/main" id="{D08C773F-9DE8-3764-F674-17A1AB3447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62561" y="2186540"/>
              <a:ext cx="60709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7" name="Rectangle 22">
              <a:extLst>
                <a:ext uri="{FF2B5EF4-FFF2-40B4-BE49-F238E27FC236}">
                  <a16:creationId xmlns:a16="http://schemas.microsoft.com/office/drawing/2014/main" id="{A53A9D43-A60E-B9A6-C207-793001142F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0814" y="1787384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8" name="Rectangle 23">
              <a:extLst>
                <a:ext uri="{FF2B5EF4-FFF2-40B4-BE49-F238E27FC236}">
                  <a16:creationId xmlns:a16="http://schemas.microsoft.com/office/drawing/2014/main" id="{78B8EA52-17C9-DF2F-01AB-E9F9756909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0814" y="1383057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9" name="Rectangle 24">
              <a:extLst>
                <a:ext uri="{FF2B5EF4-FFF2-40B4-BE49-F238E27FC236}">
                  <a16:creationId xmlns:a16="http://schemas.microsoft.com/office/drawing/2014/main" id="{1224A4C9-4272-40D5-2A0E-280919A7B9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0814" y="978730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0" name="Rectangle 25">
              <a:extLst>
                <a:ext uri="{FF2B5EF4-FFF2-40B4-BE49-F238E27FC236}">
                  <a16:creationId xmlns:a16="http://schemas.microsoft.com/office/drawing/2014/main" id="{8E3F9F10-3E65-D1F2-EFE6-C588B3483D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90814" y="574403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1" name="Rectangle 26">
              <a:extLst>
                <a:ext uri="{FF2B5EF4-FFF2-40B4-BE49-F238E27FC236}">
                  <a16:creationId xmlns:a16="http://schemas.microsoft.com/office/drawing/2014/main" id="{5808AC96-5EB7-A275-E085-1C654C0C35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7346" y="170076"/>
              <a:ext cx="183506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0" name="Freeform 27">
              <a:extLst>
                <a:ext uri="{FF2B5EF4-FFF2-40B4-BE49-F238E27FC236}">
                  <a16:creationId xmlns:a16="http://schemas.microsoft.com/office/drawing/2014/main" id="{21189FFF-5B03-451C-AF31-487EF5E3BE03}"/>
                </a:ext>
              </a:extLst>
            </p:cNvPr>
            <p:cNvSpPr>
              <a:spLocks/>
            </p:cNvSpPr>
            <p:nvPr/>
          </p:nvSpPr>
          <p:spPr bwMode="auto">
            <a:xfrm>
              <a:off x="6917813" y="122508"/>
              <a:ext cx="3654937" cy="2180883"/>
            </a:xfrm>
            <a:custGeom>
              <a:avLst/>
              <a:gdLst>
                <a:gd name="T0" fmla="*/ 0 w 515"/>
                <a:gd name="T1" fmla="*/ 0 h 410"/>
                <a:gd name="T2" fmla="*/ 0 w 515"/>
                <a:gd name="T3" fmla="*/ 410 h 410"/>
                <a:gd name="T4" fmla="*/ 515 w 515"/>
                <a:gd name="T5" fmla="*/ 410 h 4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10">
                  <a:moveTo>
                    <a:pt x="0" y="0"/>
                  </a:moveTo>
                  <a:lnTo>
                    <a:pt x="0" y="410"/>
                  </a:lnTo>
                  <a:lnTo>
                    <a:pt x="515" y="41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1" name="Rectangle 28">
              <a:extLst>
                <a:ext uri="{FF2B5EF4-FFF2-40B4-BE49-F238E27FC236}">
                  <a16:creationId xmlns:a16="http://schemas.microsoft.com/office/drawing/2014/main" id="{EAB45F95-D425-2B7A-CAEE-3D6BFF2560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68518" y="2574322"/>
              <a:ext cx="1263844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-up Duration (day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2" name="Rectangle 29">
              <a:extLst>
                <a:ext uri="{FF2B5EF4-FFF2-40B4-BE49-F238E27FC236}">
                  <a16:creationId xmlns:a16="http://schemas.microsoft.com/office/drawing/2014/main" id="{9195BD65-6E8F-67EF-365F-EACA860D21E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024392" y="1325269"/>
              <a:ext cx="878972" cy="1476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vent-free Survival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3" name="Freeform 30">
              <a:extLst>
                <a:ext uri="{FF2B5EF4-FFF2-40B4-BE49-F238E27FC236}">
                  <a16:creationId xmlns:a16="http://schemas.microsoft.com/office/drawing/2014/main" id="{E7FB032A-CAB0-CA11-30CC-F65A0CCE8F66}"/>
                </a:ext>
              </a:extLst>
            </p:cNvPr>
            <p:cNvSpPr>
              <a:spLocks/>
            </p:cNvSpPr>
            <p:nvPr/>
          </p:nvSpPr>
          <p:spPr bwMode="auto">
            <a:xfrm>
              <a:off x="7053028" y="202132"/>
              <a:ext cx="3384507" cy="521178"/>
            </a:xfrm>
            <a:custGeom>
              <a:avLst/>
              <a:gdLst>
                <a:gd name="T0" fmla="*/ 0 w 477"/>
                <a:gd name="T1" fmla="*/ 0 h 98"/>
                <a:gd name="T2" fmla="*/ 1 w 477"/>
                <a:gd name="T3" fmla="*/ 0 h 98"/>
                <a:gd name="T4" fmla="*/ 1 w 477"/>
                <a:gd name="T5" fmla="*/ 10 h 98"/>
                <a:gd name="T6" fmla="*/ 15 w 477"/>
                <a:gd name="T7" fmla="*/ 10 h 98"/>
                <a:gd name="T8" fmla="*/ 15 w 477"/>
                <a:gd name="T9" fmla="*/ 19 h 98"/>
                <a:gd name="T10" fmla="*/ 20 w 477"/>
                <a:gd name="T11" fmla="*/ 19 h 98"/>
                <a:gd name="T12" fmla="*/ 20 w 477"/>
                <a:gd name="T13" fmla="*/ 29 h 98"/>
                <a:gd name="T14" fmla="*/ 21 w 477"/>
                <a:gd name="T15" fmla="*/ 29 h 98"/>
                <a:gd name="T16" fmla="*/ 21 w 477"/>
                <a:gd name="T17" fmla="*/ 39 h 98"/>
                <a:gd name="T18" fmla="*/ 25 w 477"/>
                <a:gd name="T19" fmla="*/ 39 h 98"/>
                <a:gd name="T20" fmla="*/ 25 w 477"/>
                <a:gd name="T21" fmla="*/ 49 h 98"/>
                <a:gd name="T22" fmla="*/ 74 w 477"/>
                <a:gd name="T23" fmla="*/ 49 h 98"/>
                <a:gd name="T24" fmla="*/ 74 w 477"/>
                <a:gd name="T25" fmla="*/ 60 h 98"/>
                <a:gd name="T26" fmla="*/ 98 w 477"/>
                <a:gd name="T27" fmla="*/ 60 h 98"/>
                <a:gd name="T28" fmla="*/ 98 w 477"/>
                <a:gd name="T29" fmla="*/ 72 h 98"/>
                <a:gd name="T30" fmla="*/ 169 w 477"/>
                <a:gd name="T31" fmla="*/ 72 h 98"/>
                <a:gd name="T32" fmla="*/ 169 w 477"/>
                <a:gd name="T33" fmla="*/ 84 h 98"/>
                <a:gd name="T34" fmla="*/ 290 w 477"/>
                <a:gd name="T35" fmla="*/ 84 h 98"/>
                <a:gd name="T36" fmla="*/ 290 w 477"/>
                <a:gd name="T37" fmla="*/ 98 h 98"/>
                <a:gd name="T38" fmla="*/ 477 w 477"/>
                <a:gd name="T39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477" h="98">
                  <a:moveTo>
                    <a:pt x="0" y="0"/>
                  </a:moveTo>
                  <a:lnTo>
                    <a:pt x="1" y="0"/>
                  </a:lnTo>
                  <a:lnTo>
                    <a:pt x="1" y="10"/>
                  </a:lnTo>
                  <a:lnTo>
                    <a:pt x="15" y="10"/>
                  </a:lnTo>
                  <a:lnTo>
                    <a:pt x="15" y="19"/>
                  </a:lnTo>
                  <a:lnTo>
                    <a:pt x="20" y="19"/>
                  </a:lnTo>
                  <a:lnTo>
                    <a:pt x="20" y="29"/>
                  </a:lnTo>
                  <a:lnTo>
                    <a:pt x="21" y="29"/>
                  </a:lnTo>
                  <a:lnTo>
                    <a:pt x="21" y="39"/>
                  </a:lnTo>
                  <a:lnTo>
                    <a:pt x="25" y="39"/>
                  </a:lnTo>
                  <a:lnTo>
                    <a:pt x="25" y="49"/>
                  </a:lnTo>
                  <a:lnTo>
                    <a:pt x="74" y="49"/>
                  </a:lnTo>
                  <a:lnTo>
                    <a:pt x="74" y="60"/>
                  </a:lnTo>
                  <a:lnTo>
                    <a:pt x="98" y="60"/>
                  </a:lnTo>
                  <a:lnTo>
                    <a:pt x="98" y="72"/>
                  </a:lnTo>
                  <a:lnTo>
                    <a:pt x="169" y="72"/>
                  </a:lnTo>
                  <a:lnTo>
                    <a:pt x="169" y="84"/>
                  </a:lnTo>
                  <a:lnTo>
                    <a:pt x="290" y="84"/>
                  </a:lnTo>
                  <a:lnTo>
                    <a:pt x="290" y="98"/>
                  </a:lnTo>
                  <a:lnTo>
                    <a:pt x="477" y="98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4" name="Line 31">
              <a:extLst>
                <a:ext uri="{FF2B5EF4-FFF2-40B4-BE49-F238E27FC236}">
                  <a16:creationId xmlns:a16="http://schemas.microsoft.com/office/drawing/2014/main" id="{9CA769EE-ED71-9FB3-AFDB-E89C7372DE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44091" y="303473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5" name="Line 32">
              <a:extLst>
                <a:ext uri="{FF2B5EF4-FFF2-40B4-BE49-F238E27FC236}">
                  <a16:creationId xmlns:a16="http://schemas.microsoft.com/office/drawing/2014/main" id="{AA00CA48-81BA-FFC1-6548-08EF6AD363A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79964" y="276587"/>
              <a:ext cx="0" cy="5377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6" name="Line 33">
              <a:extLst>
                <a:ext uri="{FF2B5EF4-FFF2-40B4-BE49-F238E27FC236}">
                  <a16:creationId xmlns:a16="http://schemas.microsoft.com/office/drawing/2014/main" id="{CC434370-E12E-68A4-BA1B-2F1F5B235E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93762" y="436870"/>
              <a:ext cx="78645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7" name="Line 34">
              <a:extLst>
                <a:ext uri="{FF2B5EF4-FFF2-40B4-BE49-F238E27FC236}">
                  <a16:creationId xmlns:a16="http://schemas.microsoft.com/office/drawing/2014/main" id="{CB4694E3-3816-24E0-CE44-C1E8F5B7D05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29635" y="409983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8" name="Line 35">
              <a:extLst>
                <a:ext uri="{FF2B5EF4-FFF2-40B4-BE49-F238E27FC236}">
                  <a16:creationId xmlns:a16="http://schemas.microsoft.com/office/drawing/2014/main" id="{BF362B7A-8966-7BEB-B96F-570A8720A6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08939" y="462722"/>
              <a:ext cx="7036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9" name="Line 36">
              <a:extLst>
                <a:ext uri="{FF2B5EF4-FFF2-40B4-BE49-F238E27FC236}">
                  <a16:creationId xmlns:a16="http://schemas.microsoft.com/office/drawing/2014/main" id="{6E9CD75E-E1AE-7812-AB57-F2B44C7912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43432" y="436870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0" name="Line 37">
              <a:extLst>
                <a:ext uri="{FF2B5EF4-FFF2-40B4-BE49-F238E27FC236}">
                  <a16:creationId xmlns:a16="http://schemas.microsoft.com/office/drawing/2014/main" id="{F43B5D24-1D3F-E703-EA11-4BFA8E419A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51711" y="462722"/>
              <a:ext cx="7036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1" name="Line 38">
              <a:extLst>
                <a:ext uri="{FF2B5EF4-FFF2-40B4-BE49-F238E27FC236}">
                  <a16:creationId xmlns:a16="http://schemas.microsoft.com/office/drawing/2014/main" id="{5D700BEA-F070-B2D0-7FE3-F711E7BD70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86204" y="436870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2" name="Line 39">
              <a:extLst>
                <a:ext uri="{FF2B5EF4-FFF2-40B4-BE49-F238E27FC236}">
                  <a16:creationId xmlns:a16="http://schemas.microsoft.com/office/drawing/2014/main" id="{6610384A-6E9D-ADB5-4D94-9D1448C72A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57951" y="462722"/>
              <a:ext cx="7036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3" name="Line 40">
              <a:extLst>
                <a:ext uri="{FF2B5EF4-FFF2-40B4-BE49-F238E27FC236}">
                  <a16:creationId xmlns:a16="http://schemas.microsoft.com/office/drawing/2014/main" id="{A67333BD-4499-1E06-3235-739B42310F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92444" y="436870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4" name="Line 41">
              <a:extLst>
                <a:ext uri="{FF2B5EF4-FFF2-40B4-BE49-F238E27FC236}">
                  <a16:creationId xmlns:a16="http://schemas.microsoft.com/office/drawing/2014/main" id="{FE3936A4-6A9B-4002-4C4C-B49DAEB262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33899" y="521664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5" name="Line 42">
              <a:extLst>
                <a:ext uri="{FF2B5EF4-FFF2-40B4-BE49-F238E27FC236}">
                  <a16:creationId xmlns:a16="http://schemas.microsoft.com/office/drawing/2014/main" id="{4760E665-8518-98E2-0139-05147B9E70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69773" y="494778"/>
              <a:ext cx="0" cy="5377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6" name="Line 43">
              <a:extLst>
                <a:ext uri="{FF2B5EF4-FFF2-40B4-BE49-F238E27FC236}">
                  <a16:creationId xmlns:a16="http://schemas.microsoft.com/office/drawing/2014/main" id="{3B123152-4397-FECF-D5C9-332A5A26311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90469" y="521664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7" name="Line 44">
              <a:extLst>
                <a:ext uri="{FF2B5EF4-FFF2-40B4-BE49-F238E27FC236}">
                  <a16:creationId xmlns:a16="http://schemas.microsoft.com/office/drawing/2014/main" id="{A4C6BF99-844E-3776-D41A-E8179A687F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26342" y="494778"/>
              <a:ext cx="0" cy="5377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8" name="Line 45">
              <a:extLst>
                <a:ext uri="{FF2B5EF4-FFF2-40B4-BE49-F238E27FC236}">
                  <a16:creationId xmlns:a16="http://schemas.microsoft.com/office/drawing/2014/main" id="{27F0BEE2-A6B3-3ABC-C609-CFCA500854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88493" y="585778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9" name="Line 46">
              <a:extLst>
                <a:ext uri="{FF2B5EF4-FFF2-40B4-BE49-F238E27FC236}">
                  <a16:creationId xmlns:a16="http://schemas.microsoft.com/office/drawing/2014/main" id="{21AE0DE7-7ADC-5760-8B74-D0EF5AFA92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24366" y="553721"/>
              <a:ext cx="0" cy="5790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0" name="Line 47">
              <a:extLst>
                <a:ext uri="{FF2B5EF4-FFF2-40B4-BE49-F238E27FC236}">
                  <a16:creationId xmlns:a16="http://schemas.microsoft.com/office/drawing/2014/main" id="{935B118A-E132-3586-1991-D9049B8565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96113" y="585778"/>
              <a:ext cx="7036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1" name="Line 48">
              <a:extLst>
                <a:ext uri="{FF2B5EF4-FFF2-40B4-BE49-F238E27FC236}">
                  <a16:creationId xmlns:a16="http://schemas.microsoft.com/office/drawing/2014/main" id="{BD7132DF-66B5-CDF7-61E2-F7736B92A3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30607" y="553721"/>
              <a:ext cx="0" cy="5790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2" name="Line 49">
              <a:extLst>
                <a:ext uri="{FF2B5EF4-FFF2-40B4-BE49-F238E27FC236}">
                  <a16:creationId xmlns:a16="http://schemas.microsoft.com/office/drawing/2014/main" id="{E94BB90F-52D1-37DD-4EB1-943F7C4920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33554" y="648857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3" name="Line 50">
              <a:extLst>
                <a:ext uri="{FF2B5EF4-FFF2-40B4-BE49-F238E27FC236}">
                  <a16:creationId xmlns:a16="http://schemas.microsoft.com/office/drawing/2014/main" id="{46CB3260-ACF7-F5AC-A2D4-4FCAD7D5D7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769427" y="623005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4" name="Line 51">
              <a:extLst>
                <a:ext uri="{FF2B5EF4-FFF2-40B4-BE49-F238E27FC236}">
                  <a16:creationId xmlns:a16="http://schemas.microsoft.com/office/drawing/2014/main" id="{D70A85EB-0894-9086-A406-67FF5FA916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12512" y="723311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5" name="Line 52">
              <a:extLst>
                <a:ext uri="{FF2B5EF4-FFF2-40B4-BE49-F238E27FC236}">
                  <a16:creationId xmlns:a16="http://schemas.microsoft.com/office/drawing/2014/main" id="{8A27F5B3-28F8-690E-8138-544BFCBA70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848385" y="697459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6" name="Line 53">
              <a:extLst>
                <a:ext uri="{FF2B5EF4-FFF2-40B4-BE49-F238E27FC236}">
                  <a16:creationId xmlns:a16="http://schemas.microsoft.com/office/drawing/2014/main" id="{8A8933EE-511C-C36E-8455-BAA2515691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918752" y="723311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7" name="Line 54">
              <a:extLst>
                <a:ext uri="{FF2B5EF4-FFF2-40B4-BE49-F238E27FC236}">
                  <a16:creationId xmlns:a16="http://schemas.microsoft.com/office/drawing/2014/main" id="{2C105A8C-16DC-A4CE-CC5F-22EA9B6F41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54626" y="697459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8" name="Line 55">
              <a:extLst>
                <a:ext uri="{FF2B5EF4-FFF2-40B4-BE49-F238E27FC236}">
                  <a16:creationId xmlns:a16="http://schemas.microsoft.com/office/drawing/2014/main" id="{FEAFA1A9-DC4E-D557-28E5-875C4FCDDF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03638" y="723311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9" name="Line 56">
              <a:extLst>
                <a:ext uri="{FF2B5EF4-FFF2-40B4-BE49-F238E27FC236}">
                  <a16:creationId xmlns:a16="http://schemas.microsoft.com/office/drawing/2014/main" id="{FCF26CE6-82BD-27B2-FFA8-3EA30C2A7D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139511" y="697459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0" name="Line 57">
              <a:extLst>
                <a:ext uri="{FF2B5EF4-FFF2-40B4-BE49-F238E27FC236}">
                  <a16:creationId xmlns:a16="http://schemas.microsoft.com/office/drawing/2014/main" id="{E1EB1C5E-CCF9-82C3-25A8-7D9303B3D7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01662" y="723311"/>
              <a:ext cx="7174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1" name="Line 58">
              <a:extLst>
                <a:ext uri="{FF2B5EF4-FFF2-40B4-BE49-F238E27FC236}">
                  <a16:creationId xmlns:a16="http://schemas.microsoft.com/office/drawing/2014/main" id="{6ED5E309-1007-FDB7-7F65-2070BC320B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437535" y="697459"/>
              <a:ext cx="0" cy="527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2" name="Freeform 59">
              <a:extLst>
                <a:ext uri="{FF2B5EF4-FFF2-40B4-BE49-F238E27FC236}">
                  <a16:creationId xmlns:a16="http://schemas.microsoft.com/office/drawing/2014/main" id="{128B93C0-5CB7-E8C4-E681-D4118D992E06}"/>
                </a:ext>
              </a:extLst>
            </p:cNvPr>
            <p:cNvSpPr>
              <a:spLocks/>
            </p:cNvSpPr>
            <p:nvPr/>
          </p:nvSpPr>
          <p:spPr bwMode="auto">
            <a:xfrm>
              <a:off x="7053028" y="202132"/>
              <a:ext cx="3384507" cy="856222"/>
            </a:xfrm>
            <a:custGeom>
              <a:avLst/>
              <a:gdLst>
                <a:gd name="T0" fmla="*/ 0 w 477"/>
                <a:gd name="T1" fmla="*/ 0 h 161"/>
                <a:gd name="T2" fmla="*/ 7 w 477"/>
                <a:gd name="T3" fmla="*/ 0 h 161"/>
                <a:gd name="T4" fmla="*/ 7 w 477"/>
                <a:gd name="T5" fmla="*/ 12 h 161"/>
                <a:gd name="T6" fmla="*/ 16 w 477"/>
                <a:gd name="T7" fmla="*/ 12 h 161"/>
                <a:gd name="T8" fmla="*/ 16 w 477"/>
                <a:gd name="T9" fmla="*/ 26 h 161"/>
                <a:gd name="T10" fmla="*/ 16 w 477"/>
                <a:gd name="T11" fmla="*/ 26 h 161"/>
                <a:gd name="T12" fmla="*/ 16 w 477"/>
                <a:gd name="T13" fmla="*/ 40 h 161"/>
                <a:gd name="T14" fmla="*/ 64 w 477"/>
                <a:gd name="T15" fmla="*/ 40 h 161"/>
                <a:gd name="T16" fmla="*/ 64 w 477"/>
                <a:gd name="T17" fmla="*/ 54 h 161"/>
                <a:gd name="T18" fmla="*/ 73 w 477"/>
                <a:gd name="T19" fmla="*/ 54 h 161"/>
                <a:gd name="T20" fmla="*/ 73 w 477"/>
                <a:gd name="T21" fmla="*/ 69 h 161"/>
                <a:gd name="T22" fmla="*/ 108 w 477"/>
                <a:gd name="T23" fmla="*/ 69 h 161"/>
                <a:gd name="T24" fmla="*/ 108 w 477"/>
                <a:gd name="T25" fmla="*/ 85 h 161"/>
                <a:gd name="T26" fmla="*/ 144 w 477"/>
                <a:gd name="T27" fmla="*/ 85 h 161"/>
                <a:gd name="T28" fmla="*/ 144 w 477"/>
                <a:gd name="T29" fmla="*/ 102 h 161"/>
                <a:gd name="T30" fmla="*/ 184 w 477"/>
                <a:gd name="T31" fmla="*/ 102 h 161"/>
                <a:gd name="T32" fmla="*/ 184 w 477"/>
                <a:gd name="T33" fmla="*/ 121 h 161"/>
                <a:gd name="T34" fmla="*/ 193 w 477"/>
                <a:gd name="T35" fmla="*/ 121 h 161"/>
                <a:gd name="T36" fmla="*/ 193 w 477"/>
                <a:gd name="T37" fmla="*/ 139 h 161"/>
                <a:gd name="T38" fmla="*/ 274 w 477"/>
                <a:gd name="T39" fmla="*/ 139 h 161"/>
                <a:gd name="T40" fmla="*/ 274 w 477"/>
                <a:gd name="T41" fmla="*/ 161 h 161"/>
                <a:gd name="T42" fmla="*/ 477 w 477"/>
                <a:gd name="T43" fmla="*/ 161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477" h="161">
                  <a:moveTo>
                    <a:pt x="0" y="0"/>
                  </a:moveTo>
                  <a:lnTo>
                    <a:pt x="7" y="0"/>
                  </a:lnTo>
                  <a:lnTo>
                    <a:pt x="7" y="12"/>
                  </a:lnTo>
                  <a:lnTo>
                    <a:pt x="16" y="12"/>
                  </a:lnTo>
                  <a:lnTo>
                    <a:pt x="16" y="26"/>
                  </a:lnTo>
                  <a:lnTo>
                    <a:pt x="16" y="26"/>
                  </a:lnTo>
                  <a:lnTo>
                    <a:pt x="16" y="40"/>
                  </a:lnTo>
                  <a:lnTo>
                    <a:pt x="64" y="40"/>
                  </a:lnTo>
                  <a:lnTo>
                    <a:pt x="64" y="54"/>
                  </a:lnTo>
                  <a:lnTo>
                    <a:pt x="73" y="54"/>
                  </a:lnTo>
                  <a:lnTo>
                    <a:pt x="73" y="69"/>
                  </a:lnTo>
                  <a:lnTo>
                    <a:pt x="108" y="69"/>
                  </a:lnTo>
                  <a:lnTo>
                    <a:pt x="108" y="85"/>
                  </a:lnTo>
                  <a:lnTo>
                    <a:pt x="144" y="85"/>
                  </a:lnTo>
                  <a:lnTo>
                    <a:pt x="144" y="102"/>
                  </a:lnTo>
                  <a:lnTo>
                    <a:pt x="184" y="102"/>
                  </a:lnTo>
                  <a:lnTo>
                    <a:pt x="184" y="121"/>
                  </a:lnTo>
                  <a:lnTo>
                    <a:pt x="193" y="121"/>
                  </a:lnTo>
                  <a:lnTo>
                    <a:pt x="193" y="139"/>
                  </a:lnTo>
                  <a:lnTo>
                    <a:pt x="274" y="139"/>
                  </a:lnTo>
                  <a:lnTo>
                    <a:pt x="274" y="161"/>
                  </a:lnTo>
                  <a:lnTo>
                    <a:pt x="477" y="161"/>
                  </a:lnTo>
                </a:path>
              </a:pathLst>
            </a:custGeom>
            <a:noFill/>
            <a:ln w="1905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3" name="Line 60">
              <a:extLst>
                <a:ext uri="{FF2B5EF4-FFF2-40B4-BE49-F238E27FC236}">
                  <a16:creationId xmlns:a16="http://schemas.microsoft.com/office/drawing/2014/main" id="{4C88BF9C-71C7-2E34-07E3-AAF8F4E636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0952" y="202132"/>
              <a:ext cx="7174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4" name="Line 61">
              <a:extLst>
                <a:ext uri="{FF2B5EF4-FFF2-40B4-BE49-F238E27FC236}">
                  <a16:creationId xmlns:a16="http://schemas.microsoft.com/office/drawing/2014/main" id="{BC06E1A5-A885-21FF-B178-67A22526DF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66825" y="176280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5" name="Line 62">
              <a:extLst>
                <a:ext uri="{FF2B5EF4-FFF2-40B4-BE49-F238E27FC236}">
                  <a16:creationId xmlns:a16="http://schemas.microsoft.com/office/drawing/2014/main" id="{176CDD83-4993-4773-DC92-4A6F214EBD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66825" y="202132"/>
              <a:ext cx="7036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6" name="Line 63">
              <a:extLst>
                <a:ext uri="{FF2B5EF4-FFF2-40B4-BE49-F238E27FC236}">
                  <a16:creationId xmlns:a16="http://schemas.microsoft.com/office/drawing/2014/main" id="{FF458F68-448E-20BD-8113-A7CD9AE3BF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2699" y="176280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7" name="Line 64">
              <a:extLst>
                <a:ext uri="{FF2B5EF4-FFF2-40B4-BE49-F238E27FC236}">
                  <a16:creationId xmlns:a16="http://schemas.microsoft.com/office/drawing/2014/main" id="{3749F7B5-9BE4-41BA-FE00-2B6A685F4A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3724" y="266246"/>
              <a:ext cx="7036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8" name="Line 65">
              <a:extLst>
                <a:ext uri="{FF2B5EF4-FFF2-40B4-BE49-F238E27FC236}">
                  <a16:creationId xmlns:a16="http://schemas.microsoft.com/office/drawing/2014/main" id="{C26FA247-1F99-FF8E-C526-EE25DDFD9D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9597" y="239360"/>
              <a:ext cx="0" cy="5377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9" name="Line 66">
              <a:extLst>
                <a:ext uri="{FF2B5EF4-FFF2-40B4-BE49-F238E27FC236}">
                  <a16:creationId xmlns:a16="http://schemas.microsoft.com/office/drawing/2014/main" id="{644F1EB3-E3F0-9F6A-58E2-038488E610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3724" y="266246"/>
              <a:ext cx="7036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0" name="Line 67">
              <a:extLst>
                <a:ext uri="{FF2B5EF4-FFF2-40B4-BE49-F238E27FC236}">
                  <a16:creationId xmlns:a16="http://schemas.microsoft.com/office/drawing/2014/main" id="{4D7F134B-3206-CE27-1CCD-C4D8D02D8F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9597" y="239360"/>
              <a:ext cx="0" cy="5377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6" name="Line 68">
              <a:extLst>
                <a:ext uri="{FF2B5EF4-FFF2-40B4-BE49-F238E27FC236}">
                  <a16:creationId xmlns:a16="http://schemas.microsoft.com/office/drawing/2014/main" id="{3194CD31-8EEC-88A5-726A-3906F06FE6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87521" y="266246"/>
              <a:ext cx="78645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7" name="Line 69">
              <a:extLst>
                <a:ext uri="{FF2B5EF4-FFF2-40B4-BE49-F238E27FC236}">
                  <a16:creationId xmlns:a16="http://schemas.microsoft.com/office/drawing/2014/main" id="{908091AE-9B5F-B6A4-B0A7-0C60162B49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30293" y="239360"/>
              <a:ext cx="0" cy="5377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8" name="Line 70">
              <a:extLst>
                <a:ext uri="{FF2B5EF4-FFF2-40B4-BE49-F238E27FC236}">
                  <a16:creationId xmlns:a16="http://schemas.microsoft.com/office/drawing/2014/main" id="{FBF6E0CE-67E1-3BA8-CE4F-09B90BAB55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23395" y="266246"/>
              <a:ext cx="7036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9" name="Line 71">
              <a:extLst>
                <a:ext uri="{FF2B5EF4-FFF2-40B4-BE49-F238E27FC236}">
                  <a16:creationId xmlns:a16="http://schemas.microsoft.com/office/drawing/2014/main" id="{D2DA20AE-AD74-EF1B-40F2-5CE28626D5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59268" y="239360"/>
              <a:ext cx="0" cy="5377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0" name="Line 72">
              <a:extLst>
                <a:ext uri="{FF2B5EF4-FFF2-40B4-BE49-F238E27FC236}">
                  <a16:creationId xmlns:a16="http://schemas.microsoft.com/office/drawing/2014/main" id="{2E821D6E-73CB-59BF-8380-A77B43A1AB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29635" y="415154"/>
              <a:ext cx="7174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1" name="Line 73">
              <a:extLst>
                <a:ext uri="{FF2B5EF4-FFF2-40B4-BE49-F238E27FC236}">
                  <a16:creationId xmlns:a16="http://schemas.microsoft.com/office/drawing/2014/main" id="{D669ECE7-304C-980F-256C-A396A12BA3A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65508" y="383097"/>
              <a:ext cx="0" cy="58943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2" name="Line 74">
              <a:extLst>
                <a:ext uri="{FF2B5EF4-FFF2-40B4-BE49-F238E27FC236}">
                  <a16:creationId xmlns:a16="http://schemas.microsoft.com/office/drawing/2014/main" id="{27EBF140-A4B4-9E1E-1578-8E921C7FDE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06963" y="489608"/>
              <a:ext cx="77266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3" name="Line 75">
              <a:extLst>
                <a:ext uri="{FF2B5EF4-FFF2-40B4-BE49-F238E27FC236}">
                  <a16:creationId xmlns:a16="http://schemas.microsoft.com/office/drawing/2014/main" id="{1D1F3821-A52D-31AD-A5E5-83886F4E653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41457" y="462722"/>
              <a:ext cx="0" cy="5377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4" name="Line 76">
              <a:extLst>
                <a:ext uri="{FF2B5EF4-FFF2-40B4-BE49-F238E27FC236}">
                  <a16:creationId xmlns:a16="http://schemas.microsoft.com/office/drawing/2014/main" id="{1124CE66-AFCF-F2C9-8E49-7F6EFC4F42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34558" y="569232"/>
              <a:ext cx="7174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5" name="Line 77">
              <a:extLst>
                <a:ext uri="{FF2B5EF4-FFF2-40B4-BE49-F238E27FC236}">
                  <a16:creationId xmlns:a16="http://schemas.microsoft.com/office/drawing/2014/main" id="{D2695FB4-549A-4600-D602-BB8A40407F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70431" y="537176"/>
              <a:ext cx="0" cy="58943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6" name="Line 78">
              <a:extLst>
                <a:ext uri="{FF2B5EF4-FFF2-40B4-BE49-F238E27FC236}">
                  <a16:creationId xmlns:a16="http://schemas.microsoft.com/office/drawing/2014/main" id="{8813D8B8-F3FF-59C5-8EAD-94C1B3FE05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13203" y="569232"/>
              <a:ext cx="7036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7" name="Line 79">
              <a:extLst>
                <a:ext uri="{FF2B5EF4-FFF2-40B4-BE49-F238E27FC236}">
                  <a16:creationId xmlns:a16="http://schemas.microsoft.com/office/drawing/2014/main" id="{A4EA74E1-7A63-A326-FDCF-9307C84A15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49077" y="537176"/>
              <a:ext cx="0" cy="58943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8" name="Line 80">
              <a:extLst>
                <a:ext uri="{FF2B5EF4-FFF2-40B4-BE49-F238E27FC236}">
                  <a16:creationId xmlns:a16="http://schemas.microsoft.com/office/drawing/2014/main" id="{5EE0B31A-1C19-A13B-36B8-EF2681704F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96772" y="655061"/>
              <a:ext cx="7036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9" name="Line 81">
              <a:extLst>
                <a:ext uri="{FF2B5EF4-FFF2-40B4-BE49-F238E27FC236}">
                  <a16:creationId xmlns:a16="http://schemas.microsoft.com/office/drawing/2014/main" id="{2C69FFC7-D5D4-6539-1E0F-325256ECDF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031265" y="628175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0" name="Line 82">
              <a:extLst>
                <a:ext uri="{FF2B5EF4-FFF2-40B4-BE49-F238E27FC236}">
                  <a16:creationId xmlns:a16="http://schemas.microsoft.com/office/drawing/2014/main" id="{7F2F6C32-E069-9C5A-43C2-96B6210D33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23708" y="745027"/>
              <a:ext cx="7174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1" name="Line 83">
              <a:extLst>
                <a:ext uri="{FF2B5EF4-FFF2-40B4-BE49-F238E27FC236}">
                  <a16:creationId xmlns:a16="http://schemas.microsoft.com/office/drawing/2014/main" id="{8023887E-40E7-DFB9-9489-4409CCCFE7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159581" y="718140"/>
              <a:ext cx="0" cy="53772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2" name="Line 84">
              <a:extLst>
                <a:ext uri="{FF2B5EF4-FFF2-40B4-BE49-F238E27FC236}">
                  <a16:creationId xmlns:a16="http://schemas.microsoft.com/office/drawing/2014/main" id="{93EB3672-E9EB-7E80-E701-8AA0DB72C7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12199" y="941503"/>
              <a:ext cx="7036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3" name="Line 85">
              <a:extLst>
                <a:ext uri="{FF2B5EF4-FFF2-40B4-BE49-F238E27FC236}">
                  <a16:creationId xmlns:a16="http://schemas.microsoft.com/office/drawing/2014/main" id="{5A62F457-BAB7-C20F-6C2E-32BA076B1F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848072" y="915651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4" name="Line 86">
              <a:extLst>
                <a:ext uri="{FF2B5EF4-FFF2-40B4-BE49-F238E27FC236}">
                  <a16:creationId xmlns:a16="http://schemas.microsoft.com/office/drawing/2014/main" id="{43C42BD5-75A4-F522-41C5-C8F34CA7CB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40515" y="941503"/>
              <a:ext cx="7036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5" name="Line 87">
              <a:extLst>
                <a:ext uri="{FF2B5EF4-FFF2-40B4-BE49-F238E27FC236}">
                  <a16:creationId xmlns:a16="http://schemas.microsoft.com/office/drawing/2014/main" id="{54EB25AF-E0D1-449F-73BE-18A4AA3ED1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975009" y="915651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6" name="Line 88">
              <a:extLst>
                <a:ext uri="{FF2B5EF4-FFF2-40B4-BE49-F238E27FC236}">
                  <a16:creationId xmlns:a16="http://schemas.microsoft.com/office/drawing/2014/main" id="{D4904DDA-9653-7129-CB75-E9F6E24C96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266134" y="1058354"/>
              <a:ext cx="7174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7" name="Line 89">
              <a:extLst>
                <a:ext uri="{FF2B5EF4-FFF2-40B4-BE49-F238E27FC236}">
                  <a16:creationId xmlns:a16="http://schemas.microsoft.com/office/drawing/2014/main" id="{515F4941-AB39-848C-ADDD-6CA3606E1B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302008" y="1032502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8" name="Line 90">
              <a:extLst>
                <a:ext uri="{FF2B5EF4-FFF2-40B4-BE49-F238E27FC236}">
                  <a16:creationId xmlns:a16="http://schemas.microsoft.com/office/drawing/2014/main" id="{4E4EADD3-5133-7A67-9379-2F33AB6E91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14488" y="1058354"/>
              <a:ext cx="7174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9" name="Line 91">
              <a:extLst>
                <a:ext uri="{FF2B5EF4-FFF2-40B4-BE49-F238E27FC236}">
                  <a16:creationId xmlns:a16="http://schemas.microsoft.com/office/drawing/2014/main" id="{D4544F06-E9AF-F0A2-5C4F-1CA9B25C95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550361" y="1032502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0" name="Line 92">
              <a:extLst>
                <a:ext uri="{FF2B5EF4-FFF2-40B4-BE49-F238E27FC236}">
                  <a16:creationId xmlns:a16="http://schemas.microsoft.com/office/drawing/2014/main" id="{31A1FE06-A326-C84E-5041-CEB821FED7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89182" y="1058354"/>
              <a:ext cx="77266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1" name="Line 93">
              <a:extLst>
                <a:ext uri="{FF2B5EF4-FFF2-40B4-BE49-F238E27FC236}">
                  <a16:creationId xmlns:a16="http://schemas.microsoft.com/office/drawing/2014/main" id="{C01E236B-3DA6-84EB-8078-0AAEAFC5A2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225055" y="1032502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2" name="Line 94">
              <a:extLst>
                <a:ext uri="{FF2B5EF4-FFF2-40B4-BE49-F238E27FC236}">
                  <a16:creationId xmlns:a16="http://schemas.microsoft.com/office/drawing/2014/main" id="{ACC13044-B314-FE23-2F6B-0D84073E484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01662" y="1058354"/>
              <a:ext cx="7174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3" name="Line 95">
              <a:extLst>
                <a:ext uri="{FF2B5EF4-FFF2-40B4-BE49-F238E27FC236}">
                  <a16:creationId xmlns:a16="http://schemas.microsoft.com/office/drawing/2014/main" id="{C3C01907-6CFA-7E61-4DAC-6C48DA5FFA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437535" y="1032502"/>
              <a:ext cx="0" cy="52738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4" name="Freeform 96">
              <a:extLst>
                <a:ext uri="{FF2B5EF4-FFF2-40B4-BE49-F238E27FC236}">
                  <a16:creationId xmlns:a16="http://schemas.microsoft.com/office/drawing/2014/main" id="{23C3B06F-F1BE-B509-ACC1-EF6E6EF34A79}"/>
                </a:ext>
              </a:extLst>
            </p:cNvPr>
            <p:cNvSpPr>
              <a:spLocks/>
            </p:cNvSpPr>
            <p:nvPr/>
          </p:nvSpPr>
          <p:spPr bwMode="auto">
            <a:xfrm>
              <a:off x="7053028" y="202132"/>
              <a:ext cx="3384507" cy="632860"/>
            </a:xfrm>
            <a:custGeom>
              <a:avLst/>
              <a:gdLst>
                <a:gd name="T0" fmla="*/ 0 w 477"/>
                <a:gd name="T1" fmla="*/ 0 h 119"/>
                <a:gd name="T2" fmla="*/ 2 w 477"/>
                <a:gd name="T3" fmla="*/ 0 h 119"/>
                <a:gd name="T4" fmla="*/ 2 w 477"/>
                <a:gd name="T5" fmla="*/ 11 h 119"/>
                <a:gd name="T6" fmla="*/ 12 w 477"/>
                <a:gd name="T7" fmla="*/ 11 h 119"/>
                <a:gd name="T8" fmla="*/ 12 w 477"/>
                <a:gd name="T9" fmla="*/ 22 h 119"/>
                <a:gd name="T10" fmla="*/ 63 w 477"/>
                <a:gd name="T11" fmla="*/ 22 h 119"/>
                <a:gd name="T12" fmla="*/ 63 w 477"/>
                <a:gd name="T13" fmla="*/ 33 h 119"/>
                <a:gd name="T14" fmla="*/ 65 w 477"/>
                <a:gd name="T15" fmla="*/ 33 h 119"/>
                <a:gd name="T16" fmla="*/ 65 w 477"/>
                <a:gd name="T17" fmla="*/ 45 h 119"/>
                <a:gd name="T18" fmla="*/ 72 w 477"/>
                <a:gd name="T19" fmla="*/ 45 h 119"/>
                <a:gd name="T20" fmla="*/ 72 w 477"/>
                <a:gd name="T21" fmla="*/ 58 h 119"/>
                <a:gd name="T22" fmla="*/ 139 w 477"/>
                <a:gd name="T23" fmla="*/ 58 h 119"/>
                <a:gd name="T24" fmla="*/ 139 w 477"/>
                <a:gd name="T25" fmla="*/ 72 h 119"/>
                <a:gd name="T26" fmla="*/ 459 w 477"/>
                <a:gd name="T27" fmla="*/ 72 h 119"/>
                <a:gd name="T28" fmla="*/ 459 w 477"/>
                <a:gd name="T29" fmla="*/ 93 h 119"/>
                <a:gd name="T30" fmla="*/ 477 w 477"/>
                <a:gd name="T31" fmla="*/ 93 h 119"/>
                <a:gd name="T32" fmla="*/ 477 w 477"/>
                <a:gd name="T33" fmla="*/ 119 h 119"/>
                <a:gd name="T34" fmla="*/ 477 w 477"/>
                <a:gd name="T35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77" h="119">
                  <a:moveTo>
                    <a:pt x="0" y="0"/>
                  </a:moveTo>
                  <a:lnTo>
                    <a:pt x="2" y="0"/>
                  </a:lnTo>
                  <a:lnTo>
                    <a:pt x="2" y="11"/>
                  </a:lnTo>
                  <a:lnTo>
                    <a:pt x="12" y="11"/>
                  </a:lnTo>
                  <a:lnTo>
                    <a:pt x="12" y="22"/>
                  </a:lnTo>
                  <a:lnTo>
                    <a:pt x="63" y="22"/>
                  </a:lnTo>
                  <a:lnTo>
                    <a:pt x="63" y="33"/>
                  </a:lnTo>
                  <a:lnTo>
                    <a:pt x="65" y="33"/>
                  </a:lnTo>
                  <a:lnTo>
                    <a:pt x="65" y="45"/>
                  </a:lnTo>
                  <a:lnTo>
                    <a:pt x="72" y="45"/>
                  </a:lnTo>
                  <a:lnTo>
                    <a:pt x="72" y="58"/>
                  </a:lnTo>
                  <a:lnTo>
                    <a:pt x="139" y="58"/>
                  </a:lnTo>
                  <a:lnTo>
                    <a:pt x="139" y="72"/>
                  </a:lnTo>
                  <a:lnTo>
                    <a:pt x="459" y="72"/>
                  </a:lnTo>
                  <a:lnTo>
                    <a:pt x="459" y="93"/>
                  </a:lnTo>
                  <a:lnTo>
                    <a:pt x="477" y="93"/>
                  </a:lnTo>
                  <a:lnTo>
                    <a:pt x="477" y="119"/>
                  </a:lnTo>
                  <a:lnTo>
                    <a:pt x="477" y="119"/>
                  </a:lnTo>
                </a:path>
              </a:pathLst>
            </a:custGeom>
            <a:noFill/>
            <a:ln w="19050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5" name="Line 97">
              <a:extLst>
                <a:ext uri="{FF2B5EF4-FFF2-40B4-BE49-F238E27FC236}">
                  <a16:creationId xmlns:a16="http://schemas.microsoft.com/office/drawing/2014/main" id="{44CAD0D9-4BA8-9F68-A166-7E413D1E0A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3028" y="261075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6" name="Line 98">
              <a:extLst>
                <a:ext uri="{FF2B5EF4-FFF2-40B4-BE49-F238E27FC236}">
                  <a16:creationId xmlns:a16="http://schemas.microsoft.com/office/drawing/2014/main" id="{2018C6BF-0528-53EA-0250-EA7AD63780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87521" y="234189"/>
              <a:ext cx="0" cy="5377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7" name="Line 99">
              <a:extLst>
                <a:ext uri="{FF2B5EF4-FFF2-40B4-BE49-F238E27FC236}">
                  <a16:creationId xmlns:a16="http://schemas.microsoft.com/office/drawing/2014/main" id="{D64D1798-0F96-ADEF-A4BD-F3E164CEF9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9927" y="261075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8" name="Line 100">
              <a:extLst>
                <a:ext uri="{FF2B5EF4-FFF2-40B4-BE49-F238E27FC236}">
                  <a16:creationId xmlns:a16="http://schemas.microsoft.com/office/drawing/2014/main" id="{401A9B2B-A1C7-DC46-32A8-9F472F41B5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94420" y="234189"/>
              <a:ext cx="0" cy="5377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9" name="Line 101">
              <a:extLst>
                <a:ext uri="{FF2B5EF4-FFF2-40B4-BE49-F238E27FC236}">
                  <a16:creationId xmlns:a16="http://schemas.microsoft.com/office/drawing/2014/main" id="{29407A8E-487B-AB26-C425-309CBC45CC7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3724" y="261075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0" name="Line 102">
              <a:extLst>
                <a:ext uri="{FF2B5EF4-FFF2-40B4-BE49-F238E27FC236}">
                  <a16:creationId xmlns:a16="http://schemas.microsoft.com/office/drawing/2014/main" id="{16A790B3-3701-97D0-32AA-2267EA565D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9597" y="234189"/>
              <a:ext cx="0" cy="5377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1" name="Line 103">
              <a:extLst>
                <a:ext uri="{FF2B5EF4-FFF2-40B4-BE49-F238E27FC236}">
                  <a16:creationId xmlns:a16="http://schemas.microsoft.com/office/drawing/2014/main" id="{451EF586-5DED-62FF-656F-F820B9FC92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78647" y="318984"/>
              <a:ext cx="7174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2" name="Line 104">
              <a:extLst>
                <a:ext uri="{FF2B5EF4-FFF2-40B4-BE49-F238E27FC236}">
                  <a16:creationId xmlns:a16="http://schemas.microsoft.com/office/drawing/2014/main" id="{17CBE48F-A436-0C3D-0256-B786482CFD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14520" y="293132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3" name="Line 105">
              <a:extLst>
                <a:ext uri="{FF2B5EF4-FFF2-40B4-BE49-F238E27FC236}">
                  <a16:creationId xmlns:a16="http://schemas.microsoft.com/office/drawing/2014/main" id="{DAE447C0-E511-1E2C-6BA9-3198093046A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64191" y="351041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4" name="Line 106">
              <a:extLst>
                <a:ext uri="{FF2B5EF4-FFF2-40B4-BE49-F238E27FC236}">
                  <a16:creationId xmlns:a16="http://schemas.microsoft.com/office/drawing/2014/main" id="{6B51524E-8AFF-E81C-593B-3D6921C652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00064" y="325188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5" name="Line 107">
              <a:extLst>
                <a:ext uri="{FF2B5EF4-FFF2-40B4-BE49-F238E27FC236}">
                  <a16:creationId xmlns:a16="http://schemas.microsoft.com/office/drawing/2014/main" id="{55DD3916-E656-27FA-A5B0-E3734DFE43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00064" y="442040"/>
              <a:ext cx="77266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6" name="Line 108">
              <a:extLst>
                <a:ext uri="{FF2B5EF4-FFF2-40B4-BE49-F238E27FC236}">
                  <a16:creationId xmlns:a16="http://schemas.microsoft.com/office/drawing/2014/main" id="{7A47B25E-3D2A-18CE-2E7D-E32375C44D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534558" y="415154"/>
              <a:ext cx="0" cy="53772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7" name="Line 109">
              <a:extLst>
                <a:ext uri="{FF2B5EF4-FFF2-40B4-BE49-F238E27FC236}">
                  <a16:creationId xmlns:a16="http://schemas.microsoft.com/office/drawing/2014/main" id="{C17A8D2E-2676-C00B-1223-CC74C18B78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584229" y="511324"/>
              <a:ext cx="7174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8" name="Line 110">
              <a:extLst>
                <a:ext uri="{FF2B5EF4-FFF2-40B4-BE49-F238E27FC236}">
                  <a16:creationId xmlns:a16="http://schemas.microsoft.com/office/drawing/2014/main" id="{5A68E4B6-87B6-FAA9-64AC-9263B372174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20102" y="484437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9" name="Line 111">
              <a:extLst>
                <a:ext uri="{FF2B5EF4-FFF2-40B4-BE49-F238E27FC236}">
                  <a16:creationId xmlns:a16="http://schemas.microsoft.com/office/drawing/2014/main" id="{64DB006E-6EA4-5D61-483E-5F9D1095B8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11886" y="511324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0" name="Line 112">
              <a:extLst>
                <a:ext uri="{FF2B5EF4-FFF2-40B4-BE49-F238E27FC236}">
                  <a16:creationId xmlns:a16="http://schemas.microsoft.com/office/drawing/2014/main" id="{8AD0C5F4-ABE5-1DAE-E19B-29E1E34A0D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847759" y="484437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1" name="Line 113">
              <a:extLst>
                <a:ext uri="{FF2B5EF4-FFF2-40B4-BE49-F238E27FC236}">
                  <a16:creationId xmlns:a16="http://schemas.microsoft.com/office/drawing/2014/main" id="{447F42C0-1503-CD96-10E0-924D38C633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82253" y="511324"/>
              <a:ext cx="7174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2" name="Line 114">
              <a:extLst>
                <a:ext uri="{FF2B5EF4-FFF2-40B4-BE49-F238E27FC236}">
                  <a16:creationId xmlns:a16="http://schemas.microsoft.com/office/drawing/2014/main" id="{828F63DB-8730-134E-114E-B6BFBCD9DFB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18126" y="484437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3" name="Line 115">
              <a:extLst>
                <a:ext uri="{FF2B5EF4-FFF2-40B4-BE49-F238E27FC236}">
                  <a16:creationId xmlns:a16="http://schemas.microsoft.com/office/drawing/2014/main" id="{0D983E61-B2E9-F113-A0A7-D9CA647060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960898" y="511324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4" name="Line 116">
              <a:extLst>
                <a:ext uri="{FF2B5EF4-FFF2-40B4-BE49-F238E27FC236}">
                  <a16:creationId xmlns:a16="http://schemas.microsoft.com/office/drawing/2014/main" id="{8A6463E5-2511-F220-B7FA-694828654B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996772" y="484437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5" name="Line 117">
              <a:extLst>
                <a:ext uri="{FF2B5EF4-FFF2-40B4-BE49-F238E27FC236}">
                  <a16:creationId xmlns:a16="http://schemas.microsoft.com/office/drawing/2014/main" id="{FE8A2523-B78C-0273-E820-2C858480EF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66480" y="585778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6" name="Line 118">
              <a:extLst>
                <a:ext uri="{FF2B5EF4-FFF2-40B4-BE49-F238E27FC236}">
                  <a16:creationId xmlns:a16="http://schemas.microsoft.com/office/drawing/2014/main" id="{376062A3-5BE5-9299-6DF5-888BAD06E3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2353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7" name="Line 119">
              <a:extLst>
                <a:ext uri="{FF2B5EF4-FFF2-40B4-BE49-F238E27FC236}">
                  <a16:creationId xmlns:a16="http://schemas.microsoft.com/office/drawing/2014/main" id="{9BB6C241-05DC-368A-0A12-F4CEA8B2B1B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77643" y="585778"/>
              <a:ext cx="7174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8" name="Line 120">
              <a:extLst>
                <a:ext uri="{FF2B5EF4-FFF2-40B4-BE49-F238E27FC236}">
                  <a16:creationId xmlns:a16="http://schemas.microsoft.com/office/drawing/2014/main" id="{CA945370-9A8B-507E-DC87-08E169754CA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613516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9" name="Line 121">
              <a:extLst>
                <a:ext uri="{FF2B5EF4-FFF2-40B4-BE49-F238E27FC236}">
                  <a16:creationId xmlns:a16="http://schemas.microsoft.com/office/drawing/2014/main" id="{62ABE951-83F9-8328-2297-87C4C322DB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71057" y="585778"/>
              <a:ext cx="7174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0" name="Line 122">
              <a:extLst>
                <a:ext uri="{FF2B5EF4-FFF2-40B4-BE49-F238E27FC236}">
                  <a16:creationId xmlns:a16="http://schemas.microsoft.com/office/drawing/2014/main" id="{E7E0D439-91AC-726C-7A4A-13FD68B8DE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606931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1" name="Line 123">
              <a:extLst>
                <a:ext uri="{FF2B5EF4-FFF2-40B4-BE49-F238E27FC236}">
                  <a16:creationId xmlns:a16="http://schemas.microsoft.com/office/drawing/2014/main" id="{15592C22-4AC9-C7A5-F7E4-FD566B2D6A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00032" y="585778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2" name="Line 124">
              <a:extLst>
                <a:ext uri="{FF2B5EF4-FFF2-40B4-BE49-F238E27FC236}">
                  <a16:creationId xmlns:a16="http://schemas.microsoft.com/office/drawing/2014/main" id="{AE8E82F5-F220-D714-1159-62ABD5EA36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635905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3" name="Line 125">
              <a:extLst>
                <a:ext uri="{FF2B5EF4-FFF2-40B4-BE49-F238E27FC236}">
                  <a16:creationId xmlns:a16="http://schemas.microsoft.com/office/drawing/2014/main" id="{96D7EA1C-8266-8E54-DE06-99D692ECEE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35905" y="585778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4" name="Line 126">
              <a:extLst>
                <a:ext uri="{FF2B5EF4-FFF2-40B4-BE49-F238E27FC236}">
                  <a16:creationId xmlns:a16="http://schemas.microsoft.com/office/drawing/2014/main" id="{238C57E1-C6A4-A6DC-B7A1-172FEE7447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670399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5" name="Line 127">
              <a:extLst>
                <a:ext uri="{FF2B5EF4-FFF2-40B4-BE49-F238E27FC236}">
                  <a16:creationId xmlns:a16="http://schemas.microsoft.com/office/drawing/2014/main" id="{A4BEB75D-F7F4-3AA8-1C0B-6950001799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84259" y="585778"/>
              <a:ext cx="77266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6" name="Line 128">
              <a:extLst>
                <a:ext uri="{FF2B5EF4-FFF2-40B4-BE49-F238E27FC236}">
                  <a16:creationId xmlns:a16="http://schemas.microsoft.com/office/drawing/2014/main" id="{F79D63F1-2EB8-42E0-54A7-22BE1C49D55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27031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7" name="Line 129">
              <a:extLst>
                <a:ext uri="{FF2B5EF4-FFF2-40B4-BE49-F238E27FC236}">
                  <a16:creationId xmlns:a16="http://schemas.microsoft.com/office/drawing/2014/main" id="{9F867994-D39E-7DF5-3C17-D562656ED2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274726" y="643686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8" name="Line 130">
              <a:extLst>
                <a:ext uri="{FF2B5EF4-FFF2-40B4-BE49-F238E27FC236}">
                  <a16:creationId xmlns:a16="http://schemas.microsoft.com/office/drawing/2014/main" id="{2A88FE8C-9E8F-1BA5-C66C-A71A3869E7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309219" y="617834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9" name="Line 131">
              <a:extLst>
                <a:ext uri="{FF2B5EF4-FFF2-40B4-BE49-F238E27FC236}">
                  <a16:creationId xmlns:a16="http://schemas.microsoft.com/office/drawing/2014/main" id="{47214FD5-3ACA-4608-ED68-41052CA07B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324396" y="697459"/>
              <a:ext cx="7036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0" name="Line 132">
              <a:extLst>
                <a:ext uri="{FF2B5EF4-FFF2-40B4-BE49-F238E27FC236}">
                  <a16:creationId xmlns:a16="http://schemas.microsoft.com/office/drawing/2014/main" id="{FB9AFF70-BEC1-B23C-AC59-0B95F2C7D0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358890" y="670573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1" name="Line 133">
              <a:extLst>
                <a:ext uri="{FF2B5EF4-FFF2-40B4-BE49-F238E27FC236}">
                  <a16:creationId xmlns:a16="http://schemas.microsoft.com/office/drawing/2014/main" id="{89926CF3-1F2A-6115-D4EE-33334FCE746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331295" y="697459"/>
              <a:ext cx="77266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2" name="Line 134">
              <a:extLst>
                <a:ext uri="{FF2B5EF4-FFF2-40B4-BE49-F238E27FC236}">
                  <a16:creationId xmlns:a16="http://schemas.microsoft.com/office/drawing/2014/main" id="{1BC309D2-9209-391A-EC27-971F187B62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374067" y="670573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3" name="Line 135">
              <a:extLst>
                <a:ext uri="{FF2B5EF4-FFF2-40B4-BE49-F238E27FC236}">
                  <a16:creationId xmlns:a16="http://schemas.microsoft.com/office/drawing/2014/main" id="{43F0C9C1-0F1A-946E-16DE-EE67222EF9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01662" y="834992"/>
              <a:ext cx="7174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4" name="Line 136">
              <a:extLst>
                <a:ext uri="{FF2B5EF4-FFF2-40B4-BE49-F238E27FC236}">
                  <a16:creationId xmlns:a16="http://schemas.microsoft.com/office/drawing/2014/main" id="{FF0737ED-A061-F431-0C54-E1F07368BA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437535" y="809140"/>
              <a:ext cx="0" cy="52738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5" name="Freeform 137">
              <a:extLst>
                <a:ext uri="{FF2B5EF4-FFF2-40B4-BE49-F238E27FC236}">
                  <a16:creationId xmlns:a16="http://schemas.microsoft.com/office/drawing/2014/main" id="{4B559EF9-429F-4144-133F-086B21A22758}"/>
                </a:ext>
              </a:extLst>
            </p:cNvPr>
            <p:cNvSpPr>
              <a:spLocks/>
            </p:cNvSpPr>
            <p:nvPr/>
          </p:nvSpPr>
          <p:spPr bwMode="auto">
            <a:xfrm>
              <a:off x="7053028" y="202132"/>
              <a:ext cx="3384507" cy="761086"/>
            </a:xfrm>
            <a:custGeom>
              <a:avLst/>
              <a:gdLst>
                <a:gd name="T0" fmla="*/ 0 w 477"/>
                <a:gd name="T1" fmla="*/ 0 h 143"/>
                <a:gd name="T2" fmla="*/ 4 w 477"/>
                <a:gd name="T3" fmla="*/ 0 h 143"/>
                <a:gd name="T4" fmla="*/ 4 w 477"/>
                <a:gd name="T5" fmla="*/ 12 h 143"/>
                <a:gd name="T6" fmla="*/ 12 w 477"/>
                <a:gd name="T7" fmla="*/ 12 h 143"/>
                <a:gd name="T8" fmla="*/ 12 w 477"/>
                <a:gd name="T9" fmla="*/ 24 h 143"/>
                <a:gd name="T10" fmla="*/ 90 w 477"/>
                <a:gd name="T11" fmla="*/ 24 h 143"/>
                <a:gd name="T12" fmla="*/ 90 w 477"/>
                <a:gd name="T13" fmla="*/ 55 h 143"/>
                <a:gd name="T14" fmla="*/ 158 w 477"/>
                <a:gd name="T15" fmla="*/ 55 h 143"/>
                <a:gd name="T16" fmla="*/ 158 w 477"/>
                <a:gd name="T17" fmla="*/ 72 h 143"/>
                <a:gd name="T18" fmla="*/ 231 w 477"/>
                <a:gd name="T19" fmla="*/ 72 h 143"/>
                <a:gd name="T20" fmla="*/ 231 w 477"/>
                <a:gd name="T21" fmla="*/ 92 h 143"/>
                <a:gd name="T22" fmla="*/ 318 w 477"/>
                <a:gd name="T23" fmla="*/ 92 h 143"/>
                <a:gd name="T24" fmla="*/ 318 w 477"/>
                <a:gd name="T25" fmla="*/ 116 h 143"/>
                <a:gd name="T26" fmla="*/ 399 w 477"/>
                <a:gd name="T27" fmla="*/ 116 h 143"/>
                <a:gd name="T28" fmla="*/ 399 w 477"/>
                <a:gd name="T29" fmla="*/ 143 h 143"/>
                <a:gd name="T30" fmla="*/ 477 w 477"/>
                <a:gd name="T31" fmla="*/ 143 h 1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477" h="143">
                  <a:moveTo>
                    <a:pt x="0" y="0"/>
                  </a:moveTo>
                  <a:lnTo>
                    <a:pt x="4" y="0"/>
                  </a:lnTo>
                  <a:lnTo>
                    <a:pt x="4" y="12"/>
                  </a:lnTo>
                  <a:lnTo>
                    <a:pt x="12" y="12"/>
                  </a:lnTo>
                  <a:lnTo>
                    <a:pt x="12" y="24"/>
                  </a:lnTo>
                  <a:lnTo>
                    <a:pt x="90" y="24"/>
                  </a:lnTo>
                  <a:lnTo>
                    <a:pt x="90" y="55"/>
                  </a:lnTo>
                  <a:lnTo>
                    <a:pt x="158" y="55"/>
                  </a:lnTo>
                  <a:lnTo>
                    <a:pt x="158" y="72"/>
                  </a:lnTo>
                  <a:lnTo>
                    <a:pt x="231" y="72"/>
                  </a:lnTo>
                  <a:lnTo>
                    <a:pt x="231" y="92"/>
                  </a:lnTo>
                  <a:lnTo>
                    <a:pt x="318" y="92"/>
                  </a:lnTo>
                  <a:lnTo>
                    <a:pt x="318" y="116"/>
                  </a:lnTo>
                  <a:lnTo>
                    <a:pt x="399" y="116"/>
                  </a:lnTo>
                  <a:lnTo>
                    <a:pt x="399" y="143"/>
                  </a:lnTo>
                  <a:lnTo>
                    <a:pt x="477" y="143"/>
                  </a:lnTo>
                </a:path>
              </a:pathLst>
            </a:custGeom>
            <a:noFill/>
            <a:ln w="19050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6" name="Line 138">
              <a:extLst>
                <a:ext uri="{FF2B5EF4-FFF2-40B4-BE49-F238E27FC236}">
                  <a16:creationId xmlns:a16="http://schemas.microsoft.com/office/drawing/2014/main" id="{F8BD94A6-1B3A-552D-EDCE-311DE8985C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37851" y="202132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7" name="Line 139">
              <a:extLst>
                <a:ext uri="{FF2B5EF4-FFF2-40B4-BE49-F238E27FC236}">
                  <a16:creationId xmlns:a16="http://schemas.microsoft.com/office/drawing/2014/main" id="{012412BD-850C-9735-3B8D-37232E8186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73724" y="176280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8" name="Line 140">
              <a:extLst>
                <a:ext uri="{FF2B5EF4-FFF2-40B4-BE49-F238E27FC236}">
                  <a16:creationId xmlns:a16="http://schemas.microsoft.com/office/drawing/2014/main" id="{90E64298-F70E-76A8-E0DD-B5C3975263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44749" y="234189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9" name="Line 141">
              <a:extLst>
                <a:ext uri="{FF2B5EF4-FFF2-40B4-BE49-F238E27FC236}">
                  <a16:creationId xmlns:a16="http://schemas.microsoft.com/office/drawing/2014/main" id="{1BA98ABA-6ACB-A4D6-1E9B-E2D19B8EC9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80623" y="207303"/>
              <a:ext cx="0" cy="53772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0" name="Line 142">
              <a:extLst>
                <a:ext uri="{FF2B5EF4-FFF2-40B4-BE49-F238E27FC236}">
                  <a16:creationId xmlns:a16="http://schemas.microsoft.com/office/drawing/2014/main" id="{6091B861-DB82-B097-F1AE-9B79EF5729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9927" y="266246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1" name="Line 143">
              <a:extLst>
                <a:ext uri="{FF2B5EF4-FFF2-40B4-BE49-F238E27FC236}">
                  <a16:creationId xmlns:a16="http://schemas.microsoft.com/office/drawing/2014/main" id="{FDF73434-E665-E209-9F42-DCAA70D3C0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094420" y="234189"/>
              <a:ext cx="0" cy="58943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2" name="Line 144">
              <a:extLst>
                <a:ext uri="{FF2B5EF4-FFF2-40B4-BE49-F238E27FC236}">
                  <a16:creationId xmlns:a16="http://schemas.microsoft.com/office/drawing/2014/main" id="{E7A1BE6A-F8D7-36BD-5557-A6B5CB1DE7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73724" y="266246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3" name="Line 145">
              <a:extLst>
                <a:ext uri="{FF2B5EF4-FFF2-40B4-BE49-F238E27FC236}">
                  <a16:creationId xmlns:a16="http://schemas.microsoft.com/office/drawing/2014/main" id="{02BB06E9-BA0A-7DF9-CC4B-C4BAA487C8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09597" y="234189"/>
              <a:ext cx="0" cy="58943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4" name="Line 146">
              <a:extLst>
                <a:ext uri="{FF2B5EF4-FFF2-40B4-BE49-F238E27FC236}">
                  <a16:creationId xmlns:a16="http://schemas.microsoft.com/office/drawing/2014/main" id="{1DA9295C-F366-7C07-E558-872F7B8E03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09597" y="330359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5" name="Line 147">
              <a:extLst>
                <a:ext uri="{FF2B5EF4-FFF2-40B4-BE49-F238E27FC236}">
                  <a16:creationId xmlns:a16="http://schemas.microsoft.com/office/drawing/2014/main" id="{69E00DD6-BCBB-67E0-2E8E-D1356B3818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44091" y="303473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6" name="Line 148">
              <a:extLst>
                <a:ext uri="{FF2B5EF4-FFF2-40B4-BE49-F238E27FC236}">
                  <a16:creationId xmlns:a16="http://schemas.microsoft.com/office/drawing/2014/main" id="{5D5DA2A0-E0E0-9D59-844C-EB80DD3A0E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44091" y="330359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7" name="Line 149">
              <a:extLst>
                <a:ext uri="{FF2B5EF4-FFF2-40B4-BE49-F238E27FC236}">
                  <a16:creationId xmlns:a16="http://schemas.microsoft.com/office/drawing/2014/main" id="{76082F46-9B37-1E42-22FB-4BB55773D5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179964" y="303473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8" name="Line 150">
              <a:extLst>
                <a:ext uri="{FF2B5EF4-FFF2-40B4-BE49-F238E27FC236}">
                  <a16:creationId xmlns:a16="http://schemas.microsoft.com/office/drawing/2014/main" id="{8F2F8400-4FF5-93C4-1273-5B8780C4FC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293103" y="330359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9" name="Line 151">
              <a:extLst>
                <a:ext uri="{FF2B5EF4-FFF2-40B4-BE49-F238E27FC236}">
                  <a16:creationId xmlns:a16="http://schemas.microsoft.com/office/drawing/2014/main" id="{06B492FD-1BD2-7815-25FF-1E7C187035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28976" y="303473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0" name="Line 152">
              <a:extLst>
                <a:ext uri="{FF2B5EF4-FFF2-40B4-BE49-F238E27FC236}">
                  <a16:creationId xmlns:a16="http://schemas.microsoft.com/office/drawing/2014/main" id="{3A64C3E3-F39C-EF25-4D8F-377C0E57F27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15179" y="330359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1" name="Line 153">
              <a:extLst>
                <a:ext uri="{FF2B5EF4-FFF2-40B4-BE49-F238E27FC236}">
                  <a16:creationId xmlns:a16="http://schemas.microsoft.com/office/drawing/2014/main" id="{FD70345B-971E-30AA-9C4D-83345C6D99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351052" y="303473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2" name="Line 154">
              <a:extLst>
                <a:ext uri="{FF2B5EF4-FFF2-40B4-BE49-F238E27FC236}">
                  <a16:creationId xmlns:a16="http://schemas.microsoft.com/office/drawing/2014/main" id="{CC0AB385-63E6-524D-A441-A568C11C15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435216" y="330359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3" name="Line 155">
              <a:extLst>
                <a:ext uri="{FF2B5EF4-FFF2-40B4-BE49-F238E27FC236}">
                  <a16:creationId xmlns:a16="http://schemas.microsoft.com/office/drawing/2014/main" id="{2DEECFFA-BE00-9D59-9BB3-07E3D3D61C9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71090" y="303473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4" name="Line 156">
              <a:extLst>
                <a:ext uri="{FF2B5EF4-FFF2-40B4-BE49-F238E27FC236}">
                  <a16:creationId xmlns:a16="http://schemas.microsoft.com/office/drawing/2014/main" id="{B59F949A-00E4-2ED0-7528-100C10FE86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06305" y="330359"/>
              <a:ext cx="77266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5" name="Line 157">
              <a:extLst>
                <a:ext uri="{FF2B5EF4-FFF2-40B4-BE49-F238E27FC236}">
                  <a16:creationId xmlns:a16="http://schemas.microsoft.com/office/drawing/2014/main" id="{EBA4100C-AFBF-0983-F55F-A863865600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40798" y="303473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6" name="Line 158">
              <a:extLst>
                <a:ext uri="{FF2B5EF4-FFF2-40B4-BE49-F238E27FC236}">
                  <a16:creationId xmlns:a16="http://schemas.microsoft.com/office/drawing/2014/main" id="{54C1B023-FB01-6CDB-D293-E5A8DE4220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12545" y="494778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7" name="Line 159">
              <a:extLst>
                <a:ext uri="{FF2B5EF4-FFF2-40B4-BE49-F238E27FC236}">
                  <a16:creationId xmlns:a16="http://schemas.microsoft.com/office/drawing/2014/main" id="{34190360-7FAB-7ABD-96F0-0DA57595A4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48418" y="468926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8" name="Line 160">
              <a:extLst>
                <a:ext uri="{FF2B5EF4-FFF2-40B4-BE49-F238E27FC236}">
                  <a16:creationId xmlns:a16="http://schemas.microsoft.com/office/drawing/2014/main" id="{A6ACE4D8-4693-84C4-FBB2-74AADBB120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26342" y="494778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9" name="Line 161">
              <a:extLst>
                <a:ext uri="{FF2B5EF4-FFF2-40B4-BE49-F238E27FC236}">
                  <a16:creationId xmlns:a16="http://schemas.microsoft.com/office/drawing/2014/main" id="{0C5E589E-5D31-5744-016B-D0233A95EB7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762215" y="468926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0" name="Line 162">
              <a:extLst>
                <a:ext uri="{FF2B5EF4-FFF2-40B4-BE49-F238E27FC236}">
                  <a16:creationId xmlns:a16="http://schemas.microsoft.com/office/drawing/2014/main" id="{FD96AC29-C84B-60D9-DA10-D0DC05D050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65821" y="585778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1" name="Line 163">
              <a:extLst>
                <a:ext uri="{FF2B5EF4-FFF2-40B4-BE49-F238E27FC236}">
                  <a16:creationId xmlns:a16="http://schemas.microsoft.com/office/drawing/2014/main" id="{45BCE9E9-F9DE-5002-25C8-9B0A409592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01695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2" name="Line 164">
              <a:extLst>
                <a:ext uri="{FF2B5EF4-FFF2-40B4-BE49-F238E27FC236}">
                  <a16:creationId xmlns:a16="http://schemas.microsoft.com/office/drawing/2014/main" id="{B9AE7BD6-2EB3-A560-9E97-013F06891F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15492" y="585778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3" name="Line 165">
              <a:extLst>
                <a:ext uri="{FF2B5EF4-FFF2-40B4-BE49-F238E27FC236}">
                  <a16:creationId xmlns:a16="http://schemas.microsoft.com/office/drawing/2014/main" id="{BD34C18D-CF0F-9ADA-EAD2-9076A6F9AC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51365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4" name="Line 166">
              <a:extLst>
                <a:ext uri="{FF2B5EF4-FFF2-40B4-BE49-F238E27FC236}">
                  <a16:creationId xmlns:a16="http://schemas.microsoft.com/office/drawing/2014/main" id="{13143673-F662-8BD8-1A18-3538200B04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22391" y="585778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5" name="Line 167">
              <a:extLst>
                <a:ext uri="{FF2B5EF4-FFF2-40B4-BE49-F238E27FC236}">
                  <a16:creationId xmlns:a16="http://schemas.microsoft.com/office/drawing/2014/main" id="{2B9B9172-276B-1BDD-F28D-338B57292F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358264" y="558892"/>
              <a:ext cx="0" cy="52738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6" name="Line 168">
              <a:extLst>
                <a:ext uri="{FF2B5EF4-FFF2-40B4-BE49-F238E27FC236}">
                  <a16:creationId xmlns:a16="http://schemas.microsoft.com/office/drawing/2014/main" id="{D330B35B-F011-25D8-2224-4CB17CBF68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75667" y="692288"/>
              <a:ext cx="78645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7" name="Line 169">
              <a:extLst>
                <a:ext uri="{FF2B5EF4-FFF2-40B4-BE49-F238E27FC236}">
                  <a16:creationId xmlns:a16="http://schemas.microsoft.com/office/drawing/2014/main" id="{652F1A0C-8968-38E7-24BA-96E09F07AA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918439" y="665402"/>
              <a:ext cx="0" cy="57909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8" name="Line 170">
              <a:extLst>
                <a:ext uri="{FF2B5EF4-FFF2-40B4-BE49-F238E27FC236}">
                  <a16:creationId xmlns:a16="http://schemas.microsoft.com/office/drawing/2014/main" id="{98492BAD-16BF-DF2C-3F3C-9FADF9B266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30920" y="692288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9" name="Line 171">
              <a:extLst>
                <a:ext uri="{FF2B5EF4-FFF2-40B4-BE49-F238E27FC236}">
                  <a16:creationId xmlns:a16="http://schemas.microsoft.com/office/drawing/2014/main" id="{2919E3B4-B64E-42D1-6ABC-63EE61A14F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166793" y="665402"/>
              <a:ext cx="0" cy="57909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0" name="Line 172">
              <a:extLst>
                <a:ext uri="{FF2B5EF4-FFF2-40B4-BE49-F238E27FC236}">
                  <a16:creationId xmlns:a16="http://schemas.microsoft.com/office/drawing/2014/main" id="{DA5B6876-2E23-9229-C2ED-782DC2BD04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685576" y="819481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1" name="Line 173">
              <a:extLst>
                <a:ext uri="{FF2B5EF4-FFF2-40B4-BE49-F238E27FC236}">
                  <a16:creationId xmlns:a16="http://schemas.microsoft.com/office/drawing/2014/main" id="{03C1D2C6-78B3-8F0D-04DF-6ABE5B7C1B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720069" y="792595"/>
              <a:ext cx="0" cy="58943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2" name="Line 174">
              <a:extLst>
                <a:ext uri="{FF2B5EF4-FFF2-40B4-BE49-F238E27FC236}">
                  <a16:creationId xmlns:a16="http://schemas.microsoft.com/office/drawing/2014/main" id="{F5187056-E33E-820D-2F0F-FA34A8F262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91157" y="963218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3" name="Line 175">
              <a:extLst>
                <a:ext uri="{FF2B5EF4-FFF2-40B4-BE49-F238E27FC236}">
                  <a16:creationId xmlns:a16="http://schemas.microsoft.com/office/drawing/2014/main" id="{E7923B87-BE40-46C4-D646-EAE54AF929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927031" y="936332"/>
              <a:ext cx="0" cy="53772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4" name="Line 176">
              <a:extLst>
                <a:ext uri="{FF2B5EF4-FFF2-40B4-BE49-F238E27FC236}">
                  <a16:creationId xmlns:a16="http://schemas.microsoft.com/office/drawing/2014/main" id="{C5FAB64B-7724-75C0-1272-828139FAF66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076043" y="963218"/>
              <a:ext cx="77266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5" name="Line 177">
              <a:extLst>
                <a:ext uri="{FF2B5EF4-FFF2-40B4-BE49-F238E27FC236}">
                  <a16:creationId xmlns:a16="http://schemas.microsoft.com/office/drawing/2014/main" id="{06414AE2-34E2-E791-1349-A4752B22E8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117435" y="936332"/>
              <a:ext cx="0" cy="53772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6" name="Line 178">
              <a:extLst>
                <a:ext uri="{FF2B5EF4-FFF2-40B4-BE49-F238E27FC236}">
                  <a16:creationId xmlns:a16="http://schemas.microsoft.com/office/drawing/2014/main" id="{4D3166AE-7CE0-3751-C1BC-44ECEA01FC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39511" y="963218"/>
              <a:ext cx="7036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7" name="Line 179">
              <a:extLst>
                <a:ext uri="{FF2B5EF4-FFF2-40B4-BE49-F238E27FC236}">
                  <a16:creationId xmlns:a16="http://schemas.microsoft.com/office/drawing/2014/main" id="{77309A2D-A98A-BC1D-E9C4-B17BE98697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175384" y="936332"/>
              <a:ext cx="0" cy="53772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8" name="Line 180">
              <a:extLst>
                <a:ext uri="{FF2B5EF4-FFF2-40B4-BE49-F238E27FC236}">
                  <a16:creationId xmlns:a16="http://schemas.microsoft.com/office/drawing/2014/main" id="{2D62C668-E2CB-36AB-3404-DA69A9F2FE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01662" y="963218"/>
              <a:ext cx="7174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9" name="Line 181">
              <a:extLst>
                <a:ext uri="{FF2B5EF4-FFF2-40B4-BE49-F238E27FC236}">
                  <a16:creationId xmlns:a16="http://schemas.microsoft.com/office/drawing/2014/main" id="{552F2B5D-F346-02DC-1437-8ECB744F72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437535" y="936332"/>
              <a:ext cx="0" cy="53772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0" name="Rectangle 182">
              <a:extLst>
                <a:ext uri="{FF2B5EF4-FFF2-40B4-BE49-F238E27FC236}">
                  <a16:creationId xmlns:a16="http://schemas.microsoft.com/office/drawing/2014/main" id="{75044331-D114-3EC7-CD3F-5E6182B17E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0585" y="2829740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1" name="Rectangle 183">
              <a:extLst>
                <a:ext uri="{FF2B5EF4-FFF2-40B4-BE49-F238E27FC236}">
                  <a16:creationId xmlns:a16="http://schemas.microsoft.com/office/drawing/2014/main" id="{5E63CBBB-FDD5-98F8-2BAF-DA6B07F5CD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7835" y="2829740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2" name="Rectangle 184">
              <a:extLst>
                <a:ext uri="{FF2B5EF4-FFF2-40B4-BE49-F238E27FC236}">
                  <a16:creationId xmlns:a16="http://schemas.microsoft.com/office/drawing/2014/main" id="{4218D2D4-B93E-F5B3-3A55-FDAFEEAE5C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16464" y="2829740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3" name="Rectangle 185">
              <a:extLst>
                <a:ext uri="{FF2B5EF4-FFF2-40B4-BE49-F238E27FC236}">
                  <a16:creationId xmlns:a16="http://schemas.microsoft.com/office/drawing/2014/main" id="{249B0B23-66F1-3A47-F1F2-5C5A847E84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45093" y="2829740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4" name="Rectangle 186">
              <a:extLst>
                <a:ext uri="{FF2B5EF4-FFF2-40B4-BE49-F238E27FC236}">
                  <a16:creationId xmlns:a16="http://schemas.microsoft.com/office/drawing/2014/main" id="{7D5752A2-32B5-7943-81D5-AB51DD4136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0585" y="2931081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5" name="Rectangle 187">
              <a:extLst>
                <a:ext uri="{FF2B5EF4-FFF2-40B4-BE49-F238E27FC236}">
                  <a16:creationId xmlns:a16="http://schemas.microsoft.com/office/drawing/2014/main" id="{31C8FE34-B5C8-FAB7-1346-F4A227615D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7835" y="2931081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6" name="Rectangle 188">
              <a:extLst>
                <a:ext uri="{FF2B5EF4-FFF2-40B4-BE49-F238E27FC236}">
                  <a16:creationId xmlns:a16="http://schemas.microsoft.com/office/drawing/2014/main" id="{E89997C9-AB47-8685-0B7D-981BD1932F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52337" y="2931081"/>
              <a:ext cx="60709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7" name="Rectangle 189">
              <a:extLst>
                <a:ext uri="{FF2B5EF4-FFF2-40B4-BE49-F238E27FC236}">
                  <a16:creationId xmlns:a16="http://schemas.microsoft.com/office/drawing/2014/main" id="{648CD1A3-0658-D681-14DE-A21B9738A4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0966" y="2931081"/>
              <a:ext cx="60709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8" name="Rectangle 190">
              <a:extLst>
                <a:ext uri="{FF2B5EF4-FFF2-40B4-BE49-F238E27FC236}">
                  <a16:creationId xmlns:a16="http://schemas.microsoft.com/office/drawing/2014/main" id="{79ADA3A0-7448-827B-2815-55D15944FA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0585" y="3051671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9" name="Rectangle 191">
              <a:extLst>
                <a:ext uri="{FF2B5EF4-FFF2-40B4-BE49-F238E27FC236}">
                  <a16:creationId xmlns:a16="http://schemas.microsoft.com/office/drawing/2014/main" id="{0368FEF3-5E0D-FEFB-FDDF-26DD75A1FA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7835" y="3051671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0" name="Rectangle 192">
              <a:extLst>
                <a:ext uri="{FF2B5EF4-FFF2-40B4-BE49-F238E27FC236}">
                  <a16:creationId xmlns:a16="http://schemas.microsoft.com/office/drawing/2014/main" id="{0A4E1922-8BEB-1759-1252-D3DD227321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16464" y="3051671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1" name="Rectangle 193">
              <a:extLst>
                <a:ext uri="{FF2B5EF4-FFF2-40B4-BE49-F238E27FC236}">
                  <a16:creationId xmlns:a16="http://schemas.microsoft.com/office/drawing/2014/main" id="{7CD25A2C-7236-1DF0-36E4-14A8E3FCEF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45093" y="3051671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2" name="Rectangle 194">
              <a:extLst>
                <a:ext uri="{FF2B5EF4-FFF2-40B4-BE49-F238E27FC236}">
                  <a16:creationId xmlns:a16="http://schemas.microsoft.com/office/drawing/2014/main" id="{C267E61C-CD0A-CCF1-DE2A-3003472D2D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0585" y="3161602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3" name="Rectangle 195">
              <a:extLst>
                <a:ext uri="{FF2B5EF4-FFF2-40B4-BE49-F238E27FC236}">
                  <a16:creationId xmlns:a16="http://schemas.microsoft.com/office/drawing/2014/main" id="{B1CC81D5-7A33-F86F-6822-3A4586E434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7835" y="3161602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4" name="Rectangle 196">
              <a:extLst>
                <a:ext uri="{FF2B5EF4-FFF2-40B4-BE49-F238E27FC236}">
                  <a16:creationId xmlns:a16="http://schemas.microsoft.com/office/drawing/2014/main" id="{5A1B80E3-6D7E-CD8F-189C-68410A38B4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16464" y="3161602"/>
              <a:ext cx="122797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5" name="Rectangle 197">
              <a:extLst>
                <a:ext uri="{FF2B5EF4-FFF2-40B4-BE49-F238E27FC236}">
                  <a16:creationId xmlns:a16="http://schemas.microsoft.com/office/drawing/2014/main" id="{7571E8BA-2F26-CAB1-B8C4-236E30EC6A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80966" y="3161602"/>
              <a:ext cx="60709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6" name="Rectangle 202">
              <a:extLst>
                <a:ext uri="{FF2B5EF4-FFF2-40B4-BE49-F238E27FC236}">
                  <a16:creationId xmlns:a16="http://schemas.microsoft.com/office/drawing/2014/main" id="{A946AC4B-2C0A-16A9-4C09-4608B060C1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17813" y="2675662"/>
              <a:ext cx="732643" cy="1106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7" name="Rectangle 162">
              <a:extLst>
                <a:ext uri="{FF2B5EF4-FFF2-40B4-BE49-F238E27FC236}">
                  <a16:creationId xmlns:a16="http://schemas.microsoft.com/office/drawing/2014/main" id="{C16FDA82-5F97-9098-3941-049691672B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0472" y="2827864"/>
              <a:ext cx="387315" cy="110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8" name="Rectangle 163">
              <a:extLst>
                <a:ext uri="{FF2B5EF4-FFF2-40B4-BE49-F238E27FC236}">
                  <a16:creationId xmlns:a16="http://schemas.microsoft.com/office/drawing/2014/main" id="{5A638B39-AA12-4D6B-1A45-C501AA71F3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6771" y="2927517"/>
              <a:ext cx="339945" cy="110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9" name="Rectangle 164">
              <a:extLst>
                <a:ext uri="{FF2B5EF4-FFF2-40B4-BE49-F238E27FC236}">
                  <a16:creationId xmlns:a16="http://schemas.microsoft.com/office/drawing/2014/main" id="{E65F7C91-2087-DEAA-7B86-F68389FF88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6771" y="3024856"/>
              <a:ext cx="339945" cy="110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0" name="Rectangle 165">
              <a:extLst>
                <a:ext uri="{FF2B5EF4-FFF2-40B4-BE49-F238E27FC236}">
                  <a16:creationId xmlns:a16="http://schemas.microsoft.com/office/drawing/2014/main" id="{779C57AE-0D2F-7B40-D4D4-F5AC541E43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0428" y="3134796"/>
              <a:ext cx="292576" cy="110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1" name="Line 157">
              <a:extLst>
                <a:ext uri="{FF2B5EF4-FFF2-40B4-BE49-F238E27FC236}">
                  <a16:creationId xmlns:a16="http://schemas.microsoft.com/office/drawing/2014/main" id="{695AAB9D-D7EC-AAB1-2149-2F3D545C1A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52457" y="1615263"/>
              <a:ext cx="205582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2" name="Line 158">
              <a:extLst>
                <a:ext uri="{FF2B5EF4-FFF2-40B4-BE49-F238E27FC236}">
                  <a16:creationId xmlns:a16="http://schemas.microsoft.com/office/drawing/2014/main" id="{C891E435-6F35-EE84-7C81-C180698883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52457" y="1716603"/>
              <a:ext cx="205582" cy="0"/>
            </a:xfrm>
            <a:prstGeom prst="line">
              <a:avLst/>
            </a:prstGeom>
            <a:noFill/>
            <a:ln w="1905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3" name="Line 159">
              <a:extLst>
                <a:ext uri="{FF2B5EF4-FFF2-40B4-BE49-F238E27FC236}">
                  <a16:creationId xmlns:a16="http://schemas.microsoft.com/office/drawing/2014/main" id="{71D430A2-988C-2B5F-DF67-7ECE3397DA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52457" y="1816909"/>
              <a:ext cx="205582" cy="0"/>
            </a:xfrm>
            <a:prstGeom prst="line">
              <a:avLst/>
            </a:prstGeom>
            <a:noFill/>
            <a:ln w="19050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4" name="Line 160">
              <a:extLst>
                <a:ext uri="{FF2B5EF4-FFF2-40B4-BE49-F238E27FC236}">
                  <a16:creationId xmlns:a16="http://schemas.microsoft.com/office/drawing/2014/main" id="{E1930443-5791-BE01-A33E-10D991F3C3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752457" y="1918250"/>
              <a:ext cx="205582" cy="0"/>
            </a:xfrm>
            <a:prstGeom prst="line">
              <a:avLst/>
            </a:prstGeom>
            <a:noFill/>
            <a:ln w="19050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5" name="Rectangle 162">
              <a:extLst>
                <a:ext uri="{FF2B5EF4-FFF2-40B4-BE49-F238E27FC236}">
                  <a16:creationId xmlns:a16="http://schemas.microsoft.com/office/drawing/2014/main" id="{97EBFBBE-2A17-EF09-08D1-288D52CAAE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5004" y="1551150"/>
              <a:ext cx="387315" cy="110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6" name="Rectangle 163">
              <a:extLst>
                <a:ext uri="{FF2B5EF4-FFF2-40B4-BE49-F238E27FC236}">
                  <a16:creationId xmlns:a16="http://schemas.microsoft.com/office/drawing/2014/main" id="{213864E5-C044-0D30-AAF9-F68D74BAB1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1302" y="1650803"/>
              <a:ext cx="339945" cy="110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7" name="Rectangle 164">
              <a:extLst>
                <a:ext uri="{FF2B5EF4-FFF2-40B4-BE49-F238E27FC236}">
                  <a16:creationId xmlns:a16="http://schemas.microsoft.com/office/drawing/2014/main" id="{DD244C18-C818-15C2-9E82-B7490B74D8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01302" y="1748142"/>
              <a:ext cx="339945" cy="110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8" name="Rectangle 165">
              <a:extLst>
                <a:ext uri="{FF2B5EF4-FFF2-40B4-BE49-F238E27FC236}">
                  <a16:creationId xmlns:a16="http://schemas.microsoft.com/office/drawing/2014/main" id="{EED9AB31-5DB4-C3B4-FA83-15D5850A00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44960" y="1858082"/>
              <a:ext cx="292576" cy="1102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0" name="Line 5">
              <a:extLst>
                <a:ext uri="{FF2B5EF4-FFF2-40B4-BE49-F238E27FC236}">
                  <a16:creationId xmlns:a16="http://schemas.microsoft.com/office/drawing/2014/main" id="{64DB29D8-7CCF-6A32-09DD-615133530F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2111" y="2301131"/>
              <a:ext cx="342443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1" name="Line 6">
              <a:extLst>
                <a:ext uri="{FF2B5EF4-FFF2-40B4-BE49-F238E27FC236}">
                  <a16:creationId xmlns:a16="http://schemas.microsoft.com/office/drawing/2014/main" id="{4872C306-763C-166F-7F44-1902FE4AAED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2111" y="2301131"/>
              <a:ext cx="0" cy="5365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2" name="Line 7">
              <a:extLst>
                <a:ext uri="{FF2B5EF4-FFF2-40B4-BE49-F238E27FC236}">
                  <a16:creationId xmlns:a16="http://schemas.microsoft.com/office/drawing/2014/main" id="{151D8D91-C585-ECD1-A2BA-34A8804F57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2657" y="2301131"/>
              <a:ext cx="0" cy="5365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3" name="Line 8">
              <a:extLst>
                <a:ext uri="{FF2B5EF4-FFF2-40B4-BE49-F238E27FC236}">
                  <a16:creationId xmlns:a16="http://schemas.microsoft.com/office/drawing/2014/main" id="{A0D47444-63DF-77E6-16B3-45985618050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64599" y="2301131"/>
              <a:ext cx="0" cy="5365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4" name="Line 9">
              <a:extLst>
                <a:ext uri="{FF2B5EF4-FFF2-40B4-BE49-F238E27FC236}">
                  <a16:creationId xmlns:a16="http://schemas.microsoft.com/office/drawing/2014/main" id="{B5C5D1A7-D58F-F140-5F39-6C3BF6FE8F0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06542" y="2301131"/>
              <a:ext cx="0" cy="5365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5" name="Rectangle 10">
              <a:extLst>
                <a:ext uri="{FF2B5EF4-FFF2-40B4-BE49-F238E27FC236}">
                  <a16:creationId xmlns:a16="http://schemas.microsoft.com/office/drawing/2014/main" id="{D75D564B-0165-3852-9C6B-C91571F367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4874" y="2420013"/>
              <a:ext cx="6202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6" name="Rectangle 11">
              <a:extLst>
                <a:ext uri="{FF2B5EF4-FFF2-40B4-BE49-F238E27FC236}">
                  <a16:creationId xmlns:a16="http://schemas.microsoft.com/office/drawing/2014/main" id="{A8328F0B-47D5-8FFF-34A1-C8852284AD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7016" y="2420013"/>
              <a:ext cx="186074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7" name="Rectangle 12">
              <a:extLst>
                <a:ext uri="{FF2B5EF4-FFF2-40B4-BE49-F238E27FC236}">
                  <a16:creationId xmlns:a16="http://schemas.microsoft.com/office/drawing/2014/main" id="{EBB94AE2-5C61-9787-9889-8A9A7051D0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6850" y="2420013"/>
              <a:ext cx="24809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8" name="Rectangle 13">
              <a:extLst>
                <a:ext uri="{FF2B5EF4-FFF2-40B4-BE49-F238E27FC236}">
                  <a16:creationId xmlns:a16="http://schemas.microsoft.com/office/drawing/2014/main" id="{C8177D0E-25FF-C439-968E-A09D43DCB3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792" y="2420013"/>
              <a:ext cx="24809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9" name="Line 14">
              <a:extLst>
                <a:ext uri="{FF2B5EF4-FFF2-40B4-BE49-F238E27FC236}">
                  <a16:creationId xmlns:a16="http://schemas.microsoft.com/office/drawing/2014/main" id="{808E2EF1-1123-88DC-8D4D-6A55736F6D2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45302" y="163359"/>
              <a:ext cx="0" cy="205676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0" name="Line 15">
              <a:extLst>
                <a:ext uri="{FF2B5EF4-FFF2-40B4-BE49-F238E27FC236}">
                  <a16:creationId xmlns:a16="http://schemas.microsoft.com/office/drawing/2014/main" id="{D7E8DAF1-5F4E-E1C8-4FE1-07A22AFB83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72709" y="2220123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1" name="Line 16">
              <a:extLst>
                <a:ext uri="{FF2B5EF4-FFF2-40B4-BE49-F238E27FC236}">
                  <a16:creationId xmlns:a16="http://schemas.microsoft.com/office/drawing/2014/main" id="{512C3C83-445E-F60D-1748-E53A378276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72709" y="1808770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2" name="Line 17">
              <a:extLst>
                <a:ext uri="{FF2B5EF4-FFF2-40B4-BE49-F238E27FC236}">
                  <a16:creationId xmlns:a16="http://schemas.microsoft.com/office/drawing/2014/main" id="{F3998820-3034-8764-E526-D7D5E47733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72709" y="1397417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3" name="Line 18">
              <a:extLst>
                <a:ext uri="{FF2B5EF4-FFF2-40B4-BE49-F238E27FC236}">
                  <a16:creationId xmlns:a16="http://schemas.microsoft.com/office/drawing/2014/main" id="{3521BDBC-E333-638D-C4D5-1FFF3E4091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72709" y="986065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4" name="Line 19">
              <a:extLst>
                <a:ext uri="{FF2B5EF4-FFF2-40B4-BE49-F238E27FC236}">
                  <a16:creationId xmlns:a16="http://schemas.microsoft.com/office/drawing/2014/main" id="{EDD8548A-02CB-E26D-5FF4-DA825FADDC6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72709" y="574712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5" name="Line 20">
              <a:extLst>
                <a:ext uri="{FF2B5EF4-FFF2-40B4-BE49-F238E27FC236}">
                  <a16:creationId xmlns:a16="http://schemas.microsoft.com/office/drawing/2014/main" id="{43F41645-5309-9977-AF62-1A11BCB8BD8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72709" y="163359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6" name="Rectangle 21">
              <a:extLst>
                <a:ext uri="{FF2B5EF4-FFF2-40B4-BE49-F238E27FC236}">
                  <a16:creationId xmlns:a16="http://schemas.microsoft.com/office/drawing/2014/main" id="{51682FAB-AAF5-1840-4D20-C703624663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7038" y="2182249"/>
              <a:ext cx="6202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7" name="Rectangle 22">
              <a:extLst>
                <a:ext uri="{FF2B5EF4-FFF2-40B4-BE49-F238E27FC236}">
                  <a16:creationId xmlns:a16="http://schemas.microsoft.com/office/drawing/2014/main" id="{2BFB7911-3BA9-5423-BF1A-014335D4EB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4445" y="1776156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8" name="Rectangle 23">
              <a:extLst>
                <a:ext uri="{FF2B5EF4-FFF2-40B4-BE49-F238E27FC236}">
                  <a16:creationId xmlns:a16="http://schemas.microsoft.com/office/drawing/2014/main" id="{B79FE2E5-011A-79AE-4BCB-4F611DC4A1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4445" y="1364804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9" name="Rectangle 24">
              <a:extLst>
                <a:ext uri="{FF2B5EF4-FFF2-40B4-BE49-F238E27FC236}">
                  <a16:creationId xmlns:a16="http://schemas.microsoft.com/office/drawing/2014/main" id="{A6788BF3-4E8C-A364-FED3-BDFB767049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4445" y="953451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0" name="Rectangle 25">
              <a:extLst>
                <a:ext uri="{FF2B5EF4-FFF2-40B4-BE49-F238E27FC236}">
                  <a16:creationId xmlns:a16="http://schemas.microsoft.com/office/drawing/2014/main" id="{34D905B0-B458-9A12-DD8A-6C34A2C5DB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14445" y="542098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1" name="Rectangle 26">
              <a:extLst>
                <a:ext uri="{FF2B5EF4-FFF2-40B4-BE49-F238E27FC236}">
                  <a16:creationId xmlns:a16="http://schemas.microsoft.com/office/drawing/2014/main" id="{BB20D93D-9A7E-8C72-94F0-A4CDF47291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0228" y="130745"/>
              <a:ext cx="186074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2" name="Freeform 27">
              <a:extLst>
                <a:ext uri="{FF2B5EF4-FFF2-40B4-BE49-F238E27FC236}">
                  <a16:creationId xmlns:a16="http://schemas.microsoft.com/office/drawing/2014/main" id="{6220DA81-D74A-816A-95B6-77281DE47DA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5302" y="82351"/>
              <a:ext cx="3698051" cy="2218780"/>
            </a:xfrm>
            <a:custGeom>
              <a:avLst/>
              <a:gdLst>
                <a:gd name="T0" fmla="*/ 0 w 515"/>
                <a:gd name="T1" fmla="*/ 0 h 410"/>
                <a:gd name="T2" fmla="*/ 0 w 515"/>
                <a:gd name="T3" fmla="*/ 410 h 410"/>
                <a:gd name="T4" fmla="*/ 515 w 515"/>
                <a:gd name="T5" fmla="*/ 410 h 4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10">
                  <a:moveTo>
                    <a:pt x="0" y="0"/>
                  </a:moveTo>
                  <a:lnTo>
                    <a:pt x="0" y="410"/>
                  </a:lnTo>
                  <a:lnTo>
                    <a:pt x="515" y="410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3" name="Rectangle 28">
              <a:extLst>
                <a:ext uri="{FF2B5EF4-FFF2-40B4-BE49-F238E27FC236}">
                  <a16:creationId xmlns:a16="http://schemas.microsoft.com/office/drawing/2014/main" id="{11ADDAD2-A012-98E3-13E4-902AF81FE7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09580" y="2576769"/>
              <a:ext cx="1278553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ollow-up Duration (day)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4" name="Rectangle 29">
              <a:extLst>
                <a:ext uri="{FF2B5EF4-FFF2-40B4-BE49-F238E27FC236}">
                  <a16:creationId xmlns:a16="http://schemas.microsoft.com/office/drawing/2014/main" id="{42CE7010-A3BC-1C11-1279-0014FECCA8D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338067" y="1116786"/>
              <a:ext cx="894479" cy="1488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vent-free Survival (%)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5" name="Freeform 30">
              <a:extLst>
                <a:ext uri="{FF2B5EF4-FFF2-40B4-BE49-F238E27FC236}">
                  <a16:creationId xmlns:a16="http://schemas.microsoft.com/office/drawing/2014/main" id="{FEDD83FF-B2F5-2F82-17CD-C05C405380C5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111" y="163359"/>
              <a:ext cx="3424431" cy="1201445"/>
            </a:xfrm>
            <a:custGeom>
              <a:avLst/>
              <a:gdLst>
                <a:gd name="T0" fmla="*/ 0 w 477"/>
                <a:gd name="T1" fmla="*/ 0 h 222"/>
                <a:gd name="T2" fmla="*/ 1 w 477"/>
                <a:gd name="T3" fmla="*/ 0 h 222"/>
                <a:gd name="T4" fmla="*/ 1 w 477"/>
                <a:gd name="T5" fmla="*/ 10 h 222"/>
                <a:gd name="T6" fmla="*/ 2 w 477"/>
                <a:gd name="T7" fmla="*/ 10 h 222"/>
                <a:gd name="T8" fmla="*/ 2 w 477"/>
                <a:gd name="T9" fmla="*/ 19 h 222"/>
                <a:gd name="T10" fmla="*/ 4 w 477"/>
                <a:gd name="T11" fmla="*/ 19 h 222"/>
                <a:gd name="T12" fmla="*/ 4 w 477"/>
                <a:gd name="T13" fmla="*/ 29 h 222"/>
                <a:gd name="T14" fmla="*/ 13 w 477"/>
                <a:gd name="T15" fmla="*/ 29 h 222"/>
                <a:gd name="T16" fmla="*/ 13 w 477"/>
                <a:gd name="T17" fmla="*/ 38 h 222"/>
                <a:gd name="T18" fmla="*/ 14 w 477"/>
                <a:gd name="T19" fmla="*/ 38 h 222"/>
                <a:gd name="T20" fmla="*/ 14 w 477"/>
                <a:gd name="T21" fmla="*/ 48 h 222"/>
                <a:gd name="T22" fmla="*/ 15 w 477"/>
                <a:gd name="T23" fmla="*/ 48 h 222"/>
                <a:gd name="T24" fmla="*/ 15 w 477"/>
                <a:gd name="T25" fmla="*/ 57 h 222"/>
                <a:gd name="T26" fmla="*/ 16 w 477"/>
                <a:gd name="T27" fmla="*/ 57 h 222"/>
                <a:gd name="T28" fmla="*/ 16 w 477"/>
                <a:gd name="T29" fmla="*/ 67 h 222"/>
                <a:gd name="T30" fmla="*/ 25 w 477"/>
                <a:gd name="T31" fmla="*/ 67 h 222"/>
                <a:gd name="T32" fmla="*/ 25 w 477"/>
                <a:gd name="T33" fmla="*/ 76 h 222"/>
                <a:gd name="T34" fmla="*/ 28 w 477"/>
                <a:gd name="T35" fmla="*/ 76 h 222"/>
                <a:gd name="T36" fmla="*/ 28 w 477"/>
                <a:gd name="T37" fmla="*/ 86 h 222"/>
                <a:gd name="T38" fmla="*/ 39 w 477"/>
                <a:gd name="T39" fmla="*/ 86 h 222"/>
                <a:gd name="T40" fmla="*/ 39 w 477"/>
                <a:gd name="T41" fmla="*/ 96 h 222"/>
                <a:gd name="T42" fmla="*/ 74 w 477"/>
                <a:gd name="T43" fmla="*/ 96 h 222"/>
                <a:gd name="T44" fmla="*/ 74 w 477"/>
                <a:gd name="T45" fmla="*/ 105 h 222"/>
                <a:gd name="T46" fmla="*/ 79 w 477"/>
                <a:gd name="T47" fmla="*/ 105 h 222"/>
                <a:gd name="T48" fmla="*/ 79 w 477"/>
                <a:gd name="T49" fmla="*/ 115 h 222"/>
                <a:gd name="T50" fmla="*/ 80 w 477"/>
                <a:gd name="T51" fmla="*/ 115 h 222"/>
                <a:gd name="T52" fmla="*/ 80 w 477"/>
                <a:gd name="T53" fmla="*/ 125 h 222"/>
                <a:gd name="T54" fmla="*/ 92 w 477"/>
                <a:gd name="T55" fmla="*/ 125 h 222"/>
                <a:gd name="T56" fmla="*/ 92 w 477"/>
                <a:gd name="T57" fmla="*/ 135 h 222"/>
                <a:gd name="T58" fmla="*/ 98 w 477"/>
                <a:gd name="T59" fmla="*/ 135 h 222"/>
                <a:gd name="T60" fmla="*/ 98 w 477"/>
                <a:gd name="T61" fmla="*/ 145 h 222"/>
                <a:gd name="T62" fmla="*/ 225 w 477"/>
                <a:gd name="T63" fmla="*/ 145 h 222"/>
                <a:gd name="T64" fmla="*/ 225 w 477"/>
                <a:gd name="T65" fmla="*/ 156 h 222"/>
                <a:gd name="T66" fmla="*/ 230 w 477"/>
                <a:gd name="T67" fmla="*/ 156 h 222"/>
                <a:gd name="T68" fmla="*/ 230 w 477"/>
                <a:gd name="T69" fmla="*/ 167 h 222"/>
                <a:gd name="T70" fmla="*/ 276 w 477"/>
                <a:gd name="T71" fmla="*/ 167 h 222"/>
                <a:gd name="T72" fmla="*/ 276 w 477"/>
                <a:gd name="T73" fmla="*/ 177 h 222"/>
                <a:gd name="T74" fmla="*/ 289 w 477"/>
                <a:gd name="T75" fmla="*/ 177 h 222"/>
                <a:gd name="T76" fmla="*/ 289 w 477"/>
                <a:gd name="T77" fmla="*/ 188 h 222"/>
                <a:gd name="T78" fmla="*/ 332 w 477"/>
                <a:gd name="T79" fmla="*/ 188 h 222"/>
                <a:gd name="T80" fmla="*/ 332 w 477"/>
                <a:gd name="T81" fmla="*/ 199 h 222"/>
                <a:gd name="T82" fmla="*/ 379 w 477"/>
                <a:gd name="T83" fmla="*/ 199 h 222"/>
                <a:gd name="T84" fmla="*/ 379 w 477"/>
                <a:gd name="T85" fmla="*/ 211 h 222"/>
                <a:gd name="T86" fmla="*/ 409 w 477"/>
                <a:gd name="T87" fmla="*/ 211 h 222"/>
                <a:gd name="T88" fmla="*/ 409 w 477"/>
                <a:gd name="T89" fmla="*/ 222 h 222"/>
                <a:gd name="T90" fmla="*/ 477 w 477"/>
                <a:gd name="T91" fmla="*/ 222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477" h="222">
                  <a:moveTo>
                    <a:pt x="0" y="0"/>
                  </a:moveTo>
                  <a:lnTo>
                    <a:pt x="1" y="0"/>
                  </a:lnTo>
                  <a:lnTo>
                    <a:pt x="1" y="10"/>
                  </a:lnTo>
                  <a:lnTo>
                    <a:pt x="2" y="10"/>
                  </a:lnTo>
                  <a:lnTo>
                    <a:pt x="2" y="19"/>
                  </a:lnTo>
                  <a:lnTo>
                    <a:pt x="4" y="19"/>
                  </a:lnTo>
                  <a:lnTo>
                    <a:pt x="4" y="29"/>
                  </a:lnTo>
                  <a:lnTo>
                    <a:pt x="13" y="29"/>
                  </a:lnTo>
                  <a:lnTo>
                    <a:pt x="13" y="38"/>
                  </a:lnTo>
                  <a:lnTo>
                    <a:pt x="14" y="38"/>
                  </a:lnTo>
                  <a:lnTo>
                    <a:pt x="14" y="48"/>
                  </a:lnTo>
                  <a:lnTo>
                    <a:pt x="15" y="48"/>
                  </a:lnTo>
                  <a:lnTo>
                    <a:pt x="15" y="57"/>
                  </a:lnTo>
                  <a:lnTo>
                    <a:pt x="16" y="57"/>
                  </a:lnTo>
                  <a:lnTo>
                    <a:pt x="16" y="67"/>
                  </a:lnTo>
                  <a:lnTo>
                    <a:pt x="25" y="67"/>
                  </a:lnTo>
                  <a:lnTo>
                    <a:pt x="25" y="76"/>
                  </a:lnTo>
                  <a:lnTo>
                    <a:pt x="28" y="76"/>
                  </a:lnTo>
                  <a:lnTo>
                    <a:pt x="28" y="86"/>
                  </a:lnTo>
                  <a:lnTo>
                    <a:pt x="39" y="86"/>
                  </a:lnTo>
                  <a:lnTo>
                    <a:pt x="39" y="96"/>
                  </a:lnTo>
                  <a:lnTo>
                    <a:pt x="74" y="96"/>
                  </a:lnTo>
                  <a:lnTo>
                    <a:pt x="74" y="105"/>
                  </a:lnTo>
                  <a:lnTo>
                    <a:pt x="79" y="105"/>
                  </a:lnTo>
                  <a:lnTo>
                    <a:pt x="79" y="115"/>
                  </a:lnTo>
                  <a:lnTo>
                    <a:pt x="80" y="115"/>
                  </a:lnTo>
                  <a:lnTo>
                    <a:pt x="80" y="125"/>
                  </a:lnTo>
                  <a:lnTo>
                    <a:pt x="92" y="125"/>
                  </a:lnTo>
                  <a:lnTo>
                    <a:pt x="92" y="135"/>
                  </a:lnTo>
                  <a:lnTo>
                    <a:pt x="98" y="135"/>
                  </a:lnTo>
                  <a:lnTo>
                    <a:pt x="98" y="145"/>
                  </a:lnTo>
                  <a:lnTo>
                    <a:pt x="225" y="145"/>
                  </a:lnTo>
                  <a:lnTo>
                    <a:pt x="225" y="156"/>
                  </a:lnTo>
                  <a:lnTo>
                    <a:pt x="230" y="156"/>
                  </a:lnTo>
                  <a:lnTo>
                    <a:pt x="230" y="167"/>
                  </a:lnTo>
                  <a:lnTo>
                    <a:pt x="276" y="167"/>
                  </a:lnTo>
                  <a:lnTo>
                    <a:pt x="276" y="177"/>
                  </a:lnTo>
                  <a:lnTo>
                    <a:pt x="289" y="177"/>
                  </a:lnTo>
                  <a:lnTo>
                    <a:pt x="289" y="188"/>
                  </a:lnTo>
                  <a:lnTo>
                    <a:pt x="332" y="188"/>
                  </a:lnTo>
                  <a:lnTo>
                    <a:pt x="332" y="199"/>
                  </a:lnTo>
                  <a:lnTo>
                    <a:pt x="379" y="199"/>
                  </a:lnTo>
                  <a:lnTo>
                    <a:pt x="379" y="211"/>
                  </a:lnTo>
                  <a:lnTo>
                    <a:pt x="409" y="211"/>
                  </a:lnTo>
                  <a:lnTo>
                    <a:pt x="409" y="222"/>
                  </a:lnTo>
                  <a:lnTo>
                    <a:pt x="477" y="222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6" name="Line 31">
              <a:extLst>
                <a:ext uri="{FF2B5EF4-FFF2-40B4-BE49-F238E27FC236}">
                  <a16:creationId xmlns:a16="http://schemas.microsoft.com/office/drawing/2014/main" id="{3CE5C50F-E998-245F-06AD-50CB45FFB8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83138" y="629419"/>
              <a:ext cx="7119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7" name="Line 32">
              <a:extLst>
                <a:ext uri="{FF2B5EF4-FFF2-40B4-BE49-F238E27FC236}">
                  <a16:creationId xmlns:a16="http://schemas.microsoft.com/office/drawing/2014/main" id="{36D0BFCD-0657-EDC4-5F88-3CDCD8DC9DE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18038" y="602065"/>
              <a:ext cx="0" cy="5365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8" name="Line 33">
              <a:extLst>
                <a:ext uri="{FF2B5EF4-FFF2-40B4-BE49-F238E27FC236}">
                  <a16:creationId xmlns:a16="http://schemas.microsoft.com/office/drawing/2014/main" id="{B22A7551-86C5-092D-2FB6-C721988270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69834" y="839829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9" name="Line 34">
              <a:extLst>
                <a:ext uri="{FF2B5EF4-FFF2-40B4-BE49-F238E27FC236}">
                  <a16:creationId xmlns:a16="http://schemas.microsoft.com/office/drawing/2014/main" id="{5133A401-E40A-01D3-5381-D8343B5635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06131" y="813528"/>
              <a:ext cx="0" cy="5365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0" name="Line 35">
              <a:extLst>
                <a:ext uri="{FF2B5EF4-FFF2-40B4-BE49-F238E27FC236}">
                  <a16:creationId xmlns:a16="http://schemas.microsoft.com/office/drawing/2014/main" id="{D14DE5EA-F1AA-4D10-167D-0CE26B5134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7500" y="948191"/>
              <a:ext cx="7119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1" name="Line 36">
              <a:extLst>
                <a:ext uri="{FF2B5EF4-FFF2-40B4-BE49-F238E27FC236}">
                  <a16:creationId xmlns:a16="http://schemas.microsoft.com/office/drawing/2014/main" id="{B31E25AE-DE62-D64A-6346-9E0466F8F6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472400" y="920838"/>
              <a:ext cx="0" cy="5996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2" name="Line 37">
              <a:extLst>
                <a:ext uri="{FF2B5EF4-FFF2-40B4-BE49-F238E27FC236}">
                  <a16:creationId xmlns:a16="http://schemas.microsoft.com/office/drawing/2014/main" id="{B5F49C4B-62AE-39E5-551D-BABBE74A79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07363" y="1180694"/>
              <a:ext cx="71197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3" name="Line 38">
              <a:extLst>
                <a:ext uri="{FF2B5EF4-FFF2-40B4-BE49-F238E27FC236}">
                  <a16:creationId xmlns:a16="http://schemas.microsoft.com/office/drawing/2014/main" id="{3BC60C21-C9B5-397A-C4AD-FBE0153ACB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43660" y="1154393"/>
              <a:ext cx="0" cy="5365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4" name="Line 39">
              <a:extLst>
                <a:ext uri="{FF2B5EF4-FFF2-40B4-BE49-F238E27FC236}">
                  <a16:creationId xmlns:a16="http://schemas.microsoft.com/office/drawing/2014/main" id="{40E818D5-59D6-1B39-BFE9-60B011BEDF6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8705" y="1364804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5" name="Line 40">
              <a:extLst>
                <a:ext uri="{FF2B5EF4-FFF2-40B4-BE49-F238E27FC236}">
                  <a16:creationId xmlns:a16="http://schemas.microsoft.com/office/drawing/2014/main" id="{9A6E8648-AE5B-97B6-1619-6999FD57FD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05002" y="1337451"/>
              <a:ext cx="0" cy="5470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6" name="Line 41">
              <a:extLst>
                <a:ext uri="{FF2B5EF4-FFF2-40B4-BE49-F238E27FC236}">
                  <a16:creationId xmlns:a16="http://schemas.microsoft.com/office/drawing/2014/main" id="{AE37401E-E5F7-CB6D-6C8A-8AA875A184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70245" y="1364804"/>
              <a:ext cx="7259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7" name="Line 42">
              <a:extLst>
                <a:ext uri="{FF2B5EF4-FFF2-40B4-BE49-F238E27FC236}">
                  <a16:creationId xmlns:a16="http://schemas.microsoft.com/office/drawing/2014/main" id="{42EBED50-9938-C899-F7B1-0FC0F706D8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06542" y="1337451"/>
              <a:ext cx="0" cy="5470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8" name="Freeform 43">
              <a:extLst>
                <a:ext uri="{FF2B5EF4-FFF2-40B4-BE49-F238E27FC236}">
                  <a16:creationId xmlns:a16="http://schemas.microsoft.com/office/drawing/2014/main" id="{6EBEAF78-971C-0359-07FB-A28CE91F62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111" y="163359"/>
              <a:ext cx="3424431" cy="1428688"/>
            </a:xfrm>
            <a:custGeom>
              <a:avLst/>
              <a:gdLst>
                <a:gd name="T0" fmla="*/ 0 w 477"/>
                <a:gd name="T1" fmla="*/ 0 h 264"/>
                <a:gd name="T2" fmla="*/ 1 w 477"/>
                <a:gd name="T3" fmla="*/ 0 h 264"/>
                <a:gd name="T4" fmla="*/ 1 w 477"/>
                <a:gd name="T5" fmla="*/ 12 h 264"/>
                <a:gd name="T6" fmla="*/ 2 w 477"/>
                <a:gd name="T7" fmla="*/ 12 h 264"/>
                <a:gd name="T8" fmla="*/ 2 w 477"/>
                <a:gd name="T9" fmla="*/ 23 h 264"/>
                <a:gd name="T10" fmla="*/ 2 w 477"/>
                <a:gd name="T11" fmla="*/ 23 h 264"/>
                <a:gd name="T12" fmla="*/ 2 w 477"/>
                <a:gd name="T13" fmla="*/ 34 h 264"/>
                <a:gd name="T14" fmla="*/ 3 w 477"/>
                <a:gd name="T15" fmla="*/ 34 h 264"/>
                <a:gd name="T16" fmla="*/ 3 w 477"/>
                <a:gd name="T17" fmla="*/ 45 h 264"/>
                <a:gd name="T18" fmla="*/ 3 w 477"/>
                <a:gd name="T19" fmla="*/ 45 h 264"/>
                <a:gd name="T20" fmla="*/ 3 w 477"/>
                <a:gd name="T21" fmla="*/ 56 h 264"/>
                <a:gd name="T22" fmla="*/ 4 w 477"/>
                <a:gd name="T23" fmla="*/ 56 h 264"/>
                <a:gd name="T24" fmla="*/ 4 w 477"/>
                <a:gd name="T25" fmla="*/ 67 h 264"/>
                <a:gd name="T26" fmla="*/ 6 w 477"/>
                <a:gd name="T27" fmla="*/ 67 h 264"/>
                <a:gd name="T28" fmla="*/ 6 w 477"/>
                <a:gd name="T29" fmla="*/ 79 h 264"/>
                <a:gd name="T30" fmla="*/ 11 w 477"/>
                <a:gd name="T31" fmla="*/ 79 h 264"/>
                <a:gd name="T32" fmla="*/ 11 w 477"/>
                <a:gd name="T33" fmla="*/ 90 h 264"/>
                <a:gd name="T34" fmla="*/ 11 w 477"/>
                <a:gd name="T35" fmla="*/ 90 h 264"/>
                <a:gd name="T36" fmla="*/ 11 w 477"/>
                <a:gd name="T37" fmla="*/ 101 h 264"/>
                <a:gd name="T38" fmla="*/ 16 w 477"/>
                <a:gd name="T39" fmla="*/ 101 h 264"/>
                <a:gd name="T40" fmla="*/ 16 w 477"/>
                <a:gd name="T41" fmla="*/ 113 h 264"/>
                <a:gd name="T42" fmla="*/ 21 w 477"/>
                <a:gd name="T43" fmla="*/ 113 h 264"/>
                <a:gd name="T44" fmla="*/ 21 w 477"/>
                <a:gd name="T45" fmla="*/ 124 h 264"/>
                <a:gd name="T46" fmla="*/ 49 w 477"/>
                <a:gd name="T47" fmla="*/ 124 h 264"/>
                <a:gd name="T48" fmla="*/ 49 w 477"/>
                <a:gd name="T49" fmla="*/ 136 h 264"/>
                <a:gd name="T50" fmla="*/ 59 w 477"/>
                <a:gd name="T51" fmla="*/ 136 h 264"/>
                <a:gd name="T52" fmla="*/ 59 w 477"/>
                <a:gd name="T53" fmla="*/ 149 h 264"/>
                <a:gd name="T54" fmla="*/ 64 w 477"/>
                <a:gd name="T55" fmla="*/ 149 h 264"/>
                <a:gd name="T56" fmla="*/ 64 w 477"/>
                <a:gd name="T57" fmla="*/ 161 h 264"/>
                <a:gd name="T58" fmla="*/ 95 w 477"/>
                <a:gd name="T59" fmla="*/ 161 h 264"/>
                <a:gd name="T60" fmla="*/ 95 w 477"/>
                <a:gd name="T61" fmla="*/ 174 h 264"/>
                <a:gd name="T62" fmla="*/ 141 w 477"/>
                <a:gd name="T63" fmla="*/ 174 h 264"/>
                <a:gd name="T64" fmla="*/ 141 w 477"/>
                <a:gd name="T65" fmla="*/ 186 h 264"/>
                <a:gd name="T66" fmla="*/ 173 w 477"/>
                <a:gd name="T67" fmla="*/ 186 h 264"/>
                <a:gd name="T68" fmla="*/ 173 w 477"/>
                <a:gd name="T69" fmla="*/ 200 h 264"/>
                <a:gd name="T70" fmla="*/ 193 w 477"/>
                <a:gd name="T71" fmla="*/ 200 h 264"/>
                <a:gd name="T72" fmla="*/ 193 w 477"/>
                <a:gd name="T73" fmla="*/ 214 h 264"/>
                <a:gd name="T74" fmla="*/ 231 w 477"/>
                <a:gd name="T75" fmla="*/ 214 h 264"/>
                <a:gd name="T76" fmla="*/ 231 w 477"/>
                <a:gd name="T77" fmla="*/ 228 h 264"/>
                <a:gd name="T78" fmla="*/ 274 w 477"/>
                <a:gd name="T79" fmla="*/ 228 h 264"/>
                <a:gd name="T80" fmla="*/ 274 w 477"/>
                <a:gd name="T81" fmla="*/ 245 h 264"/>
                <a:gd name="T82" fmla="*/ 409 w 477"/>
                <a:gd name="T83" fmla="*/ 245 h 264"/>
                <a:gd name="T84" fmla="*/ 409 w 477"/>
                <a:gd name="T85" fmla="*/ 264 h 264"/>
                <a:gd name="T86" fmla="*/ 477 w 477"/>
                <a:gd name="T87" fmla="*/ 264 h 2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477" h="264">
                  <a:moveTo>
                    <a:pt x="0" y="0"/>
                  </a:moveTo>
                  <a:lnTo>
                    <a:pt x="1" y="0"/>
                  </a:lnTo>
                  <a:lnTo>
                    <a:pt x="1" y="12"/>
                  </a:lnTo>
                  <a:lnTo>
                    <a:pt x="2" y="12"/>
                  </a:lnTo>
                  <a:lnTo>
                    <a:pt x="2" y="23"/>
                  </a:lnTo>
                  <a:lnTo>
                    <a:pt x="2" y="23"/>
                  </a:lnTo>
                  <a:lnTo>
                    <a:pt x="2" y="34"/>
                  </a:lnTo>
                  <a:lnTo>
                    <a:pt x="3" y="34"/>
                  </a:lnTo>
                  <a:lnTo>
                    <a:pt x="3" y="45"/>
                  </a:lnTo>
                  <a:lnTo>
                    <a:pt x="3" y="45"/>
                  </a:lnTo>
                  <a:lnTo>
                    <a:pt x="3" y="56"/>
                  </a:lnTo>
                  <a:lnTo>
                    <a:pt x="4" y="56"/>
                  </a:lnTo>
                  <a:lnTo>
                    <a:pt x="4" y="67"/>
                  </a:lnTo>
                  <a:lnTo>
                    <a:pt x="6" y="67"/>
                  </a:lnTo>
                  <a:lnTo>
                    <a:pt x="6" y="79"/>
                  </a:lnTo>
                  <a:lnTo>
                    <a:pt x="11" y="79"/>
                  </a:lnTo>
                  <a:lnTo>
                    <a:pt x="11" y="90"/>
                  </a:lnTo>
                  <a:lnTo>
                    <a:pt x="11" y="90"/>
                  </a:lnTo>
                  <a:lnTo>
                    <a:pt x="11" y="101"/>
                  </a:lnTo>
                  <a:lnTo>
                    <a:pt x="16" y="101"/>
                  </a:lnTo>
                  <a:lnTo>
                    <a:pt x="16" y="113"/>
                  </a:lnTo>
                  <a:lnTo>
                    <a:pt x="21" y="113"/>
                  </a:lnTo>
                  <a:lnTo>
                    <a:pt x="21" y="124"/>
                  </a:lnTo>
                  <a:lnTo>
                    <a:pt x="49" y="124"/>
                  </a:lnTo>
                  <a:lnTo>
                    <a:pt x="49" y="136"/>
                  </a:lnTo>
                  <a:lnTo>
                    <a:pt x="59" y="136"/>
                  </a:lnTo>
                  <a:lnTo>
                    <a:pt x="59" y="149"/>
                  </a:lnTo>
                  <a:lnTo>
                    <a:pt x="64" y="149"/>
                  </a:lnTo>
                  <a:lnTo>
                    <a:pt x="64" y="161"/>
                  </a:lnTo>
                  <a:lnTo>
                    <a:pt x="95" y="161"/>
                  </a:lnTo>
                  <a:lnTo>
                    <a:pt x="95" y="174"/>
                  </a:lnTo>
                  <a:lnTo>
                    <a:pt x="141" y="174"/>
                  </a:lnTo>
                  <a:lnTo>
                    <a:pt x="141" y="186"/>
                  </a:lnTo>
                  <a:lnTo>
                    <a:pt x="173" y="186"/>
                  </a:lnTo>
                  <a:lnTo>
                    <a:pt x="173" y="200"/>
                  </a:lnTo>
                  <a:lnTo>
                    <a:pt x="193" y="200"/>
                  </a:lnTo>
                  <a:lnTo>
                    <a:pt x="193" y="214"/>
                  </a:lnTo>
                  <a:lnTo>
                    <a:pt x="231" y="214"/>
                  </a:lnTo>
                  <a:lnTo>
                    <a:pt x="231" y="228"/>
                  </a:lnTo>
                  <a:lnTo>
                    <a:pt x="274" y="228"/>
                  </a:lnTo>
                  <a:lnTo>
                    <a:pt x="274" y="245"/>
                  </a:lnTo>
                  <a:lnTo>
                    <a:pt x="409" y="245"/>
                  </a:lnTo>
                  <a:lnTo>
                    <a:pt x="409" y="264"/>
                  </a:lnTo>
                  <a:lnTo>
                    <a:pt x="477" y="264"/>
                  </a:lnTo>
                </a:path>
              </a:pathLst>
            </a:custGeom>
            <a:noFill/>
            <a:ln w="1905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9" name="Line 44">
              <a:extLst>
                <a:ext uri="{FF2B5EF4-FFF2-40B4-BE49-F238E27FC236}">
                  <a16:creationId xmlns:a16="http://schemas.microsoft.com/office/drawing/2014/main" id="{BAFAFE46-C724-C8AE-8CF6-5420BA6A5B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53308" y="710427"/>
              <a:ext cx="7119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0" name="Line 45">
              <a:extLst>
                <a:ext uri="{FF2B5EF4-FFF2-40B4-BE49-F238E27FC236}">
                  <a16:creationId xmlns:a16="http://schemas.microsoft.com/office/drawing/2014/main" id="{59E3EBF7-6355-7E03-7E91-8FDF028AE2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89604" y="683074"/>
              <a:ext cx="0" cy="5470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1" name="Line 46">
              <a:extLst>
                <a:ext uri="{FF2B5EF4-FFF2-40B4-BE49-F238E27FC236}">
                  <a16:creationId xmlns:a16="http://schemas.microsoft.com/office/drawing/2014/main" id="{CD194488-9983-A005-5247-1EC51D53F0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0802" y="834569"/>
              <a:ext cx="72593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2" name="Line 47">
              <a:extLst>
                <a:ext uri="{FF2B5EF4-FFF2-40B4-BE49-F238E27FC236}">
                  <a16:creationId xmlns:a16="http://schemas.microsoft.com/office/drawing/2014/main" id="{5AA44737-B72B-AD25-4FA8-824EB0FD2E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97098" y="807216"/>
              <a:ext cx="0" cy="5470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3" name="Line 48">
              <a:extLst>
                <a:ext uri="{FF2B5EF4-FFF2-40B4-BE49-F238E27FC236}">
                  <a16:creationId xmlns:a16="http://schemas.microsoft.com/office/drawing/2014/main" id="{5A5A83C8-1FE9-C21B-D5A2-5FE5756387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41401" y="1034459"/>
              <a:ext cx="7817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4" name="Line 49">
              <a:extLst>
                <a:ext uri="{FF2B5EF4-FFF2-40B4-BE49-F238E27FC236}">
                  <a16:creationId xmlns:a16="http://schemas.microsoft.com/office/drawing/2014/main" id="{07D29F5B-258F-3F3A-3DC7-4EDCC67BA2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76301" y="1008158"/>
              <a:ext cx="0" cy="53655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5" name="Line 50">
              <a:extLst>
                <a:ext uri="{FF2B5EF4-FFF2-40B4-BE49-F238E27FC236}">
                  <a16:creationId xmlns:a16="http://schemas.microsoft.com/office/drawing/2014/main" id="{06007DD8-69A3-A725-8299-5E9F2CF2CBC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5421" y="1170174"/>
              <a:ext cx="72593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6" name="Line 51">
              <a:extLst>
                <a:ext uri="{FF2B5EF4-FFF2-40B4-BE49-F238E27FC236}">
                  <a16:creationId xmlns:a16="http://schemas.microsoft.com/office/drawing/2014/main" id="{85BF6619-63D0-DFC6-D70C-9739814872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1717" y="1142820"/>
              <a:ext cx="0" cy="5996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7" name="Line 52">
              <a:extLst>
                <a:ext uri="{FF2B5EF4-FFF2-40B4-BE49-F238E27FC236}">
                  <a16:creationId xmlns:a16="http://schemas.microsoft.com/office/drawing/2014/main" id="{74C8F21C-1193-98D4-B5AC-A17403E408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62033" y="1397417"/>
              <a:ext cx="7119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8" name="Line 53">
              <a:extLst>
                <a:ext uri="{FF2B5EF4-FFF2-40B4-BE49-F238E27FC236}">
                  <a16:creationId xmlns:a16="http://schemas.microsoft.com/office/drawing/2014/main" id="{4C0EEB17-56D0-310A-F2CE-E59D966026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98330" y="1370064"/>
              <a:ext cx="0" cy="5470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9" name="Line 54">
              <a:extLst>
                <a:ext uri="{FF2B5EF4-FFF2-40B4-BE49-F238E27FC236}">
                  <a16:creationId xmlns:a16="http://schemas.microsoft.com/office/drawing/2014/main" id="{B73FA240-D8C5-B662-BA64-0AF7AE45A7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1863" y="1397417"/>
              <a:ext cx="7119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0" name="Line 55">
              <a:extLst>
                <a:ext uri="{FF2B5EF4-FFF2-40B4-BE49-F238E27FC236}">
                  <a16:creationId xmlns:a16="http://schemas.microsoft.com/office/drawing/2014/main" id="{9A9E0668-5BE9-FD56-4A94-C550CA2DE6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26763" y="1370064"/>
              <a:ext cx="0" cy="5470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1" name="Line 56">
              <a:extLst>
                <a:ext uri="{FF2B5EF4-FFF2-40B4-BE49-F238E27FC236}">
                  <a16:creationId xmlns:a16="http://schemas.microsoft.com/office/drawing/2014/main" id="{61C83C5E-40FA-F42B-765D-5B0CDFE40A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1323" y="1488946"/>
              <a:ext cx="72593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2" name="Line 57">
              <a:extLst>
                <a:ext uri="{FF2B5EF4-FFF2-40B4-BE49-F238E27FC236}">
                  <a16:creationId xmlns:a16="http://schemas.microsoft.com/office/drawing/2014/main" id="{9E31E9E0-12B5-BDEC-23D6-356B5D0CCD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57620" y="1462645"/>
              <a:ext cx="0" cy="53655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3" name="Line 58">
              <a:extLst>
                <a:ext uri="{FF2B5EF4-FFF2-40B4-BE49-F238E27FC236}">
                  <a16:creationId xmlns:a16="http://schemas.microsoft.com/office/drawing/2014/main" id="{C1E40863-C77D-44D1-5519-36BEC022AB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55259" y="1592047"/>
              <a:ext cx="78177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4" name="Line 59">
              <a:extLst>
                <a:ext uri="{FF2B5EF4-FFF2-40B4-BE49-F238E27FC236}">
                  <a16:creationId xmlns:a16="http://schemas.microsoft.com/office/drawing/2014/main" id="{E0E53149-880E-142D-F43F-95EEB9490C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91555" y="1564694"/>
              <a:ext cx="0" cy="5470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5" name="Line 60">
              <a:extLst>
                <a:ext uri="{FF2B5EF4-FFF2-40B4-BE49-F238E27FC236}">
                  <a16:creationId xmlns:a16="http://schemas.microsoft.com/office/drawing/2014/main" id="{C57938D1-5772-974E-8D8E-51430F2677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70245" y="1592047"/>
              <a:ext cx="72593" cy="0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6" name="Line 61">
              <a:extLst>
                <a:ext uri="{FF2B5EF4-FFF2-40B4-BE49-F238E27FC236}">
                  <a16:creationId xmlns:a16="http://schemas.microsoft.com/office/drawing/2014/main" id="{B7915737-DFE2-6714-24BC-9D6A9499EF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06542" y="1564694"/>
              <a:ext cx="0" cy="54707"/>
            </a:xfrm>
            <a:prstGeom prst="line">
              <a:avLst/>
            </a:prstGeom>
            <a:noFill/>
            <a:ln w="7938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7" name="Freeform 62">
              <a:extLst>
                <a:ext uri="{FF2B5EF4-FFF2-40B4-BE49-F238E27FC236}">
                  <a16:creationId xmlns:a16="http://schemas.microsoft.com/office/drawing/2014/main" id="{95E9200C-E7D9-3A89-2288-53510639384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111" y="163359"/>
              <a:ext cx="3424431" cy="833226"/>
            </a:xfrm>
            <a:custGeom>
              <a:avLst/>
              <a:gdLst>
                <a:gd name="T0" fmla="*/ 0 w 477"/>
                <a:gd name="T1" fmla="*/ 0 h 154"/>
                <a:gd name="T2" fmla="*/ 2 w 477"/>
                <a:gd name="T3" fmla="*/ 0 h 154"/>
                <a:gd name="T4" fmla="*/ 2 w 477"/>
                <a:gd name="T5" fmla="*/ 11 h 154"/>
                <a:gd name="T6" fmla="*/ 3 w 477"/>
                <a:gd name="T7" fmla="*/ 11 h 154"/>
                <a:gd name="T8" fmla="*/ 3 w 477"/>
                <a:gd name="T9" fmla="*/ 21 h 154"/>
                <a:gd name="T10" fmla="*/ 9 w 477"/>
                <a:gd name="T11" fmla="*/ 21 h 154"/>
                <a:gd name="T12" fmla="*/ 9 w 477"/>
                <a:gd name="T13" fmla="*/ 32 h 154"/>
                <a:gd name="T14" fmla="*/ 33 w 477"/>
                <a:gd name="T15" fmla="*/ 32 h 154"/>
                <a:gd name="T16" fmla="*/ 33 w 477"/>
                <a:gd name="T17" fmla="*/ 43 h 154"/>
                <a:gd name="T18" fmla="*/ 52 w 477"/>
                <a:gd name="T19" fmla="*/ 43 h 154"/>
                <a:gd name="T20" fmla="*/ 52 w 477"/>
                <a:gd name="T21" fmla="*/ 55 h 154"/>
                <a:gd name="T22" fmla="*/ 65 w 477"/>
                <a:gd name="T23" fmla="*/ 55 h 154"/>
                <a:gd name="T24" fmla="*/ 65 w 477"/>
                <a:gd name="T25" fmla="*/ 67 h 154"/>
                <a:gd name="T26" fmla="*/ 72 w 477"/>
                <a:gd name="T27" fmla="*/ 67 h 154"/>
                <a:gd name="T28" fmla="*/ 72 w 477"/>
                <a:gd name="T29" fmla="*/ 80 h 154"/>
                <a:gd name="T30" fmla="*/ 130 w 477"/>
                <a:gd name="T31" fmla="*/ 80 h 154"/>
                <a:gd name="T32" fmla="*/ 130 w 477"/>
                <a:gd name="T33" fmla="*/ 94 h 154"/>
                <a:gd name="T34" fmla="*/ 273 w 477"/>
                <a:gd name="T35" fmla="*/ 94 h 154"/>
                <a:gd name="T36" fmla="*/ 273 w 477"/>
                <a:gd name="T37" fmla="*/ 110 h 154"/>
                <a:gd name="T38" fmla="*/ 284 w 477"/>
                <a:gd name="T39" fmla="*/ 110 h 154"/>
                <a:gd name="T40" fmla="*/ 284 w 477"/>
                <a:gd name="T41" fmla="*/ 126 h 154"/>
                <a:gd name="T42" fmla="*/ 477 w 477"/>
                <a:gd name="T43" fmla="*/ 126 h 154"/>
                <a:gd name="T44" fmla="*/ 477 w 477"/>
                <a:gd name="T45" fmla="*/ 154 h 154"/>
                <a:gd name="T46" fmla="*/ 477 w 477"/>
                <a:gd name="T47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</a:cxnLst>
              <a:rect l="0" t="0" r="r" b="b"/>
              <a:pathLst>
                <a:path w="477" h="154">
                  <a:moveTo>
                    <a:pt x="0" y="0"/>
                  </a:moveTo>
                  <a:lnTo>
                    <a:pt x="2" y="0"/>
                  </a:lnTo>
                  <a:lnTo>
                    <a:pt x="2" y="11"/>
                  </a:lnTo>
                  <a:lnTo>
                    <a:pt x="3" y="11"/>
                  </a:lnTo>
                  <a:lnTo>
                    <a:pt x="3" y="21"/>
                  </a:lnTo>
                  <a:lnTo>
                    <a:pt x="9" y="21"/>
                  </a:lnTo>
                  <a:lnTo>
                    <a:pt x="9" y="32"/>
                  </a:lnTo>
                  <a:lnTo>
                    <a:pt x="33" y="32"/>
                  </a:lnTo>
                  <a:lnTo>
                    <a:pt x="33" y="43"/>
                  </a:lnTo>
                  <a:lnTo>
                    <a:pt x="52" y="43"/>
                  </a:lnTo>
                  <a:lnTo>
                    <a:pt x="52" y="55"/>
                  </a:lnTo>
                  <a:lnTo>
                    <a:pt x="65" y="55"/>
                  </a:lnTo>
                  <a:lnTo>
                    <a:pt x="65" y="67"/>
                  </a:lnTo>
                  <a:lnTo>
                    <a:pt x="72" y="67"/>
                  </a:lnTo>
                  <a:lnTo>
                    <a:pt x="72" y="80"/>
                  </a:lnTo>
                  <a:lnTo>
                    <a:pt x="130" y="80"/>
                  </a:lnTo>
                  <a:lnTo>
                    <a:pt x="130" y="94"/>
                  </a:lnTo>
                  <a:lnTo>
                    <a:pt x="273" y="94"/>
                  </a:lnTo>
                  <a:lnTo>
                    <a:pt x="273" y="110"/>
                  </a:lnTo>
                  <a:lnTo>
                    <a:pt x="284" y="110"/>
                  </a:lnTo>
                  <a:lnTo>
                    <a:pt x="284" y="126"/>
                  </a:lnTo>
                  <a:lnTo>
                    <a:pt x="477" y="126"/>
                  </a:lnTo>
                  <a:lnTo>
                    <a:pt x="477" y="154"/>
                  </a:lnTo>
                  <a:lnTo>
                    <a:pt x="477" y="154"/>
                  </a:lnTo>
                </a:path>
              </a:pathLst>
            </a:custGeom>
            <a:noFill/>
            <a:ln w="19050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8" name="Line 63">
              <a:extLst>
                <a:ext uri="{FF2B5EF4-FFF2-40B4-BE49-F238E27FC236}">
                  <a16:creationId xmlns:a16="http://schemas.microsoft.com/office/drawing/2014/main" id="{433414FD-3D7E-B193-C6DA-B4468ACEFF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2111" y="276981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9" name="Line 64">
              <a:extLst>
                <a:ext uri="{FF2B5EF4-FFF2-40B4-BE49-F238E27FC236}">
                  <a16:creationId xmlns:a16="http://schemas.microsoft.com/office/drawing/2014/main" id="{9128EE5D-6268-5EBE-4E34-407B37AC3E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7011" y="250679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0" name="Line 65">
              <a:extLst>
                <a:ext uri="{FF2B5EF4-FFF2-40B4-BE49-F238E27FC236}">
                  <a16:creationId xmlns:a16="http://schemas.microsoft.com/office/drawing/2014/main" id="{6421A8F7-2166-87E1-BD71-0E8072D919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9091" y="276981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1" name="Line 66">
              <a:extLst>
                <a:ext uri="{FF2B5EF4-FFF2-40B4-BE49-F238E27FC236}">
                  <a16:creationId xmlns:a16="http://schemas.microsoft.com/office/drawing/2014/main" id="{66ABF27D-C029-64B3-6891-2C10C80CFC8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3992" y="250679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2" name="Line 67">
              <a:extLst>
                <a:ext uri="{FF2B5EF4-FFF2-40B4-BE49-F238E27FC236}">
                  <a16:creationId xmlns:a16="http://schemas.microsoft.com/office/drawing/2014/main" id="{05B5F819-AB96-BA44-8739-F11DCAD6CC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3051" y="276981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3" name="Line 68">
              <a:extLst>
                <a:ext uri="{FF2B5EF4-FFF2-40B4-BE49-F238E27FC236}">
                  <a16:creationId xmlns:a16="http://schemas.microsoft.com/office/drawing/2014/main" id="{50035CA4-0330-9F48-EBE4-F5A51E0DA7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39348" y="250679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4" name="Line 69">
              <a:extLst>
                <a:ext uri="{FF2B5EF4-FFF2-40B4-BE49-F238E27FC236}">
                  <a16:creationId xmlns:a16="http://schemas.microsoft.com/office/drawing/2014/main" id="{CD2F6E97-338E-32B2-4E25-B6D1968E04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11571" y="396915"/>
              <a:ext cx="72593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5" name="Line 70">
              <a:extLst>
                <a:ext uri="{FF2B5EF4-FFF2-40B4-BE49-F238E27FC236}">
                  <a16:creationId xmlns:a16="http://schemas.microsoft.com/office/drawing/2014/main" id="{E40B9B75-B71C-6986-C4E6-912DF5FDD4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47868" y="369562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6" name="Line 71">
              <a:extLst>
                <a:ext uri="{FF2B5EF4-FFF2-40B4-BE49-F238E27FC236}">
                  <a16:creationId xmlns:a16="http://schemas.microsoft.com/office/drawing/2014/main" id="{20AE91E1-D274-7341-190A-172B3D5568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8124" y="461090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7" name="Line 72">
              <a:extLst>
                <a:ext uri="{FF2B5EF4-FFF2-40B4-BE49-F238E27FC236}">
                  <a16:creationId xmlns:a16="http://schemas.microsoft.com/office/drawing/2014/main" id="{6834C3E3-77E9-6775-177F-00E05AF5AF3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4421" y="434789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8" name="Line 73">
              <a:extLst>
                <a:ext uri="{FF2B5EF4-FFF2-40B4-BE49-F238E27FC236}">
                  <a16:creationId xmlns:a16="http://schemas.microsoft.com/office/drawing/2014/main" id="{C8BB3531-229B-AFCC-1628-0EEE057C0D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4421" y="526317"/>
              <a:ext cx="7817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9" name="Line 74">
              <a:extLst>
                <a:ext uri="{FF2B5EF4-FFF2-40B4-BE49-F238E27FC236}">
                  <a16:creationId xmlns:a16="http://schemas.microsoft.com/office/drawing/2014/main" id="{91EA781F-80E4-F57C-0C20-96972B8F1C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69321" y="498964"/>
              <a:ext cx="0" cy="54707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0" name="Line 75">
              <a:extLst>
                <a:ext uri="{FF2B5EF4-FFF2-40B4-BE49-F238E27FC236}">
                  <a16:creationId xmlns:a16="http://schemas.microsoft.com/office/drawing/2014/main" id="{1CBEEA3D-8CC3-B857-2399-85959A0AAB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9578" y="596805"/>
              <a:ext cx="72593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1" name="Line 76">
              <a:extLst>
                <a:ext uri="{FF2B5EF4-FFF2-40B4-BE49-F238E27FC236}">
                  <a16:creationId xmlns:a16="http://schemas.microsoft.com/office/drawing/2014/main" id="{802FB82D-F8AD-F72F-3B5E-93459E8C7B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55874" y="564191"/>
              <a:ext cx="0" cy="59967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2" name="Line 77">
              <a:extLst>
                <a:ext uri="{FF2B5EF4-FFF2-40B4-BE49-F238E27FC236}">
                  <a16:creationId xmlns:a16="http://schemas.microsoft.com/office/drawing/2014/main" id="{BBCA997B-B564-9C19-C57F-F51CB5BC10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49921" y="596805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3" name="Line 78">
              <a:extLst>
                <a:ext uri="{FF2B5EF4-FFF2-40B4-BE49-F238E27FC236}">
                  <a16:creationId xmlns:a16="http://schemas.microsoft.com/office/drawing/2014/main" id="{F3D74DC7-0D02-071F-F925-62814F3E1F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86217" y="564191"/>
              <a:ext cx="0" cy="59967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4" name="Line 79">
              <a:extLst>
                <a:ext uri="{FF2B5EF4-FFF2-40B4-BE49-F238E27FC236}">
                  <a16:creationId xmlns:a16="http://schemas.microsoft.com/office/drawing/2014/main" id="{093DD6EE-F1D0-EF43-F976-F563AFDB6A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21117" y="596805"/>
              <a:ext cx="72593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5" name="Line 80">
              <a:extLst>
                <a:ext uri="{FF2B5EF4-FFF2-40B4-BE49-F238E27FC236}">
                  <a16:creationId xmlns:a16="http://schemas.microsoft.com/office/drawing/2014/main" id="{277E966D-10C1-FEE6-F633-04AB202E10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7414" y="564191"/>
              <a:ext cx="0" cy="59967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6" name="Line 81">
              <a:extLst>
                <a:ext uri="{FF2B5EF4-FFF2-40B4-BE49-F238E27FC236}">
                  <a16:creationId xmlns:a16="http://schemas.microsoft.com/office/drawing/2014/main" id="{8781F241-5F3B-480F-C86D-2CB6DCF3F2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0691" y="672553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7" name="Line 82">
              <a:extLst>
                <a:ext uri="{FF2B5EF4-FFF2-40B4-BE49-F238E27FC236}">
                  <a16:creationId xmlns:a16="http://schemas.microsoft.com/office/drawing/2014/main" id="{5A8831DF-D72F-87A0-BD7E-F8ED81BC0C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36987" y="645200"/>
              <a:ext cx="0" cy="54707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8" name="Line 83">
              <a:extLst>
                <a:ext uri="{FF2B5EF4-FFF2-40B4-BE49-F238E27FC236}">
                  <a16:creationId xmlns:a16="http://schemas.microsoft.com/office/drawing/2014/main" id="{8010873B-2F5B-E703-67D0-74C834D7ED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24710" y="672553"/>
              <a:ext cx="72593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9" name="Line 84">
              <a:extLst>
                <a:ext uri="{FF2B5EF4-FFF2-40B4-BE49-F238E27FC236}">
                  <a16:creationId xmlns:a16="http://schemas.microsoft.com/office/drawing/2014/main" id="{C39E7D68-B4A0-83EB-B8CA-DDBDFD9B7F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1007" y="645200"/>
              <a:ext cx="0" cy="54707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0" name="Line 85">
              <a:extLst>
                <a:ext uri="{FF2B5EF4-FFF2-40B4-BE49-F238E27FC236}">
                  <a16:creationId xmlns:a16="http://schemas.microsoft.com/office/drawing/2014/main" id="{3F24515C-B0EC-BB74-90E1-86A1ACBEAB9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29843" y="845090"/>
              <a:ext cx="72593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1" name="Line 86">
              <a:extLst>
                <a:ext uri="{FF2B5EF4-FFF2-40B4-BE49-F238E27FC236}">
                  <a16:creationId xmlns:a16="http://schemas.microsoft.com/office/drawing/2014/main" id="{05AFCEFF-71FF-9F4E-4B7F-7B4ED7C51B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66139" y="818788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2" name="Line 87">
              <a:extLst>
                <a:ext uri="{FF2B5EF4-FFF2-40B4-BE49-F238E27FC236}">
                  <a16:creationId xmlns:a16="http://schemas.microsoft.com/office/drawing/2014/main" id="{48AD2F3B-2F1B-617B-8E90-E502F5C8BF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59160" y="845090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3" name="Line 88">
              <a:extLst>
                <a:ext uri="{FF2B5EF4-FFF2-40B4-BE49-F238E27FC236}">
                  <a16:creationId xmlns:a16="http://schemas.microsoft.com/office/drawing/2014/main" id="{28BBAC3A-C3E7-E04C-3AD2-6F1AF94728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995456" y="818788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4" name="Line 89">
              <a:extLst>
                <a:ext uri="{FF2B5EF4-FFF2-40B4-BE49-F238E27FC236}">
                  <a16:creationId xmlns:a16="http://schemas.microsoft.com/office/drawing/2014/main" id="{D21F83D6-97AA-8233-F7E1-8E880E0265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95456" y="845090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5" name="Line 90">
              <a:extLst>
                <a:ext uri="{FF2B5EF4-FFF2-40B4-BE49-F238E27FC236}">
                  <a16:creationId xmlns:a16="http://schemas.microsoft.com/office/drawing/2014/main" id="{6389E324-79E9-5BD6-BB85-EA6D8F256F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30356" y="818788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6" name="Line 91">
              <a:extLst>
                <a:ext uri="{FF2B5EF4-FFF2-40B4-BE49-F238E27FC236}">
                  <a16:creationId xmlns:a16="http://schemas.microsoft.com/office/drawing/2014/main" id="{F3FF8694-37E8-A938-1949-817D70CC73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46739" y="845090"/>
              <a:ext cx="7817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7" name="Line 92">
              <a:extLst>
                <a:ext uri="{FF2B5EF4-FFF2-40B4-BE49-F238E27FC236}">
                  <a16:creationId xmlns:a16="http://schemas.microsoft.com/office/drawing/2014/main" id="{92D09EE2-3D71-0BAD-D0EE-5DA4B0833C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90015" y="818788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8" name="Line 93">
              <a:extLst>
                <a:ext uri="{FF2B5EF4-FFF2-40B4-BE49-F238E27FC236}">
                  <a16:creationId xmlns:a16="http://schemas.microsoft.com/office/drawing/2014/main" id="{25435172-AA88-41F5-08C4-42F2FF06EC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41812" y="845090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9" name="Line 94">
              <a:extLst>
                <a:ext uri="{FF2B5EF4-FFF2-40B4-BE49-F238E27FC236}">
                  <a16:creationId xmlns:a16="http://schemas.microsoft.com/office/drawing/2014/main" id="{CAF8CDC8-581C-EC59-1692-DC6197507F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676713" y="818788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0" name="Line 95">
              <a:extLst>
                <a:ext uri="{FF2B5EF4-FFF2-40B4-BE49-F238E27FC236}">
                  <a16:creationId xmlns:a16="http://schemas.microsoft.com/office/drawing/2014/main" id="{DA606F82-7AF7-50B6-CA10-4A2089D442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92068" y="845090"/>
              <a:ext cx="7119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1" name="Line 96">
              <a:extLst>
                <a:ext uri="{FF2B5EF4-FFF2-40B4-BE49-F238E27FC236}">
                  <a16:creationId xmlns:a16="http://schemas.microsoft.com/office/drawing/2014/main" id="{B73F8D54-23B4-11D6-9E53-B744C13BF3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26969" y="818788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2" name="Line 97">
              <a:extLst>
                <a:ext uri="{FF2B5EF4-FFF2-40B4-BE49-F238E27FC236}">
                  <a16:creationId xmlns:a16="http://schemas.microsoft.com/office/drawing/2014/main" id="{F90CA4AA-B88E-EF9E-F7A4-2492D377E9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99049" y="845090"/>
              <a:ext cx="78177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3" name="Line 98">
              <a:extLst>
                <a:ext uri="{FF2B5EF4-FFF2-40B4-BE49-F238E27FC236}">
                  <a16:creationId xmlns:a16="http://schemas.microsoft.com/office/drawing/2014/main" id="{60A4D7FA-A1DA-F0AA-6958-2B9E1C796D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42325" y="818788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4" name="Line 99">
              <a:extLst>
                <a:ext uri="{FF2B5EF4-FFF2-40B4-BE49-F238E27FC236}">
                  <a16:creationId xmlns:a16="http://schemas.microsoft.com/office/drawing/2014/main" id="{16649269-E8EB-4E15-F3E9-ACBA3156A9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70245" y="996585"/>
              <a:ext cx="72593" cy="0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5" name="Line 100">
              <a:extLst>
                <a:ext uri="{FF2B5EF4-FFF2-40B4-BE49-F238E27FC236}">
                  <a16:creationId xmlns:a16="http://schemas.microsoft.com/office/drawing/2014/main" id="{8EE425DD-D49F-12A7-8048-1644BAF5E2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06542" y="970284"/>
              <a:ext cx="0" cy="53655"/>
            </a:xfrm>
            <a:prstGeom prst="line">
              <a:avLst/>
            </a:prstGeom>
            <a:noFill/>
            <a:ln w="7938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6" name="Freeform 101">
              <a:extLst>
                <a:ext uri="{FF2B5EF4-FFF2-40B4-BE49-F238E27FC236}">
                  <a16:creationId xmlns:a16="http://schemas.microsoft.com/office/drawing/2014/main" id="{6EE743D5-7B75-3846-00D0-293B2510307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2111" y="163359"/>
              <a:ext cx="3424431" cy="1499176"/>
            </a:xfrm>
            <a:custGeom>
              <a:avLst/>
              <a:gdLst>
                <a:gd name="T0" fmla="*/ 0 w 477"/>
                <a:gd name="T1" fmla="*/ 0 h 277"/>
                <a:gd name="T2" fmla="*/ 3 w 477"/>
                <a:gd name="T3" fmla="*/ 0 h 277"/>
                <a:gd name="T4" fmla="*/ 3 w 477"/>
                <a:gd name="T5" fmla="*/ 11 h 277"/>
                <a:gd name="T6" fmla="*/ 4 w 477"/>
                <a:gd name="T7" fmla="*/ 11 h 277"/>
                <a:gd name="T8" fmla="*/ 4 w 477"/>
                <a:gd name="T9" fmla="*/ 22 h 277"/>
                <a:gd name="T10" fmla="*/ 14 w 477"/>
                <a:gd name="T11" fmla="*/ 22 h 277"/>
                <a:gd name="T12" fmla="*/ 14 w 477"/>
                <a:gd name="T13" fmla="*/ 35 h 277"/>
                <a:gd name="T14" fmla="*/ 16 w 477"/>
                <a:gd name="T15" fmla="*/ 35 h 277"/>
                <a:gd name="T16" fmla="*/ 16 w 477"/>
                <a:gd name="T17" fmla="*/ 48 h 277"/>
                <a:gd name="T18" fmla="*/ 18 w 477"/>
                <a:gd name="T19" fmla="*/ 48 h 277"/>
                <a:gd name="T20" fmla="*/ 18 w 477"/>
                <a:gd name="T21" fmla="*/ 61 h 277"/>
                <a:gd name="T22" fmla="*/ 52 w 477"/>
                <a:gd name="T23" fmla="*/ 61 h 277"/>
                <a:gd name="T24" fmla="*/ 52 w 477"/>
                <a:gd name="T25" fmla="*/ 76 h 277"/>
                <a:gd name="T26" fmla="*/ 65 w 477"/>
                <a:gd name="T27" fmla="*/ 76 h 277"/>
                <a:gd name="T28" fmla="*/ 65 w 477"/>
                <a:gd name="T29" fmla="*/ 91 h 277"/>
                <a:gd name="T30" fmla="*/ 75 w 477"/>
                <a:gd name="T31" fmla="*/ 91 h 277"/>
                <a:gd name="T32" fmla="*/ 75 w 477"/>
                <a:gd name="T33" fmla="*/ 106 h 277"/>
                <a:gd name="T34" fmla="*/ 78 w 477"/>
                <a:gd name="T35" fmla="*/ 106 h 277"/>
                <a:gd name="T36" fmla="*/ 78 w 477"/>
                <a:gd name="T37" fmla="*/ 122 h 277"/>
                <a:gd name="T38" fmla="*/ 90 w 477"/>
                <a:gd name="T39" fmla="*/ 122 h 277"/>
                <a:gd name="T40" fmla="*/ 90 w 477"/>
                <a:gd name="T41" fmla="*/ 138 h 277"/>
                <a:gd name="T42" fmla="*/ 93 w 477"/>
                <a:gd name="T43" fmla="*/ 138 h 277"/>
                <a:gd name="T44" fmla="*/ 93 w 477"/>
                <a:gd name="T45" fmla="*/ 154 h 277"/>
                <a:gd name="T46" fmla="*/ 232 w 477"/>
                <a:gd name="T47" fmla="*/ 154 h 277"/>
                <a:gd name="T48" fmla="*/ 232 w 477"/>
                <a:gd name="T49" fmla="*/ 174 h 277"/>
                <a:gd name="T50" fmla="*/ 312 w 477"/>
                <a:gd name="T51" fmla="*/ 174 h 277"/>
                <a:gd name="T52" fmla="*/ 312 w 477"/>
                <a:gd name="T53" fmla="*/ 197 h 277"/>
                <a:gd name="T54" fmla="*/ 313 w 477"/>
                <a:gd name="T55" fmla="*/ 197 h 277"/>
                <a:gd name="T56" fmla="*/ 313 w 477"/>
                <a:gd name="T57" fmla="*/ 220 h 277"/>
                <a:gd name="T58" fmla="*/ 334 w 477"/>
                <a:gd name="T59" fmla="*/ 220 h 277"/>
                <a:gd name="T60" fmla="*/ 334 w 477"/>
                <a:gd name="T61" fmla="*/ 243 h 277"/>
                <a:gd name="T62" fmla="*/ 436 w 477"/>
                <a:gd name="T63" fmla="*/ 243 h 277"/>
                <a:gd name="T64" fmla="*/ 436 w 477"/>
                <a:gd name="T65" fmla="*/ 277 h 277"/>
                <a:gd name="T66" fmla="*/ 477 w 477"/>
                <a:gd name="T67" fmla="*/ 277 h 2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77" h="277">
                  <a:moveTo>
                    <a:pt x="0" y="0"/>
                  </a:moveTo>
                  <a:lnTo>
                    <a:pt x="3" y="0"/>
                  </a:lnTo>
                  <a:lnTo>
                    <a:pt x="3" y="11"/>
                  </a:lnTo>
                  <a:lnTo>
                    <a:pt x="4" y="11"/>
                  </a:lnTo>
                  <a:lnTo>
                    <a:pt x="4" y="22"/>
                  </a:lnTo>
                  <a:lnTo>
                    <a:pt x="14" y="22"/>
                  </a:lnTo>
                  <a:lnTo>
                    <a:pt x="14" y="35"/>
                  </a:lnTo>
                  <a:lnTo>
                    <a:pt x="16" y="35"/>
                  </a:lnTo>
                  <a:lnTo>
                    <a:pt x="16" y="48"/>
                  </a:lnTo>
                  <a:lnTo>
                    <a:pt x="18" y="48"/>
                  </a:lnTo>
                  <a:lnTo>
                    <a:pt x="18" y="61"/>
                  </a:lnTo>
                  <a:lnTo>
                    <a:pt x="52" y="61"/>
                  </a:lnTo>
                  <a:lnTo>
                    <a:pt x="52" y="76"/>
                  </a:lnTo>
                  <a:lnTo>
                    <a:pt x="65" y="76"/>
                  </a:lnTo>
                  <a:lnTo>
                    <a:pt x="65" y="91"/>
                  </a:lnTo>
                  <a:lnTo>
                    <a:pt x="75" y="91"/>
                  </a:lnTo>
                  <a:lnTo>
                    <a:pt x="75" y="106"/>
                  </a:lnTo>
                  <a:lnTo>
                    <a:pt x="78" y="106"/>
                  </a:lnTo>
                  <a:lnTo>
                    <a:pt x="78" y="122"/>
                  </a:lnTo>
                  <a:lnTo>
                    <a:pt x="90" y="122"/>
                  </a:lnTo>
                  <a:lnTo>
                    <a:pt x="90" y="138"/>
                  </a:lnTo>
                  <a:lnTo>
                    <a:pt x="93" y="138"/>
                  </a:lnTo>
                  <a:lnTo>
                    <a:pt x="93" y="154"/>
                  </a:lnTo>
                  <a:lnTo>
                    <a:pt x="232" y="154"/>
                  </a:lnTo>
                  <a:lnTo>
                    <a:pt x="232" y="174"/>
                  </a:lnTo>
                  <a:lnTo>
                    <a:pt x="312" y="174"/>
                  </a:lnTo>
                  <a:lnTo>
                    <a:pt x="312" y="197"/>
                  </a:lnTo>
                  <a:lnTo>
                    <a:pt x="313" y="197"/>
                  </a:lnTo>
                  <a:lnTo>
                    <a:pt x="313" y="220"/>
                  </a:lnTo>
                  <a:lnTo>
                    <a:pt x="334" y="220"/>
                  </a:lnTo>
                  <a:lnTo>
                    <a:pt x="334" y="243"/>
                  </a:lnTo>
                  <a:lnTo>
                    <a:pt x="436" y="243"/>
                  </a:lnTo>
                  <a:lnTo>
                    <a:pt x="436" y="277"/>
                  </a:lnTo>
                  <a:lnTo>
                    <a:pt x="477" y="277"/>
                  </a:lnTo>
                </a:path>
              </a:pathLst>
            </a:custGeom>
            <a:noFill/>
            <a:ln w="19050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7" name="Line 102">
              <a:extLst>
                <a:ext uri="{FF2B5EF4-FFF2-40B4-BE49-F238E27FC236}">
                  <a16:creationId xmlns:a16="http://schemas.microsoft.com/office/drawing/2014/main" id="{D009D4AE-D19C-64C9-3063-71F2769D18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66755" y="223326"/>
              <a:ext cx="72593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8" name="Line 103">
              <a:extLst>
                <a:ext uri="{FF2B5EF4-FFF2-40B4-BE49-F238E27FC236}">
                  <a16:creationId xmlns:a16="http://schemas.microsoft.com/office/drawing/2014/main" id="{E84ABA41-C2E3-9885-417A-A4A330AAC89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03051" y="195973"/>
              <a:ext cx="0" cy="5470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9" name="Line 104">
              <a:extLst>
                <a:ext uri="{FF2B5EF4-FFF2-40B4-BE49-F238E27FC236}">
                  <a16:creationId xmlns:a16="http://schemas.microsoft.com/office/drawing/2014/main" id="{EBB1C191-8D76-3547-14C6-B6699C9A98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3735" y="255940"/>
              <a:ext cx="72593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0" name="Line 105">
              <a:extLst>
                <a:ext uri="{FF2B5EF4-FFF2-40B4-BE49-F238E27FC236}">
                  <a16:creationId xmlns:a16="http://schemas.microsoft.com/office/drawing/2014/main" id="{E95B20FC-96DA-35BC-E35A-F85C9C9AF3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10032" y="228587"/>
              <a:ext cx="0" cy="53655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1" name="Line 106">
              <a:extLst>
                <a:ext uri="{FF2B5EF4-FFF2-40B4-BE49-F238E27FC236}">
                  <a16:creationId xmlns:a16="http://schemas.microsoft.com/office/drawing/2014/main" id="{BEE3E553-911B-6FEA-4D09-DD41687E8B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89091" y="282241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2" name="Line 107">
              <a:extLst>
                <a:ext uri="{FF2B5EF4-FFF2-40B4-BE49-F238E27FC236}">
                  <a16:creationId xmlns:a16="http://schemas.microsoft.com/office/drawing/2014/main" id="{9342DB26-E632-D102-47B0-002B03FAD3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23992" y="255940"/>
              <a:ext cx="0" cy="58915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3" name="Line 108">
              <a:extLst>
                <a:ext uri="{FF2B5EF4-FFF2-40B4-BE49-F238E27FC236}">
                  <a16:creationId xmlns:a16="http://schemas.microsoft.com/office/drawing/2014/main" id="{A2B544C4-4BF4-F0EB-CD0B-94427EEF30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03051" y="282241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4" name="Line 109">
              <a:extLst>
                <a:ext uri="{FF2B5EF4-FFF2-40B4-BE49-F238E27FC236}">
                  <a16:creationId xmlns:a16="http://schemas.microsoft.com/office/drawing/2014/main" id="{82B4421C-5CCD-A073-A7D1-7B35F854A3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39348" y="255940"/>
              <a:ext cx="0" cy="58915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5" name="Line 110">
              <a:extLst>
                <a:ext uri="{FF2B5EF4-FFF2-40B4-BE49-F238E27FC236}">
                  <a16:creationId xmlns:a16="http://schemas.microsoft.com/office/drawing/2014/main" id="{B15304C6-7AC8-CE74-86B0-1874559BA2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9348" y="282241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6" name="Line 111">
              <a:extLst>
                <a:ext uri="{FF2B5EF4-FFF2-40B4-BE49-F238E27FC236}">
                  <a16:creationId xmlns:a16="http://schemas.microsoft.com/office/drawing/2014/main" id="{352B4327-9FD8-8CEF-22E6-58BA4798D6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74248" y="255940"/>
              <a:ext cx="0" cy="58915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7" name="Line 112">
              <a:extLst>
                <a:ext uri="{FF2B5EF4-FFF2-40B4-BE49-F238E27FC236}">
                  <a16:creationId xmlns:a16="http://schemas.microsoft.com/office/drawing/2014/main" id="{89609D20-1D60-7932-8FA8-347CA40EA5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39861" y="493704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8" name="Line 113">
              <a:extLst>
                <a:ext uri="{FF2B5EF4-FFF2-40B4-BE49-F238E27FC236}">
                  <a16:creationId xmlns:a16="http://schemas.microsoft.com/office/drawing/2014/main" id="{4A9010DE-C482-9815-201E-39161644AA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74762" y="466351"/>
              <a:ext cx="0" cy="5470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9" name="Line 114">
              <a:extLst>
                <a:ext uri="{FF2B5EF4-FFF2-40B4-BE49-F238E27FC236}">
                  <a16:creationId xmlns:a16="http://schemas.microsoft.com/office/drawing/2014/main" id="{CB36D6C6-8518-69E2-00A0-A58BFD2075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1058" y="493704"/>
              <a:ext cx="79573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0" name="Line 115">
              <a:extLst>
                <a:ext uri="{FF2B5EF4-FFF2-40B4-BE49-F238E27FC236}">
                  <a16:creationId xmlns:a16="http://schemas.microsoft.com/office/drawing/2014/main" id="{F02C32B9-8188-6F2D-9B22-C2F7EB72F4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54334" y="466351"/>
              <a:ext cx="0" cy="5470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1" name="Line 116">
              <a:extLst>
                <a:ext uri="{FF2B5EF4-FFF2-40B4-BE49-F238E27FC236}">
                  <a16:creationId xmlns:a16="http://schemas.microsoft.com/office/drawing/2014/main" id="{53A33B5F-2044-F766-2CBB-C3C41A8AA9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5018" y="493704"/>
              <a:ext cx="72593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2" name="Line 117">
              <a:extLst>
                <a:ext uri="{FF2B5EF4-FFF2-40B4-BE49-F238E27FC236}">
                  <a16:creationId xmlns:a16="http://schemas.microsoft.com/office/drawing/2014/main" id="{5F150189-928C-4A4E-2E58-26711F347D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61315" y="466351"/>
              <a:ext cx="0" cy="5470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3" name="Line 118">
              <a:extLst>
                <a:ext uri="{FF2B5EF4-FFF2-40B4-BE49-F238E27FC236}">
                  <a16:creationId xmlns:a16="http://schemas.microsoft.com/office/drawing/2014/main" id="{9BC9A6FB-4D1A-70E5-3FF7-0918BB5D548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47355" y="493704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4" name="Line 119">
              <a:extLst>
                <a:ext uri="{FF2B5EF4-FFF2-40B4-BE49-F238E27FC236}">
                  <a16:creationId xmlns:a16="http://schemas.microsoft.com/office/drawing/2014/main" id="{374B05B0-6A51-A732-8DC1-4367B27C6B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3651" y="466351"/>
              <a:ext cx="0" cy="5470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5" name="Line 120">
              <a:extLst>
                <a:ext uri="{FF2B5EF4-FFF2-40B4-BE49-F238E27FC236}">
                  <a16:creationId xmlns:a16="http://schemas.microsoft.com/office/drawing/2014/main" id="{C702C18B-1A18-B9FA-225D-A810704E63D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41914" y="824049"/>
              <a:ext cx="7817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6" name="Line 121">
              <a:extLst>
                <a:ext uri="{FF2B5EF4-FFF2-40B4-BE49-F238E27FC236}">
                  <a16:creationId xmlns:a16="http://schemas.microsoft.com/office/drawing/2014/main" id="{1CD4FC55-167A-8CB4-1D71-94CE18951C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6815" y="791435"/>
              <a:ext cx="0" cy="5996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7" name="Line 122">
              <a:extLst>
                <a:ext uri="{FF2B5EF4-FFF2-40B4-BE49-F238E27FC236}">
                  <a16:creationId xmlns:a16="http://schemas.microsoft.com/office/drawing/2014/main" id="{EE2F5774-AFA1-5FF1-ABC3-52CA89B9FD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3368" y="996585"/>
              <a:ext cx="72593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8" name="Line 123">
              <a:extLst>
                <a:ext uri="{FF2B5EF4-FFF2-40B4-BE49-F238E27FC236}">
                  <a16:creationId xmlns:a16="http://schemas.microsoft.com/office/drawing/2014/main" id="{CD792B9B-B581-E1A2-EA75-A29102DC0E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99664" y="970284"/>
              <a:ext cx="0" cy="53655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9" name="Line 124">
              <a:extLst>
                <a:ext uri="{FF2B5EF4-FFF2-40B4-BE49-F238E27FC236}">
                  <a16:creationId xmlns:a16="http://schemas.microsoft.com/office/drawing/2014/main" id="{1CF9D739-834B-CB3B-1074-86C5822354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9210" y="996585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0" name="Line 125">
              <a:extLst>
                <a:ext uri="{FF2B5EF4-FFF2-40B4-BE49-F238E27FC236}">
                  <a16:creationId xmlns:a16="http://schemas.microsoft.com/office/drawing/2014/main" id="{222700CA-1226-AFDA-09FC-3B72DD8239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45507" y="970284"/>
              <a:ext cx="0" cy="53655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1" name="Line 126">
              <a:extLst>
                <a:ext uri="{FF2B5EF4-FFF2-40B4-BE49-F238E27FC236}">
                  <a16:creationId xmlns:a16="http://schemas.microsoft.com/office/drawing/2014/main" id="{27EDB4E0-08C4-8127-B5EB-538F849B06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59467" y="996585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2" name="Line 127">
              <a:extLst>
                <a:ext uri="{FF2B5EF4-FFF2-40B4-BE49-F238E27FC236}">
                  <a16:creationId xmlns:a16="http://schemas.microsoft.com/office/drawing/2014/main" id="{9F06B371-B17C-84E3-B800-A7CD5CBAC1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95763" y="970284"/>
              <a:ext cx="0" cy="53655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3" name="Line 128">
              <a:extLst>
                <a:ext uri="{FF2B5EF4-FFF2-40B4-BE49-F238E27FC236}">
                  <a16:creationId xmlns:a16="http://schemas.microsoft.com/office/drawing/2014/main" id="{A3178F78-093A-CE14-181C-863027EA01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4514" y="1104947"/>
              <a:ext cx="72593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4" name="Line 129">
              <a:extLst>
                <a:ext uri="{FF2B5EF4-FFF2-40B4-BE49-F238E27FC236}">
                  <a16:creationId xmlns:a16="http://schemas.microsoft.com/office/drawing/2014/main" id="{0CB5C225-5BDA-823E-E488-35A61EC3E1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20810" y="1078646"/>
              <a:ext cx="0" cy="58915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5" name="Line 130">
              <a:extLst>
                <a:ext uri="{FF2B5EF4-FFF2-40B4-BE49-F238E27FC236}">
                  <a16:creationId xmlns:a16="http://schemas.microsoft.com/office/drawing/2014/main" id="{B3628A2D-E775-B5BB-90AD-1DFC33E25E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45713" y="1478426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6" name="Line 131">
              <a:extLst>
                <a:ext uri="{FF2B5EF4-FFF2-40B4-BE49-F238E27FC236}">
                  <a16:creationId xmlns:a16="http://schemas.microsoft.com/office/drawing/2014/main" id="{5A6A0A18-F9CA-DB72-58D7-D37C2A6CA0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80613" y="1451072"/>
              <a:ext cx="0" cy="5470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7" name="Line 132">
              <a:extLst>
                <a:ext uri="{FF2B5EF4-FFF2-40B4-BE49-F238E27FC236}">
                  <a16:creationId xmlns:a16="http://schemas.microsoft.com/office/drawing/2014/main" id="{2A7440C8-27BA-22A8-54F4-3AE6FB17DF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53719" y="1478426"/>
              <a:ext cx="71197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8" name="Line 133">
              <a:extLst>
                <a:ext uri="{FF2B5EF4-FFF2-40B4-BE49-F238E27FC236}">
                  <a16:creationId xmlns:a16="http://schemas.microsoft.com/office/drawing/2014/main" id="{976AF674-6BE7-DDEB-9694-71110A74FE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90015" y="1451072"/>
              <a:ext cx="0" cy="5470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9" name="Line 134">
              <a:extLst>
                <a:ext uri="{FF2B5EF4-FFF2-40B4-BE49-F238E27FC236}">
                  <a16:creationId xmlns:a16="http://schemas.microsoft.com/office/drawing/2014/main" id="{FE32AFBE-8DEC-24BE-A174-251AA9E764A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70245" y="1662535"/>
              <a:ext cx="72593" cy="0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0" name="Line 135">
              <a:extLst>
                <a:ext uri="{FF2B5EF4-FFF2-40B4-BE49-F238E27FC236}">
                  <a16:creationId xmlns:a16="http://schemas.microsoft.com/office/drawing/2014/main" id="{5E784A5D-B7A5-DAEE-FB6D-564EBD2E60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806542" y="1635181"/>
              <a:ext cx="0" cy="54707"/>
            </a:xfrm>
            <a:prstGeom prst="line">
              <a:avLst/>
            </a:prstGeom>
            <a:noFill/>
            <a:ln w="7938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1" name="Rectangle 136">
              <a:extLst>
                <a:ext uri="{FF2B5EF4-FFF2-40B4-BE49-F238E27FC236}">
                  <a16:creationId xmlns:a16="http://schemas.microsoft.com/office/drawing/2014/main" id="{EA301C56-E40C-50E1-46EF-FAD298EAD5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8578" y="2836626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2" name="Rectangle 137">
              <a:extLst>
                <a:ext uri="{FF2B5EF4-FFF2-40B4-BE49-F238E27FC236}">
                  <a16:creationId xmlns:a16="http://schemas.microsoft.com/office/drawing/2014/main" id="{AEDBA6B6-DED6-2656-43CD-D31096CF2A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9124" y="2836626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3" name="Rectangle 138">
              <a:extLst>
                <a:ext uri="{FF2B5EF4-FFF2-40B4-BE49-F238E27FC236}">
                  <a16:creationId xmlns:a16="http://schemas.microsoft.com/office/drawing/2014/main" id="{56A642F0-9330-E695-AD71-BFC0D00F84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1067" y="2836626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4" name="Rectangle 139">
              <a:extLst>
                <a:ext uri="{FF2B5EF4-FFF2-40B4-BE49-F238E27FC236}">
                  <a16:creationId xmlns:a16="http://schemas.microsoft.com/office/drawing/2014/main" id="{9E402C83-A3C3-E3D2-1EAC-F9DE978BD6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3009" y="2836626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5" name="Rectangle 140">
              <a:extLst>
                <a:ext uri="{FF2B5EF4-FFF2-40B4-BE49-F238E27FC236}">
                  <a16:creationId xmlns:a16="http://schemas.microsoft.com/office/drawing/2014/main" id="{859999EE-1AA2-C567-D2DE-D0834DE47C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8578" y="2949352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6" name="Rectangle 141">
              <a:extLst>
                <a:ext uri="{FF2B5EF4-FFF2-40B4-BE49-F238E27FC236}">
                  <a16:creationId xmlns:a16="http://schemas.microsoft.com/office/drawing/2014/main" id="{4BFE0514-4E6A-8450-1E04-5E850A4AFE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9124" y="2949352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7" name="Rectangle 142">
              <a:extLst>
                <a:ext uri="{FF2B5EF4-FFF2-40B4-BE49-F238E27FC236}">
                  <a16:creationId xmlns:a16="http://schemas.microsoft.com/office/drawing/2014/main" id="{1654F567-6F73-A8EB-FA56-B41A928873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7363" y="2949352"/>
              <a:ext cx="6202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8" name="Rectangle 143">
              <a:extLst>
                <a:ext uri="{FF2B5EF4-FFF2-40B4-BE49-F238E27FC236}">
                  <a16:creationId xmlns:a16="http://schemas.microsoft.com/office/drawing/2014/main" id="{C6B71402-A80B-07C4-3187-6B24A35E8A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9305" y="2949352"/>
              <a:ext cx="6202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9" name="Rectangle 144">
              <a:extLst>
                <a:ext uri="{FF2B5EF4-FFF2-40B4-BE49-F238E27FC236}">
                  <a16:creationId xmlns:a16="http://schemas.microsoft.com/office/drawing/2014/main" id="{9A1100B5-7CAB-87A8-36AA-7ED72020D3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8578" y="3052453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0" name="Rectangle 145">
              <a:extLst>
                <a:ext uri="{FF2B5EF4-FFF2-40B4-BE49-F238E27FC236}">
                  <a16:creationId xmlns:a16="http://schemas.microsoft.com/office/drawing/2014/main" id="{004AD18C-C3FB-5D7A-6E5B-35AF542422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9124" y="3052453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1" name="Rectangle 146">
              <a:extLst>
                <a:ext uri="{FF2B5EF4-FFF2-40B4-BE49-F238E27FC236}">
                  <a16:creationId xmlns:a16="http://schemas.microsoft.com/office/drawing/2014/main" id="{0821E45B-4138-FB91-E8B4-24A93F81CF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1067" y="3052453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2" name="Rectangle 147">
              <a:extLst>
                <a:ext uri="{FF2B5EF4-FFF2-40B4-BE49-F238E27FC236}">
                  <a16:creationId xmlns:a16="http://schemas.microsoft.com/office/drawing/2014/main" id="{60003EA5-84B4-561E-5B6E-F4DF83AC93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9305" y="3052453"/>
              <a:ext cx="6202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3" name="Rectangle 148">
              <a:extLst>
                <a:ext uri="{FF2B5EF4-FFF2-40B4-BE49-F238E27FC236}">
                  <a16:creationId xmlns:a16="http://schemas.microsoft.com/office/drawing/2014/main" id="{C327A713-6B18-6AF1-AE23-6B18433E55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8578" y="3164128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4" name="Rectangle 149">
              <a:extLst>
                <a:ext uri="{FF2B5EF4-FFF2-40B4-BE49-F238E27FC236}">
                  <a16:creationId xmlns:a16="http://schemas.microsoft.com/office/drawing/2014/main" id="{785E1E3E-4DCD-4E41-45D1-0096B824D4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9124" y="3164128"/>
              <a:ext cx="124049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5" name="Rectangle 150">
              <a:extLst>
                <a:ext uri="{FF2B5EF4-FFF2-40B4-BE49-F238E27FC236}">
                  <a16:creationId xmlns:a16="http://schemas.microsoft.com/office/drawing/2014/main" id="{2E2C5EAF-A7C0-A5D1-7F48-8A0235DF5A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7363" y="3164128"/>
              <a:ext cx="6202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6" name="Rectangle 151">
              <a:extLst>
                <a:ext uri="{FF2B5EF4-FFF2-40B4-BE49-F238E27FC236}">
                  <a16:creationId xmlns:a16="http://schemas.microsoft.com/office/drawing/2014/main" id="{A0B9879A-1CC6-DB71-55DD-D5CEC4B156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9305" y="3164128"/>
              <a:ext cx="6202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7" name="Rectangle 156">
              <a:extLst>
                <a:ext uri="{FF2B5EF4-FFF2-40B4-BE49-F238E27FC236}">
                  <a16:creationId xmlns:a16="http://schemas.microsoft.com/office/drawing/2014/main" id="{53AF7778-CF3D-A742-E622-0DE0F95EA6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5302" y="2679870"/>
              <a:ext cx="741477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8" name="Rectangle 162">
              <a:extLst>
                <a:ext uri="{FF2B5EF4-FFF2-40B4-BE49-F238E27FC236}">
                  <a16:creationId xmlns:a16="http://schemas.microsoft.com/office/drawing/2014/main" id="{D7B124D4-021C-990B-1E9E-C7004CFEFD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0941" y="2834716"/>
              <a:ext cx="391884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9" name="Rectangle 163">
              <a:extLst>
                <a:ext uri="{FF2B5EF4-FFF2-40B4-BE49-F238E27FC236}">
                  <a16:creationId xmlns:a16="http://schemas.microsoft.com/office/drawing/2014/main" id="{7C15AF4A-3681-30B5-DB67-8755EE7445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7759" y="2936101"/>
              <a:ext cx="34395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0" name="Rectangle 164">
              <a:extLst>
                <a:ext uri="{FF2B5EF4-FFF2-40B4-BE49-F238E27FC236}">
                  <a16:creationId xmlns:a16="http://schemas.microsoft.com/office/drawing/2014/main" id="{614BFF73-2FB9-FBBB-EA21-BDAA4093FD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87759" y="3035132"/>
              <a:ext cx="34395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1" name="Rectangle 165">
              <a:extLst>
                <a:ext uri="{FF2B5EF4-FFF2-40B4-BE49-F238E27FC236}">
                  <a16:creationId xmlns:a16="http://schemas.microsoft.com/office/drawing/2014/main" id="{AA2A6FCE-B4D6-BA8E-3D83-36EB1D6912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1931" y="3146982"/>
              <a:ext cx="296027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2" name="Line 157">
              <a:extLst>
                <a:ext uri="{FF2B5EF4-FFF2-40B4-BE49-F238E27FC236}">
                  <a16:creationId xmlns:a16="http://schemas.microsoft.com/office/drawing/2014/main" id="{BE81FD77-0BA0-4106-AF03-392A937D38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9987" y="293814"/>
              <a:ext cx="208007" cy="0"/>
            </a:xfrm>
            <a:prstGeom prst="line">
              <a:avLst/>
            </a:pr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3" name="Line 158">
              <a:extLst>
                <a:ext uri="{FF2B5EF4-FFF2-40B4-BE49-F238E27FC236}">
                  <a16:creationId xmlns:a16="http://schemas.microsoft.com/office/drawing/2014/main" id="{E3C44F4A-1453-1FBF-F127-A6D659F09EF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9987" y="396915"/>
              <a:ext cx="208007" cy="0"/>
            </a:xfrm>
            <a:prstGeom prst="line">
              <a:avLst/>
            </a:prstGeom>
            <a:noFill/>
            <a:ln w="19050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4" name="Line 159">
              <a:extLst>
                <a:ext uri="{FF2B5EF4-FFF2-40B4-BE49-F238E27FC236}">
                  <a16:creationId xmlns:a16="http://schemas.microsoft.com/office/drawing/2014/main" id="{EB0FCE76-97BD-4C6D-5789-3C6C03F7C5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9987" y="498964"/>
              <a:ext cx="208007" cy="0"/>
            </a:xfrm>
            <a:prstGeom prst="line">
              <a:avLst/>
            </a:prstGeom>
            <a:noFill/>
            <a:ln w="19050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5" name="Line 160">
              <a:extLst>
                <a:ext uri="{FF2B5EF4-FFF2-40B4-BE49-F238E27FC236}">
                  <a16:creationId xmlns:a16="http://schemas.microsoft.com/office/drawing/2014/main" id="{FA7DDCDD-20CB-24BE-152F-851598CC09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9987" y="602065"/>
              <a:ext cx="208007" cy="0"/>
            </a:xfrm>
            <a:prstGeom prst="line">
              <a:avLst/>
            </a:prstGeom>
            <a:noFill/>
            <a:ln w="19050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6" name="Rectangle 162">
              <a:extLst>
                <a:ext uri="{FF2B5EF4-FFF2-40B4-BE49-F238E27FC236}">
                  <a16:creationId xmlns:a16="http://schemas.microsoft.com/office/drawing/2014/main" id="{EFC75AFA-A5ED-76F5-D2C3-4ABC0448F4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6130" y="228587"/>
              <a:ext cx="391884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7" name="Rectangle 163">
              <a:extLst>
                <a:ext uri="{FF2B5EF4-FFF2-40B4-BE49-F238E27FC236}">
                  <a16:creationId xmlns:a16="http://schemas.microsoft.com/office/drawing/2014/main" id="{17D2F878-0BC7-A63D-F279-F033DCD95C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2948" y="329971"/>
              <a:ext cx="34395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8" name="Rectangle 164">
              <a:extLst>
                <a:ext uri="{FF2B5EF4-FFF2-40B4-BE49-F238E27FC236}">
                  <a16:creationId xmlns:a16="http://schemas.microsoft.com/office/drawing/2014/main" id="{C1EC62A0-D271-7FFC-3FD6-E31E2CC797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2948" y="429002"/>
              <a:ext cx="343955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9" name="Rectangle 165">
              <a:extLst>
                <a:ext uri="{FF2B5EF4-FFF2-40B4-BE49-F238E27FC236}">
                  <a16:creationId xmlns:a16="http://schemas.microsoft.com/office/drawing/2014/main" id="{3B6D3A37-9A71-D54C-2E63-8224A2C99F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27120" y="540853"/>
              <a:ext cx="296027" cy="112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-</a:t>
              </a:r>
              <a:r>
                <a:rPr kumimoji="0" lang="en-US" altLang="ja-JP" sz="1100" b="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EF</a:t>
              </a:r>
              <a:endParaRPr kumimoji="0" lang="ja-JP" altLang="ja-JP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51867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1</TotalTime>
  <Words>185</Words>
  <Application>Microsoft Office PowerPoint</Application>
  <PresentationFormat>ワイド画面</PresentationFormat>
  <Paragraphs>1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ya Inoue</dc:creator>
  <cp:lastModifiedBy>Naoya Inoue</cp:lastModifiedBy>
  <cp:revision>50</cp:revision>
  <dcterms:created xsi:type="dcterms:W3CDTF">2023-11-17T10:12:32Z</dcterms:created>
  <dcterms:modified xsi:type="dcterms:W3CDTF">2024-02-19T13:30:22Z</dcterms:modified>
</cp:coreProperties>
</file>